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390" r:id="rId2"/>
    <p:sldId id="388" r:id="rId3"/>
    <p:sldId id="288" r:id="rId4"/>
    <p:sldId id="287" r:id="rId5"/>
    <p:sldId id="384" r:id="rId6"/>
    <p:sldId id="383" r:id="rId7"/>
    <p:sldId id="381" r:id="rId8"/>
    <p:sldId id="259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81" d="100"/>
          <a:sy n="81" d="100"/>
        </p:scale>
        <p:origin x="754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94628F-CB34-4F53-A1BC-095E33E05C71}" type="datetimeFigureOut">
              <a:rPr lang="en-IN" smtClean="0"/>
              <a:t>15-01-2025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697CF3-1230-4D04-A67A-C4D3B005551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991765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9697CF3-1230-4D04-A67A-C4D3B0055515}" type="slidenum">
              <a:rPr lang="en-IN" smtClean="0"/>
              <a:t>1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687461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9697CF3-1230-4D04-A67A-C4D3B0055515}" type="slidenum">
              <a:rPr lang="en-IN" smtClean="0"/>
              <a:t>6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6697825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30F2C4B-3B68-46E8-AE17-BE0411314FF0}" type="slidenum">
              <a:rPr lang="en-IN" smtClean="0"/>
              <a:t>8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165180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7D84D4-2840-1FF9-DD11-9C64FA6FA7A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5B4EEB7-11DA-E720-9EEF-081EC4E5F24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265FB8-6F55-6FD4-FF52-5108F3F258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E1E8E-B936-401F-B34A-3DB4B71AE49B}" type="datetimeFigureOut">
              <a:rPr lang="en-IN" smtClean="0"/>
              <a:t>15-01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B9F3F6-908F-1849-2599-39C3685F62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3F49E5-4058-94F7-E473-7876203F5F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E14EF-D77F-4473-9A46-2ED1FD41306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794108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502727-8405-A725-1935-027B6EBBF3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4CABE2F-B449-DEE5-8C5D-6A36969D7E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E0BA39-B804-A1A6-62BD-01CCAAEC24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E1E8E-B936-401F-B34A-3DB4B71AE49B}" type="datetimeFigureOut">
              <a:rPr lang="en-IN" smtClean="0"/>
              <a:t>15-01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A90D82-40CD-4DB5-2B9B-BC1947B780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5EB289-98D9-E613-7872-08595EA818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E14EF-D77F-4473-9A46-2ED1FD41306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606616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054574E-4392-8748-7F95-448F868D444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0EB43FB-0D45-ADD9-5264-9EE7CE996A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A55618-2117-8BCE-39EE-01A4B3AAD8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E1E8E-B936-401F-B34A-3DB4B71AE49B}" type="datetimeFigureOut">
              <a:rPr lang="en-IN" smtClean="0"/>
              <a:t>15-01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F862C5-CD12-1D82-971C-CAF799CFB1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B01460-2495-E5A4-E8F9-B6B99967AC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E14EF-D77F-4473-9A46-2ED1FD41306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930121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7369EE-78A1-B849-6BBA-B7CB0D662E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58CC4D-2984-7073-50D6-B3F53467BC4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1E7DE0-911B-186F-01D9-47C1FF1989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E1E8E-B936-401F-B34A-3DB4B71AE49B}" type="datetimeFigureOut">
              <a:rPr lang="en-IN" smtClean="0"/>
              <a:t>15-01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A74FB0-379B-5646-D7CC-91DEF3766D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144AE4-8CFE-909D-06D3-A24DDAF3E2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E14EF-D77F-4473-9A46-2ED1FD41306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341162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56DF39-EAE4-5559-4032-810CC56E93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E68BD00-503E-E765-40D0-EFF5A4D9D8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7F7C3D-9FEA-E937-2BC0-1A80903494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E1E8E-B936-401F-B34A-3DB4B71AE49B}" type="datetimeFigureOut">
              <a:rPr lang="en-IN" smtClean="0"/>
              <a:t>15-01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1CA43A-7445-9758-3E70-16ACA38303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52A9C8-BF16-EF6A-DCCD-9BFE6F4152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E14EF-D77F-4473-9A46-2ED1FD41306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964194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216220-7C77-87F4-B9BC-8C82D457D9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DEC57E-83D8-40E4-50CF-B132C673FC5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C4C0C1A-4B7C-61FF-6A8F-E7D998BA64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69822AB-3D31-6C92-4793-449E5C83C7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E1E8E-B936-401F-B34A-3DB4B71AE49B}" type="datetimeFigureOut">
              <a:rPr lang="en-IN" smtClean="0"/>
              <a:t>15-01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28C165D-84CB-2725-23CD-C1E60BC7FD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0893C6-BABF-4562-DC60-8D3E34F9F9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E14EF-D77F-4473-9A46-2ED1FD41306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92449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859870-E5B0-FEFF-BD60-F4C6659EB5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B19C562-BB03-EE40-BBA7-428420621B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5E14FF9-5DCB-1333-CB62-C85C03BBA2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247E41B-1D8B-3862-3373-C04024C5D46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6ACEA63-107F-18BE-B63B-C025161AF02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2DF8842-6620-C585-7DF4-1965043909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E1E8E-B936-401F-B34A-3DB4B71AE49B}" type="datetimeFigureOut">
              <a:rPr lang="en-IN" smtClean="0"/>
              <a:t>15-01-2025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B4CBAB1-ABB6-69B6-6BE7-E2809868B5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46BB1E9-6848-9576-0345-61DC00BC0C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E14EF-D77F-4473-9A46-2ED1FD41306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753394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40C10E-1FD8-5D81-59BA-75F6783DDC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DD782C5-6F82-A6FE-E36F-DDED1C73F2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E1E8E-B936-401F-B34A-3DB4B71AE49B}" type="datetimeFigureOut">
              <a:rPr lang="en-IN" smtClean="0"/>
              <a:t>15-01-2025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DD74AEF-8384-2BED-3380-BFEBAB0A83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F1CD33C-072F-0C12-2DC9-F0FAB31046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E14EF-D77F-4473-9A46-2ED1FD41306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063687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E136F4E-5026-E6A0-F329-1654EA849A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E1E8E-B936-401F-B34A-3DB4B71AE49B}" type="datetimeFigureOut">
              <a:rPr lang="en-IN" smtClean="0"/>
              <a:t>15-01-2025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3AE5A05-405F-77E4-A7F0-4789DFB686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3956055-2DD5-CAB4-C342-02DF610102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E14EF-D77F-4473-9A46-2ED1FD41306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666980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48534D-4ED9-EC93-5F91-B40981A892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008653-A53F-4981-5D92-A9C19B57F83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FA0F71-9D87-10CA-B35B-FB87436C8B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48BF5FE-3B1C-4538-2C47-0675261170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E1E8E-B936-401F-B34A-3DB4B71AE49B}" type="datetimeFigureOut">
              <a:rPr lang="en-IN" smtClean="0"/>
              <a:t>15-01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E50738-6E30-5118-1529-5193317B71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0ABA07-FC4E-7C98-610A-99037B27DB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E14EF-D77F-4473-9A46-2ED1FD41306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35930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E0E57F-7C21-3849-EA08-2FC8315C43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36DB732-9F7A-E294-63A5-212A94041E6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D275A10-BDA0-2C9C-B58F-E0525C0472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5AE165-2663-D03D-A83F-1903D7A688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E1E8E-B936-401F-B34A-3DB4B71AE49B}" type="datetimeFigureOut">
              <a:rPr lang="en-IN" smtClean="0"/>
              <a:t>15-01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A8E8B3-BA0F-34CF-73FD-112A2B9A3A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E24FC1-40A6-EF57-4366-A183B8BC09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E14EF-D77F-4473-9A46-2ED1FD41306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910235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23155CD-39C2-5A05-AF14-DAABE0F565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855C4B4-4AEE-F8B9-0917-05A1E91658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221FCB-2995-9F11-EA49-2278AAEB3FC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5E1E8E-B936-401F-B34A-3DB4B71AE49B}" type="datetimeFigureOut">
              <a:rPr lang="en-IN" smtClean="0"/>
              <a:t>15-01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BCF46D-DCA0-14DA-3071-2241FFFD94F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5BBB7D-32F9-F84A-AB5F-F2BECA30FED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1E14EF-D77F-4473-9A46-2ED1FD41306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680440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3.emf"/><Relationship Id="rId7" Type="http://schemas.openxmlformats.org/officeDocument/2006/relationships/image" Target="../media/image5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4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8.bin"/><Relationship Id="rId13" Type="http://schemas.openxmlformats.org/officeDocument/2006/relationships/image" Target="../media/image12.emf"/><Relationship Id="rId3" Type="http://schemas.openxmlformats.org/officeDocument/2006/relationships/image" Target="../media/image7.emf"/><Relationship Id="rId7" Type="http://schemas.openxmlformats.org/officeDocument/2006/relationships/image" Target="../media/image9.emf"/><Relationship Id="rId12" Type="http://schemas.openxmlformats.org/officeDocument/2006/relationships/oleObject" Target="../embeddings/oleObject10.bin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7.bin"/><Relationship Id="rId11" Type="http://schemas.openxmlformats.org/officeDocument/2006/relationships/image" Target="../media/image11.emf"/><Relationship Id="rId5" Type="http://schemas.openxmlformats.org/officeDocument/2006/relationships/image" Target="../media/image8.emf"/><Relationship Id="rId10" Type="http://schemas.openxmlformats.org/officeDocument/2006/relationships/oleObject" Target="../embeddings/oleObject9.bin"/><Relationship Id="rId4" Type="http://schemas.openxmlformats.org/officeDocument/2006/relationships/oleObject" Target="../embeddings/oleObject6.bin"/><Relationship Id="rId9" Type="http://schemas.openxmlformats.org/officeDocument/2006/relationships/image" Target="../media/image10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4.bin"/><Relationship Id="rId3" Type="http://schemas.openxmlformats.org/officeDocument/2006/relationships/image" Target="../media/image13.emf"/><Relationship Id="rId7" Type="http://schemas.openxmlformats.org/officeDocument/2006/relationships/image" Target="../media/image15.emf"/><Relationship Id="rId2" Type="http://schemas.openxmlformats.org/officeDocument/2006/relationships/oleObject" Target="../embeddings/oleObject1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13.bin"/><Relationship Id="rId5" Type="http://schemas.openxmlformats.org/officeDocument/2006/relationships/image" Target="../media/image14.emf"/><Relationship Id="rId4" Type="http://schemas.openxmlformats.org/officeDocument/2006/relationships/oleObject" Target="../embeddings/oleObject12.bin"/><Relationship Id="rId9" Type="http://schemas.openxmlformats.org/officeDocument/2006/relationships/image" Target="../media/image16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8.bin"/><Relationship Id="rId13" Type="http://schemas.openxmlformats.org/officeDocument/2006/relationships/image" Target="../media/image22.emf"/><Relationship Id="rId3" Type="http://schemas.openxmlformats.org/officeDocument/2006/relationships/image" Target="../media/image17.emf"/><Relationship Id="rId7" Type="http://schemas.openxmlformats.org/officeDocument/2006/relationships/image" Target="../media/image19.emf"/><Relationship Id="rId12" Type="http://schemas.openxmlformats.org/officeDocument/2006/relationships/oleObject" Target="../embeddings/oleObject20.bin"/><Relationship Id="rId2" Type="http://schemas.openxmlformats.org/officeDocument/2006/relationships/oleObject" Target="../embeddings/oleObject15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17.bin"/><Relationship Id="rId11" Type="http://schemas.openxmlformats.org/officeDocument/2006/relationships/image" Target="../media/image21.emf"/><Relationship Id="rId5" Type="http://schemas.openxmlformats.org/officeDocument/2006/relationships/image" Target="../media/image18.emf"/><Relationship Id="rId10" Type="http://schemas.openxmlformats.org/officeDocument/2006/relationships/oleObject" Target="../embeddings/oleObject19.bin"/><Relationship Id="rId4" Type="http://schemas.openxmlformats.org/officeDocument/2006/relationships/oleObject" Target="../embeddings/oleObject16.bin"/><Relationship Id="rId9" Type="http://schemas.openxmlformats.org/officeDocument/2006/relationships/image" Target="../media/image20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emf"/><Relationship Id="rId13" Type="http://schemas.openxmlformats.org/officeDocument/2006/relationships/oleObject" Target="../embeddings/oleObject26.bin"/><Relationship Id="rId3" Type="http://schemas.openxmlformats.org/officeDocument/2006/relationships/oleObject" Target="../embeddings/oleObject21.bin"/><Relationship Id="rId7" Type="http://schemas.openxmlformats.org/officeDocument/2006/relationships/oleObject" Target="../embeddings/oleObject23.bin"/><Relationship Id="rId12" Type="http://schemas.openxmlformats.org/officeDocument/2006/relationships/image" Target="../media/image27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emf"/><Relationship Id="rId11" Type="http://schemas.openxmlformats.org/officeDocument/2006/relationships/oleObject" Target="../embeddings/oleObject25.bin"/><Relationship Id="rId5" Type="http://schemas.openxmlformats.org/officeDocument/2006/relationships/oleObject" Target="../embeddings/oleObject22.bin"/><Relationship Id="rId10" Type="http://schemas.openxmlformats.org/officeDocument/2006/relationships/image" Target="../media/image26.emf"/><Relationship Id="rId4" Type="http://schemas.openxmlformats.org/officeDocument/2006/relationships/image" Target="../media/image23.emf"/><Relationship Id="rId9" Type="http://schemas.openxmlformats.org/officeDocument/2006/relationships/oleObject" Target="../embeddings/oleObject24.bin"/><Relationship Id="rId14" Type="http://schemas.openxmlformats.org/officeDocument/2006/relationships/image" Target="../media/image28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0.bin"/><Relationship Id="rId3" Type="http://schemas.openxmlformats.org/officeDocument/2006/relationships/image" Target="../media/image29.emf"/><Relationship Id="rId7" Type="http://schemas.openxmlformats.org/officeDocument/2006/relationships/image" Target="../media/image31.emf"/><Relationship Id="rId2" Type="http://schemas.openxmlformats.org/officeDocument/2006/relationships/oleObject" Target="../embeddings/oleObject27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29.bin"/><Relationship Id="rId11" Type="http://schemas.openxmlformats.org/officeDocument/2006/relationships/image" Target="../media/image33.emf"/><Relationship Id="rId5" Type="http://schemas.openxmlformats.org/officeDocument/2006/relationships/image" Target="../media/image30.emf"/><Relationship Id="rId10" Type="http://schemas.openxmlformats.org/officeDocument/2006/relationships/oleObject" Target="../embeddings/oleObject31.bin"/><Relationship Id="rId4" Type="http://schemas.openxmlformats.org/officeDocument/2006/relationships/oleObject" Target="../embeddings/oleObject28.bin"/><Relationship Id="rId9" Type="http://schemas.openxmlformats.org/officeDocument/2006/relationships/image" Target="../media/image32.emf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53A9E32-7E4A-54F5-6448-1380A44C8756}"/>
              </a:ext>
            </a:extLst>
          </p:cNvPr>
          <p:cNvSpPr txBox="1"/>
          <p:nvPr/>
        </p:nvSpPr>
        <p:spPr>
          <a:xfrm>
            <a:off x="3772920" y="2904772"/>
            <a:ext cx="72092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          P      5M      5MP          10M     10MP              25P  25MP   50M     50MP   100M 100MP       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5CE7D497-7574-1D07-7BEC-55D870164B0E}"/>
              </a:ext>
            </a:extLst>
          </p:cNvPr>
          <p:cNvGrpSpPr/>
          <p:nvPr/>
        </p:nvGrpSpPr>
        <p:grpSpPr>
          <a:xfrm>
            <a:off x="2171223" y="436676"/>
            <a:ext cx="9643701" cy="2392681"/>
            <a:chOff x="1971040" y="3428998"/>
            <a:chExt cx="9643701" cy="2392681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32DF2FC2-7226-6C95-ED85-AE61BB1E062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25000"/>
                      </a14:imgEffect>
                      <a14:imgEffect>
                        <a14:saturation sat="3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052" t="2516" r="29911" b="4593"/>
            <a:stretch/>
          </p:blipFill>
          <p:spPr>
            <a:xfrm rot="16200000">
              <a:off x="4999078" y="400960"/>
              <a:ext cx="2392681" cy="8448757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B9E5A409-1A6F-EF9C-8FC5-20111E27E6CD}"/>
                </a:ext>
              </a:extLst>
            </p:cNvPr>
            <p:cNvSpPr txBox="1"/>
            <p:nvPr/>
          </p:nvSpPr>
          <p:spPr>
            <a:xfrm>
              <a:off x="3268880" y="3520500"/>
              <a:ext cx="834586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C         P      5M     5MP       10M       10MP              25P      25MP       50M       50MP         100M  100MP       </a:t>
              </a: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535984AC-2428-C20C-3C71-486E0EF865B3}"/>
              </a:ext>
            </a:extLst>
          </p:cNvPr>
          <p:cNvSpPr txBox="1"/>
          <p:nvPr/>
        </p:nvSpPr>
        <p:spPr>
          <a:xfrm>
            <a:off x="1734728" y="373589"/>
            <a:ext cx="4726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47E30BC-1AB2-F0E5-F2B1-CF7B936553CA}"/>
              </a:ext>
            </a:extLst>
          </p:cNvPr>
          <p:cNvSpPr txBox="1"/>
          <p:nvPr/>
        </p:nvSpPr>
        <p:spPr>
          <a:xfrm>
            <a:off x="1734727" y="3181070"/>
            <a:ext cx="4726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5578E38-ECEE-0D65-4DE2-17B23EC67678}"/>
              </a:ext>
            </a:extLst>
          </p:cNvPr>
          <p:cNvSpPr txBox="1"/>
          <p:nvPr/>
        </p:nvSpPr>
        <p:spPr>
          <a:xfrm>
            <a:off x="723104" y="5884246"/>
            <a:ext cx="1074579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: 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Effect of different concentrations of melatonin (5µM, 10µM, 25µM, 50µM and 100µM) on seedling growth under 18%PEG induced stress conditions. A. L-799 (drought sensitive) and B. Suraj (drought tolerant). 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C530405C-E33E-0374-E90F-DD24DDFD8518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55" t="31895" r="1887" b="33450"/>
          <a:stretch/>
        </p:blipFill>
        <p:spPr>
          <a:xfrm>
            <a:off x="2171221" y="2879385"/>
            <a:ext cx="8448757" cy="2454615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98ABE9A9-78C6-9173-D795-373DCEE60E53}"/>
              </a:ext>
            </a:extLst>
          </p:cNvPr>
          <p:cNvSpPr txBox="1"/>
          <p:nvPr/>
        </p:nvSpPr>
        <p:spPr>
          <a:xfrm>
            <a:off x="3205112" y="2968294"/>
            <a:ext cx="77770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           P            5M      5MP        10M     10MP       25P       25MP       50M       50MP         100M  100MP      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2C6ECAF-8CEA-855A-91EB-C26DA3A49670}"/>
              </a:ext>
            </a:extLst>
          </p:cNvPr>
          <p:cNvSpPr txBox="1"/>
          <p:nvPr/>
        </p:nvSpPr>
        <p:spPr>
          <a:xfrm>
            <a:off x="3634671" y="5351970"/>
            <a:ext cx="82905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 Control,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 PEG-treated,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 Melatonin primed control,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 Melatonin primed PEG-treated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79977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Box 35">
            <a:extLst>
              <a:ext uri="{FF2B5EF4-FFF2-40B4-BE49-F238E27FC236}">
                <a16:creationId xmlns:a16="http://schemas.microsoft.com/office/drawing/2014/main" id="{87BB0738-CA47-42CC-78F2-B54C1452A976}"/>
              </a:ext>
            </a:extLst>
          </p:cNvPr>
          <p:cNvSpPr txBox="1"/>
          <p:nvPr/>
        </p:nvSpPr>
        <p:spPr>
          <a:xfrm>
            <a:off x="1917376" y="361109"/>
            <a:ext cx="497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aphicFrame>
        <p:nvGraphicFramePr>
          <p:cNvPr id="74" name="Object 73">
            <a:extLst>
              <a:ext uri="{FF2B5EF4-FFF2-40B4-BE49-F238E27FC236}">
                <a16:creationId xmlns:a16="http://schemas.microsoft.com/office/drawing/2014/main" id="{9582BA0F-D6AB-AAF4-22F9-06E1E8999AC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55851600"/>
              </p:ext>
            </p:extLst>
          </p:nvPr>
        </p:nvGraphicFramePr>
        <p:xfrm>
          <a:off x="2086595" y="323954"/>
          <a:ext cx="4024313" cy="25288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4024289" imgH="2529450" progId="Prism8.Document">
                  <p:embed/>
                </p:oleObj>
              </mc:Choice>
              <mc:Fallback>
                <p:oleObj name="Prism 8" r:id="rId2" imgW="4024289" imgH="2529450" progId="Prism8.Document">
                  <p:embed/>
                  <p:pic>
                    <p:nvPicPr>
                      <p:cNvPr id="74" name="Object 73">
                        <a:extLst>
                          <a:ext uri="{FF2B5EF4-FFF2-40B4-BE49-F238E27FC236}">
                            <a16:creationId xmlns:a16="http://schemas.microsoft.com/office/drawing/2014/main" id="{9582BA0F-D6AB-AAF4-22F9-06E1E8999AC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086595" y="323954"/>
                        <a:ext cx="4024313" cy="25288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7" name="TextBox 36">
            <a:extLst>
              <a:ext uri="{FF2B5EF4-FFF2-40B4-BE49-F238E27FC236}">
                <a16:creationId xmlns:a16="http://schemas.microsoft.com/office/drawing/2014/main" id="{A4A722BF-9557-7C52-B7BA-48943AF77E51}"/>
              </a:ext>
            </a:extLst>
          </p:cNvPr>
          <p:cNvSpPr txBox="1"/>
          <p:nvPr/>
        </p:nvSpPr>
        <p:spPr>
          <a:xfrm>
            <a:off x="3821560" y="1430336"/>
            <a:ext cx="259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B1A60EF-94C4-146C-1F0B-65D3654CC128}"/>
              </a:ext>
            </a:extLst>
          </p:cNvPr>
          <p:cNvSpPr txBox="1"/>
          <p:nvPr/>
        </p:nvSpPr>
        <p:spPr>
          <a:xfrm>
            <a:off x="4655277" y="760494"/>
            <a:ext cx="259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DEAF5BD1-BB3C-E9B0-DD59-167E524B9C38}"/>
              </a:ext>
            </a:extLst>
          </p:cNvPr>
          <p:cNvSpPr txBox="1"/>
          <p:nvPr/>
        </p:nvSpPr>
        <p:spPr>
          <a:xfrm>
            <a:off x="4915253" y="1743978"/>
            <a:ext cx="259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5244F98-FEAB-94BD-8A96-3F9A123F2982}"/>
              </a:ext>
            </a:extLst>
          </p:cNvPr>
          <p:cNvSpPr txBox="1"/>
          <p:nvPr/>
        </p:nvSpPr>
        <p:spPr>
          <a:xfrm>
            <a:off x="5213695" y="1987947"/>
            <a:ext cx="259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E693FAB-91F5-24B0-674E-266F8CC87996}"/>
              </a:ext>
            </a:extLst>
          </p:cNvPr>
          <p:cNvSpPr txBox="1"/>
          <p:nvPr/>
        </p:nvSpPr>
        <p:spPr>
          <a:xfrm>
            <a:off x="3564835" y="1978979"/>
            <a:ext cx="259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259B7EB0-EF1F-84C0-9A04-31D292E7A6CE}"/>
              </a:ext>
            </a:extLst>
          </p:cNvPr>
          <p:cNvSpPr txBox="1"/>
          <p:nvPr/>
        </p:nvSpPr>
        <p:spPr>
          <a:xfrm>
            <a:off x="3006876" y="2039536"/>
            <a:ext cx="259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24EFEC84-7D1B-616B-5D5A-6FA8D75C2C40}"/>
              </a:ext>
            </a:extLst>
          </p:cNvPr>
          <p:cNvSpPr txBox="1"/>
          <p:nvPr/>
        </p:nvSpPr>
        <p:spPr>
          <a:xfrm>
            <a:off x="3275817" y="2184459"/>
            <a:ext cx="259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91B6CF63-6A84-36FE-42F6-DE3DD6D2EBB8}"/>
              </a:ext>
            </a:extLst>
          </p:cNvPr>
          <p:cNvSpPr txBox="1"/>
          <p:nvPr/>
        </p:nvSpPr>
        <p:spPr>
          <a:xfrm>
            <a:off x="4367068" y="2057467"/>
            <a:ext cx="259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A1659E5-0F27-80B3-E91E-D37A96A57748}"/>
              </a:ext>
            </a:extLst>
          </p:cNvPr>
          <p:cNvSpPr txBox="1"/>
          <p:nvPr/>
        </p:nvSpPr>
        <p:spPr>
          <a:xfrm>
            <a:off x="6003876" y="282979"/>
            <a:ext cx="497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53" name="Object 52">
            <a:extLst>
              <a:ext uri="{FF2B5EF4-FFF2-40B4-BE49-F238E27FC236}">
                <a16:creationId xmlns:a16="http://schemas.microsoft.com/office/drawing/2014/main" id="{B02AA6D9-280F-5F5B-7D7B-4ADC88E86F2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14765611"/>
              </p:ext>
            </p:extLst>
          </p:nvPr>
        </p:nvGraphicFramePr>
        <p:xfrm>
          <a:off x="6136002" y="303228"/>
          <a:ext cx="4014787" cy="25288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4015290" imgH="2529450" progId="Prism8.Document">
                  <p:embed/>
                </p:oleObj>
              </mc:Choice>
              <mc:Fallback>
                <p:oleObj name="Prism 8" r:id="rId4" imgW="4015290" imgH="2529450" progId="Prism8.Document">
                  <p:embed/>
                  <p:pic>
                    <p:nvPicPr>
                      <p:cNvPr id="53" name="Object 52">
                        <a:extLst>
                          <a:ext uri="{FF2B5EF4-FFF2-40B4-BE49-F238E27FC236}">
                            <a16:creationId xmlns:a16="http://schemas.microsoft.com/office/drawing/2014/main" id="{B02AA6D9-280F-5F5B-7D7B-4ADC88E86F2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136002" y="303228"/>
                        <a:ext cx="4014787" cy="25288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4" name="TextBox 53">
            <a:extLst>
              <a:ext uri="{FF2B5EF4-FFF2-40B4-BE49-F238E27FC236}">
                <a16:creationId xmlns:a16="http://schemas.microsoft.com/office/drawing/2014/main" id="{7FBED7AC-61BE-F436-AAAF-B250F84A987B}"/>
              </a:ext>
            </a:extLst>
          </p:cNvPr>
          <p:cNvSpPr txBox="1"/>
          <p:nvPr/>
        </p:nvSpPr>
        <p:spPr>
          <a:xfrm>
            <a:off x="7110913" y="1350954"/>
            <a:ext cx="259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91F766AA-7111-D7CB-8026-E416B91CBDBB}"/>
              </a:ext>
            </a:extLst>
          </p:cNvPr>
          <p:cNvSpPr txBox="1"/>
          <p:nvPr/>
        </p:nvSpPr>
        <p:spPr>
          <a:xfrm>
            <a:off x="7937415" y="686737"/>
            <a:ext cx="259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229EABD4-31F8-67CC-EC25-670598DA507E}"/>
              </a:ext>
            </a:extLst>
          </p:cNvPr>
          <p:cNvSpPr txBox="1"/>
          <p:nvPr/>
        </p:nvSpPr>
        <p:spPr>
          <a:xfrm>
            <a:off x="9028977" y="857595"/>
            <a:ext cx="259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6365E78-EEC7-F984-08FD-C4530BC82032}"/>
              </a:ext>
            </a:extLst>
          </p:cNvPr>
          <p:cNvSpPr txBox="1"/>
          <p:nvPr/>
        </p:nvSpPr>
        <p:spPr>
          <a:xfrm>
            <a:off x="9297893" y="1094358"/>
            <a:ext cx="259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5374AA03-B6B1-348B-538A-07A23612B5FC}"/>
              </a:ext>
            </a:extLst>
          </p:cNvPr>
          <p:cNvSpPr txBox="1"/>
          <p:nvPr/>
        </p:nvSpPr>
        <p:spPr>
          <a:xfrm>
            <a:off x="7669157" y="1417773"/>
            <a:ext cx="259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90B4396C-3AAD-0DC8-9752-4F753ECB78BF}"/>
              </a:ext>
            </a:extLst>
          </p:cNvPr>
          <p:cNvSpPr txBox="1"/>
          <p:nvPr/>
        </p:nvSpPr>
        <p:spPr>
          <a:xfrm>
            <a:off x="8752437" y="1263884"/>
            <a:ext cx="259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915E15EB-7C38-6912-9200-566EC1274B60}"/>
              </a:ext>
            </a:extLst>
          </p:cNvPr>
          <p:cNvSpPr txBox="1"/>
          <p:nvPr/>
        </p:nvSpPr>
        <p:spPr>
          <a:xfrm>
            <a:off x="8474531" y="1345378"/>
            <a:ext cx="259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23F5FF19-DB10-36AA-2073-29BBE6290A8F}"/>
              </a:ext>
            </a:extLst>
          </p:cNvPr>
          <p:cNvSpPr txBox="1"/>
          <p:nvPr/>
        </p:nvSpPr>
        <p:spPr>
          <a:xfrm>
            <a:off x="7381070" y="1380308"/>
            <a:ext cx="259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281C4850-3AE5-61C8-342E-555B5705884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92982061"/>
              </p:ext>
            </p:extLst>
          </p:nvPr>
        </p:nvGraphicFramePr>
        <p:xfrm>
          <a:off x="2198688" y="2978150"/>
          <a:ext cx="3687762" cy="2343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3919182" imgH="2491654" progId="Prism8.Document">
                  <p:embed/>
                </p:oleObj>
              </mc:Choice>
              <mc:Fallback>
                <p:oleObj name="Prism 8" r:id="rId6" imgW="3919182" imgH="2491654" progId="Prism8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281C4850-3AE5-61C8-342E-555B5705884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198688" y="2978150"/>
                        <a:ext cx="3687762" cy="2343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4" name="Group 13">
            <a:extLst>
              <a:ext uri="{FF2B5EF4-FFF2-40B4-BE49-F238E27FC236}">
                <a16:creationId xmlns:a16="http://schemas.microsoft.com/office/drawing/2014/main" id="{89C2BD0F-3CAD-5C8F-7BF6-997A0172D2D1}"/>
              </a:ext>
            </a:extLst>
          </p:cNvPr>
          <p:cNvGrpSpPr/>
          <p:nvPr/>
        </p:nvGrpSpPr>
        <p:grpSpPr>
          <a:xfrm>
            <a:off x="3044634" y="3144895"/>
            <a:ext cx="2398156" cy="1770751"/>
            <a:chOff x="1854099" y="724587"/>
            <a:chExt cx="2398156" cy="1770751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F355081C-E4A1-20C1-3C13-7F300B3C0EDE}"/>
                </a:ext>
              </a:extLst>
            </p:cNvPr>
            <p:cNvSpPr txBox="1"/>
            <p:nvPr/>
          </p:nvSpPr>
          <p:spPr>
            <a:xfrm>
              <a:off x="3919746" y="1670228"/>
              <a:ext cx="3325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7C3F42A-12C4-47C2-4681-E34689D6D0F0}"/>
                </a:ext>
              </a:extLst>
            </p:cNvPr>
            <p:cNvSpPr txBox="1"/>
            <p:nvPr/>
          </p:nvSpPr>
          <p:spPr>
            <a:xfrm>
              <a:off x="1854099" y="1975508"/>
              <a:ext cx="3325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AA7C498-815C-6644-E1B4-A3719DF93793}"/>
                </a:ext>
              </a:extLst>
            </p:cNvPr>
            <p:cNvSpPr txBox="1"/>
            <p:nvPr/>
          </p:nvSpPr>
          <p:spPr>
            <a:xfrm>
              <a:off x="2372192" y="2114007"/>
              <a:ext cx="3325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753A807E-B404-935D-4A59-1749CBCAFC54}"/>
                </a:ext>
              </a:extLst>
            </p:cNvPr>
            <p:cNvSpPr txBox="1"/>
            <p:nvPr/>
          </p:nvSpPr>
          <p:spPr>
            <a:xfrm>
              <a:off x="2619943" y="2218339"/>
              <a:ext cx="3325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E4128EE-6DC7-732B-24CE-1C9F3C5F35A8}"/>
                </a:ext>
              </a:extLst>
            </p:cNvPr>
            <p:cNvSpPr txBox="1"/>
            <p:nvPr/>
          </p:nvSpPr>
          <p:spPr>
            <a:xfrm>
              <a:off x="2101765" y="724587"/>
              <a:ext cx="3325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C5F4818-7EB5-198C-3A50-5FF3BE4693F2}"/>
                </a:ext>
              </a:extLst>
            </p:cNvPr>
            <p:cNvSpPr txBox="1"/>
            <p:nvPr/>
          </p:nvSpPr>
          <p:spPr>
            <a:xfrm>
              <a:off x="3656565" y="1818154"/>
              <a:ext cx="3325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99CA984-B5E8-E381-8EC0-C6F2943992E3}"/>
                </a:ext>
              </a:extLst>
            </p:cNvPr>
            <p:cNvSpPr txBox="1"/>
            <p:nvPr/>
          </p:nvSpPr>
          <p:spPr>
            <a:xfrm>
              <a:off x="3153902" y="1975508"/>
              <a:ext cx="3325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36072AF-1404-5A3E-5864-8A83E8AFAE16}"/>
                </a:ext>
              </a:extLst>
            </p:cNvPr>
            <p:cNvSpPr txBox="1"/>
            <p:nvPr/>
          </p:nvSpPr>
          <p:spPr>
            <a:xfrm>
              <a:off x="3401653" y="2167180"/>
              <a:ext cx="3325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A86DB8C2-10F3-0E93-9210-BC9AA878DEE8}"/>
              </a:ext>
            </a:extLst>
          </p:cNvPr>
          <p:cNvSpPr txBox="1"/>
          <p:nvPr/>
        </p:nvSpPr>
        <p:spPr>
          <a:xfrm>
            <a:off x="2041211" y="2797621"/>
            <a:ext cx="497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24" name="Object 23">
            <a:extLst>
              <a:ext uri="{FF2B5EF4-FFF2-40B4-BE49-F238E27FC236}">
                <a16:creationId xmlns:a16="http://schemas.microsoft.com/office/drawing/2014/main" id="{52F6DE2F-18B6-72A7-28A4-9DB0B565BBB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00810481"/>
              </p:ext>
            </p:extLst>
          </p:nvPr>
        </p:nvGraphicFramePr>
        <p:xfrm>
          <a:off x="6208066" y="2901708"/>
          <a:ext cx="3798888" cy="23764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3987934" imgH="2491654" progId="Prism8.Document">
                  <p:embed/>
                </p:oleObj>
              </mc:Choice>
              <mc:Fallback>
                <p:oleObj name="Prism 8" r:id="rId8" imgW="3987934" imgH="2491654" progId="Prism8.Document">
                  <p:embed/>
                  <p:pic>
                    <p:nvPicPr>
                      <p:cNvPr id="24" name="Object 23">
                        <a:extLst>
                          <a:ext uri="{FF2B5EF4-FFF2-40B4-BE49-F238E27FC236}">
                            <a16:creationId xmlns:a16="http://schemas.microsoft.com/office/drawing/2014/main" id="{52F6DE2F-18B6-72A7-28A4-9DB0B565BBB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6208066" y="2901708"/>
                        <a:ext cx="3798888" cy="23764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5" name="TextBox 24">
            <a:extLst>
              <a:ext uri="{FF2B5EF4-FFF2-40B4-BE49-F238E27FC236}">
                <a16:creationId xmlns:a16="http://schemas.microsoft.com/office/drawing/2014/main" id="{9054FAB6-5429-FF5A-718A-235398ED107D}"/>
              </a:ext>
            </a:extLst>
          </p:cNvPr>
          <p:cNvSpPr txBox="1"/>
          <p:nvPr/>
        </p:nvSpPr>
        <p:spPr>
          <a:xfrm>
            <a:off x="9229171" y="4383308"/>
            <a:ext cx="3325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93F851C-A3D7-17EC-46A4-C20B90260464}"/>
              </a:ext>
            </a:extLst>
          </p:cNvPr>
          <p:cNvSpPr txBox="1"/>
          <p:nvPr/>
        </p:nvSpPr>
        <p:spPr>
          <a:xfrm>
            <a:off x="7141114" y="4430762"/>
            <a:ext cx="3325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64193D8-7EAD-0B7F-7E6A-331B316424BB}"/>
              </a:ext>
            </a:extLst>
          </p:cNvPr>
          <p:cNvSpPr txBox="1"/>
          <p:nvPr/>
        </p:nvSpPr>
        <p:spPr>
          <a:xfrm>
            <a:off x="7651370" y="4514945"/>
            <a:ext cx="3325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2792AC6-8943-29E5-BED5-AF9DC7CA10D0}"/>
              </a:ext>
            </a:extLst>
          </p:cNvPr>
          <p:cNvSpPr txBox="1"/>
          <p:nvPr/>
        </p:nvSpPr>
        <p:spPr>
          <a:xfrm>
            <a:off x="7921541" y="4591566"/>
            <a:ext cx="3325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8CBF55A-3310-1175-DC94-D1EA938BE2F2}"/>
              </a:ext>
            </a:extLst>
          </p:cNvPr>
          <p:cNvSpPr txBox="1"/>
          <p:nvPr/>
        </p:nvSpPr>
        <p:spPr>
          <a:xfrm>
            <a:off x="7397541" y="3069202"/>
            <a:ext cx="3325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1D40EA8-EDDB-06D0-597A-0AE5CF574E3B}"/>
              </a:ext>
            </a:extLst>
          </p:cNvPr>
          <p:cNvSpPr txBox="1"/>
          <p:nvPr/>
        </p:nvSpPr>
        <p:spPr>
          <a:xfrm>
            <a:off x="8951214" y="4417396"/>
            <a:ext cx="3325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894E2E5-A6BF-5422-61F1-5F081323F045}"/>
              </a:ext>
            </a:extLst>
          </p:cNvPr>
          <p:cNvSpPr txBox="1"/>
          <p:nvPr/>
        </p:nvSpPr>
        <p:spPr>
          <a:xfrm>
            <a:off x="8440958" y="4450333"/>
            <a:ext cx="3325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4BC1492-BD61-BD89-D4A8-83ACFFED97B4}"/>
              </a:ext>
            </a:extLst>
          </p:cNvPr>
          <p:cNvSpPr txBox="1"/>
          <p:nvPr/>
        </p:nvSpPr>
        <p:spPr>
          <a:xfrm>
            <a:off x="8692300" y="4575405"/>
            <a:ext cx="3325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1EB7ADD-CCFA-6D25-14C4-719017B83BA1}"/>
              </a:ext>
            </a:extLst>
          </p:cNvPr>
          <p:cNvSpPr txBox="1"/>
          <p:nvPr/>
        </p:nvSpPr>
        <p:spPr>
          <a:xfrm>
            <a:off x="6164857" y="2848765"/>
            <a:ext cx="497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893E8AA-9081-ED8E-3CAC-000AACFFE7D8}"/>
              </a:ext>
            </a:extLst>
          </p:cNvPr>
          <p:cNvSpPr txBox="1"/>
          <p:nvPr/>
        </p:nvSpPr>
        <p:spPr>
          <a:xfrm>
            <a:off x="448175" y="5685483"/>
            <a:ext cx="1155599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: 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Effect of melatonin priming on melatonin and MGO biosynthesises and signalling under optimal and PEG-induced stress conditions in drought sensitive (L-799) and drought tolerant (Suraj) varieties of cotton (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Gossypium hirsutum 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L.). A) ) Relative fold change expression of melatonin biosynthesis gens 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SNAT2, 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B) Melatonin signalling receptor 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PMTR1, 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C) MGO biosynthesis genes 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MGS1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 and D) 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SSAO1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data represent mean values ± SE of 3 independent experiments, with 3 replicates per treatment in each experiment. Different alphabets within the group represent significant differences among the treatments according to Duncan’s multiple range test (DMRT) at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value ≤ 0.05.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A45B19D-FF2B-62CC-488A-475B376E9E37}"/>
              </a:ext>
            </a:extLst>
          </p:cNvPr>
          <p:cNvSpPr txBox="1"/>
          <p:nvPr/>
        </p:nvSpPr>
        <p:spPr>
          <a:xfrm>
            <a:off x="2908038" y="5201371"/>
            <a:ext cx="82905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 Control,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 PEG-treated,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 Melatonin primed control,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 Melatonin primed PEG-treated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57125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AE29DB8B-C67F-0CD3-AF6C-911FC92ACAB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75316082"/>
              </p:ext>
            </p:extLst>
          </p:nvPr>
        </p:nvGraphicFramePr>
        <p:xfrm>
          <a:off x="138113" y="363538"/>
          <a:ext cx="3919537" cy="24939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919182" imgH="2494534" progId="Prism8.Document">
                  <p:embed/>
                </p:oleObj>
              </mc:Choice>
              <mc:Fallback>
                <p:oleObj name="Prism 8" r:id="rId2" imgW="3919182" imgH="2494534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AE29DB8B-C67F-0CD3-AF6C-911FC92ACAB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38113" y="363538"/>
                        <a:ext cx="3919537" cy="24939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8A6931B3-6696-FDD4-E227-892D9A36B3A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1333424"/>
              </p:ext>
            </p:extLst>
          </p:nvPr>
        </p:nvGraphicFramePr>
        <p:xfrm>
          <a:off x="4370527" y="342922"/>
          <a:ext cx="3919538" cy="2492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3919182" imgH="2491654" progId="Prism8.Document">
                  <p:embed/>
                </p:oleObj>
              </mc:Choice>
              <mc:Fallback>
                <p:oleObj name="Prism 8" r:id="rId4" imgW="3919182" imgH="2491654" progId="Prism8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8A6931B3-6696-FDD4-E227-892D9A36B3A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370527" y="342922"/>
                        <a:ext cx="3919538" cy="2492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723A3773-AE12-B7AF-4575-9A4080967CA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99417179"/>
              </p:ext>
            </p:extLst>
          </p:nvPr>
        </p:nvGraphicFramePr>
        <p:xfrm>
          <a:off x="8150589" y="310201"/>
          <a:ext cx="3919538" cy="2492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3919182" imgH="2491654" progId="Prism8.Document">
                  <p:embed/>
                </p:oleObj>
              </mc:Choice>
              <mc:Fallback>
                <p:oleObj name="Prism 8" r:id="rId6" imgW="3919182" imgH="2491654" progId="Prism8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723A3773-AE12-B7AF-4575-9A4080967CA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8150589" y="310201"/>
                        <a:ext cx="3919538" cy="2492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DE6E03D5-64AB-A36D-E699-D31CB5DDCD5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21501570"/>
              </p:ext>
            </p:extLst>
          </p:nvPr>
        </p:nvGraphicFramePr>
        <p:xfrm>
          <a:off x="105755" y="2925665"/>
          <a:ext cx="4014788" cy="25288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4015290" imgH="2529450" progId="Prism8.Document">
                  <p:embed/>
                </p:oleObj>
              </mc:Choice>
              <mc:Fallback>
                <p:oleObj name="Prism 8" r:id="rId8" imgW="4015290" imgH="2529450" progId="Prism8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DE6E03D5-64AB-A36D-E699-D31CB5DDCD5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05755" y="2925665"/>
                        <a:ext cx="4014788" cy="25288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BA57CEAF-4DD6-8B5C-5653-A251101F218D}"/>
              </a:ext>
            </a:extLst>
          </p:cNvPr>
          <p:cNvSpPr txBox="1"/>
          <p:nvPr/>
        </p:nvSpPr>
        <p:spPr>
          <a:xfrm>
            <a:off x="6108297" y="1417378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0652589-F1EC-8F8D-DC1C-5B2FD724E4F4}"/>
              </a:ext>
            </a:extLst>
          </p:cNvPr>
          <p:cNvSpPr txBox="1"/>
          <p:nvPr/>
        </p:nvSpPr>
        <p:spPr>
          <a:xfrm>
            <a:off x="5285018" y="1966235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4D9D58A-4758-6C9B-38A4-5472B2438B15}"/>
              </a:ext>
            </a:extLst>
          </p:cNvPr>
          <p:cNvSpPr txBox="1"/>
          <p:nvPr/>
        </p:nvSpPr>
        <p:spPr>
          <a:xfrm>
            <a:off x="6643462" y="1952081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E37F05C-5F38-0534-D567-B4F099AC2C4F}"/>
              </a:ext>
            </a:extLst>
          </p:cNvPr>
          <p:cNvSpPr txBox="1"/>
          <p:nvPr/>
        </p:nvSpPr>
        <p:spPr>
          <a:xfrm>
            <a:off x="5563875" y="2148870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08ABB28-82E0-DDFA-8AEF-09C451C94DB2}"/>
              </a:ext>
            </a:extLst>
          </p:cNvPr>
          <p:cNvSpPr txBox="1"/>
          <p:nvPr/>
        </p:nvSpPr>
        <p:spPr>
          <a:xfrm>
            <a:off x="6933821" y="460104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9EC0849-C5D2-138B-D0F1-557005837861}"/>
              </a:ext>
            </a:extLst>
          </p:cNvPr>
          <p:cNvSpPr txBox="1"/>
          <p:nvPr/>
        </p:nvSpPr>
        <p:spPr>
          <a:xfrm>
            <a:off x="9611347" y="1929301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691E6F9-BC14-E443-8DE5-67F370F19E30}"/>
              </a:ext>
            </a:extLst>
          </p:cNvPr>
          <p:cNvSpPr txBox="1"/>
          <p:nvPr/>
        </p:nvSpPr>
        <p:spPr>
          <a:xfrm>
            <a:off x="5842732" y="1888300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6AF6714-DC98-BD1C-06CB-C99A4B76F02A}"/>
              </a:ext>
            </a:extLst>
          </p:cNvPr>
          <p:cNvSpPr txBox="1"/>
          <p:nvPr/>
        </p:nvSpPr>
        <p:spPr>
          <a:xfrm>
            <a:off x="3275550" y="3412335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7EB095B-B9C6-7602-1117-7493F01381C4}"/>
              </a:ext>
            </a:extLst>
          </p:cNvPr>
          <p:cNvSpPr txBox="1"/>
          <p:nvPr/>
        </p:nvSpPr>
        <p:spPr>
          <a:xfrm>
            <a:off x="7474232" y="1555877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CF05F66-002B-349B-6DA9-FA519B9395B4}"/>
              </a:ext>
            </a:extLst>
          </p:cNvPr>
          <p:cNvSpPr txBox="1"/>
          <p:nvPr/>
        </p:nvSpPr>
        <p:spPr>
          <a:xfrm>
            <a:off x="7201587" y="1726461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13B94E3-FA44-70B2-E348-D2648CFA334B}"/>
              </a:ext>
            </a:extLst>
          </p:cNvPr>
          <p:cNvSpPr txBox="1"/>
          <p:nvPr/>
        </p:nvSpPr>
        <p:spPr>
          <a:xfrm>
            <a:off x="9314770" y="2145579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C60B3A8-A9F6-2D42-D205-DB2E8668FD52}"/>
              </a:ext>
            </a:extLst>
          </p:cNvPr>
          <p:cNvSpPr txBox="1"/>
          <p:nvPr/>
        </p:nvSpPr>
        <p:spPr>
          <a:xfrm>
            <a:off x="9050188" y="2050067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C4FED33-1519-7116-6A49-D693773D7268}"/>
              </a:ext>
            </a:extLst>
          </p:cNvPr>
          <p:cNvSpPr txBox="1"/>
          <p:nvPr/>
        </p:nvSpPr>
        <p:spPr>
          <a:xfrm>
            <a:off x="10987763" y="1927608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E21A076-31AF-B248-B463-BCB001FA2C01}"/>
              </a:ext>
            </a:extLst>
          </p:cNvPr>
          <p:cNvSpPr txBox="1"/>
          <p:nvPr/>
        </p:nvSpPr>
        <p:spPr>
          <a:xfrm flipH="1">
            <a:off x="11246763" y="1727469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237536C-9171-828C-7E36-401C616ECBA1}"/>
              </a:ext>
            </a:extLst>
          </p:cNvPr>
          <p:cNvSpPr txBox="1"/>
          <p:nvPr/>
        </p:nvSpPr>
        <p:spPr>
          <a:xfrm>
            <a:off x="1896582" y="3982203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3CD6825-9099-4E6F-4A08-E53AC2EFEC18}"/>
              </a:ext>
            </a:extLst>
          </p:cNvPr>
          <p:cNvSpPr txBox="1"/>
          <p:nvPr/>
        </p:nvSpPr>
        <p:spPr>
          <a:xfrm>
            <a:off x="9892545" y="1356809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D1867C09-5677-1265-E828-9FD8BA9F3291}"/>
              </a:ext>
            </a:extLst>
          </p:cNvPr>
          <p:cNvSpPr txBox="1"/>
          <p:nvPr/>
        </p:nvSpPr>
        <p:spPr>
          <a:xfrm>
            <a:off x="2445805" y="4041775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7E7035F-954E-4C49-AC64-46B2C8C19FEB}"/>
              </a:ext>
            </a:extLst>
          </p:cNvPr>
          <p:cNvSpPr txBox="1"/>
          <p:nvPr/>
        </p:nvSpPr>
        <p:spPr>
          <a:xfrm>
            <a:off x="10695498" y="988046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365936F9-480C-14D8-DD9E-A08E4D7C1F8E}"/>
              </a:ext>
            </a:extLst>
          </p:cNvPr>
          <p:cNvSpPr txBox="1"/>
          <p:nvPr/>
        </p:nvSpPr>
        <p:spPr>
          <a:xfrm>
            <a:off x="10425719" y="2039161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A424C49-D2BE-C8BC-86F7-6140236D6D7C}"/>
              </a:ext>
            </a:extLst>
          </p:cNvPr>
          <p:cNvSpPr txBox="1"/>
          <p:nvPr/>
        </p:nvSpPr>
        <p:spPr>
          <a:xfrm>
            <a:off x="1359706" y="4318774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72CE2055-B3BC-2064-FC00-F2FDA807C071}"/>
              </a:ext>
            </a:extLst>
          </p:cNvPr>
          <p:cNvSpPr txBox="1"/>
          <p:nvPr/>
        </p:nvSpPr>
        <p:spPr>
          <a:xfrm>
            <a:off x="1626803" y="4272946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21B9476-F577-EDE1-6A5B-FEB84EE13633}"/>
              </a:ext>
            </a:extLst>
          </p:cNvPr>
          <p:cNvSpPr txBox="1"/>
          <p:nvPr/>
        </p:nvSpPr>
        <p:spPr>
          <a:xfrm>
            <a:off x="1085801" y="4011989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A3507351-BACF-FB3C-2ABC-DF1E1FE08973}"/>
              </a:ext>
            </a:extLst>
          </p:cNvPr>
          <p:cNvSpPr txBox="1"/>
          <p:nvPr/>
        </p:nvSpPr>
        <p:spPr>
          <a:xfrm>
            <a:off x="2728829" y="3549395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B71BCAC9-F3C9-9FDC-0707-F24CA715EA72}"/>
              </a:ext>
            </a:extLst>
          </p:cNvPr>
          <p:cNvSpPr txBox="1"/>
          <p:nvPr/>
        </p:nvSpPr>
        <p:spPr>
          <a:xfrm>
            <a:off x="2989729" y="3112579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7" name="Group 66">
            <a:extLst>
              <a:ext uri="{FF2B5EF4-FFF2-40B4-BE49-F238E27FC236}">
                <a16:creationId xmlns:a16="http://schemas.microsoft.com/office/drawing/2014/main" id="{9BD5995C-0805-C546-CCC5-87888C3D497B}"/>
              </a:ext>
            </a:extLst>
          </p:cNvPr>
          <p:cNvGrpSpPr/>
          <p:nvPr/>
        </p:nvGrpSpPr>
        <p:grpSpPr>
          <a:xfrm>
            <a:off x="4303399" y="2905223"/>
            <a:ext cx="3976688" cy="2528888"/>
            <a:chOff x="4303399" y="2914650"/>
            <a:chExt cx="3976688" cy="2528888"/>
          </a:xfrm>
        </p:grpSpPr>
        <p:graphicFrame>
          <p:nvGraphicFramePr>
            <p:cNvPr id="7" name="Object 6">
              <a:extLst>
                <a:ext uri="{FF2B5EF4-FFF2-40B4-BE49-F238E27FC236}">
                  <a16:creationId xmlns:a16="http://schemas.microsoft.com/office/drawing/2014/main" id="{6C7784FF-BEDB-1B78-6991-414278E3242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80689263"/>
                </p:ext>
              </p:extLst>
            </p:nvPr>
          </p:nvGraphicFramePr>
          <p:xfrm>
            <a:off x="4303399" y="2914650"/>
            <a:ext cx="3976688" cy="25288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0" imgW="3977135" imgH="2529450" progId="Prism8.Document">
                    <p:embed/>
                  </p:oleObj>
                </mc:Choice>
                <mc:Fallback>
                  <p:oleObj name="Prism 8" r:id="rId10" imgW="3977135" imgH="2529450" progId="Prism8.Document">
                    <p:embed/>
                    <p:pic>
                      <p:nvPicPr>
                        <p:cNvPr id="7" name="Object 6">
                          <a:extLst>
                            <a:ext uri="{FF2B5EF4-FFF2-40B4-BE49-F238E27FC236}">
                              <a16:creationId xmlns:a16="http://schemas.microsoft.com/office/drawing/2014/main" id="{6C7784FF-BEDB-1B78-6991-414278E3242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4303399" y="2914650"/>
                          <a:ext cx="3976688" cy="25288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7DCCD3B6-270D-88D0-8AAA-87C315E035D0}"/>
                </a:ext>
              </a:extLst>
            </p:cNvPr>
            <p:cNvSpPr txBox="1"/>
            <p:nvPr/>
          </p:nvSpPr>
          <p:spPr>
            <a:xfrm>
              <a:off x="5241269" y="4586348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D00107AD-66A2-25E4-62EC-9816EE64C7DD}"/>
                </a:ext>
              </a:extLst>
            </p:cNvPr>
            <p:cNvSpPr txBox="1"/>
            <p:nvPr/>
          </p:nvSpPr>
          <p:spPr>
            <a:xfrm>
              <a:off x="5795792" y="4540520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1D87B9F6-BB66-E905-C3C0-8AE868A949D6}"/>
                </a:ext>
              </a:extLst>
            </p:cNvPr>
            <p:cNvSpPr txBox="1"/>
            <p:nvPr/>
          </p:nvSpPr>
          <p:spPr>
            <a:xfrm>
              <a:off x="7456100" y="4241912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23E7D93F-BDB0-AE4A-C9B7-26477F35499C}"/>
                </a:ext>
              </a:extLst>
            </p:cNvPr>
            <p:cNvSpPr txBox="1"/>
            <p:nvPr/>
          </p:nvSpPr>
          <p:spPr>
            <a:xfrm>
              <a:off x="6063752" y="4123309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8C7B58DE-7AB0-9D39-1256-02F7A7B2D182}"/>
                </a:ext>
              </a:extLst>
            </p:cNvPr>
            <p:cNvSpPr txBox="1"/>
            <p:nvPr/>
          </p:nvSpPr>
          <p:spPr>
            <a:xfrm>
              <a:off x="6600650" y="4592082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E5E1E0E0-7126-A1BD-7E97-4908FFE52E82}"/>
                </a:ext>
              </a:extLst>
            </p:cNvPr>
            <p:cNvSpPr txBox="1"/>
            <p:nvPr/>
          </p:nvSpPr>
          <p:spPr>
            <a:xfrm>
              <a:off x="6881535" y="3076025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4486B85C-F751-1A63-268B-834907D8FA46}"/>
                </a:ext>
              </a:extLst>
            </p:cNvPr>
            <p:cNvSpPr txBox="1"/>
            <p:nvPr/>
          </p:nvSpPr>
          <p:spPr>
            <a:xfrm>
              <a:off x="5499624" y="4767080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97388C44-AD17-ADD5-61DD-9F91F1F0B244}"/>
                </a:ext>
              </a:extLst>
            </p:cNvPr>
            <p:cNvSpPr txBox="1"/>
            <p:nvPr/>
          </p:nvSpPr>
          <p:spPr>
            <a:xfrm>
              <a:off x="7170278" y="4375815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1" name="TextBox 50">
            <a:extLst>
              <a:ext uri="{FF2B5EF4-FFF2-40B4-BE49-F238E27FC236}">
                <a16:creationId xmlns:a16="http://schemas.microsoft.com/office/drawing/2014/main" id="{7313FD69-28EA-61A3-A8FE-35E36339AA12}"/>
              </a:ext>
            </a:extLst>
          </p:cNvPr>
          <p:cNvSpPr txBox="1"/>
          <p:nvPr/>
        </p:nvSpPr>
        <p:spPr>
          <a:xfrm>
            <a:off x="5781909" y="7659003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287A98AE-B610-EF2E-515C-1CF27993EC8A}"/>
              </a:ext>
            </a:extLst>
          </p:cNvPr>
          <p:cNvSpPr txBox="1"/>
          <p:nvPr/>
        </p:nvSpPr>
        <p:spPr>
          <a:xfrm>
            <a:off x="5934309" y="7811403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345F8BA8-B506-BB81-2F00-1DF3066F05E6}"/>
              </a:ext>
            </a:extLst>
          </p:cNvPr>
          <p:cNvSpPr txBox="1"/>
          <p:nvPr/>
        </p:nvSpPr>
        <p:spPr>
          <a:xfrm>
            <a:off x="7805311" y="7826267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8" name="Group 67">
            <a:extLst>
              <a:ext uri="{FF2B5EF4-FFF2-40B4-BE49-F238E27FC236}">
                <a16:creationId xmlns:a16="http://schemas.microsoft.com/office/drawing/2014/main" id="{A26C88E6-0797-F86F-FD5F-019AF713A63F}"/>
              </a:ext>
            </a:extLst>
          </p:cNvPr>
          <p:cNvGrpSpPr/>
          <p:nvPr/>
        </p:nvGrpSpPr>
        <p:grpSpPr>
          <a:xfrm>
            <a:off x="8139065" y="2883580"/>
            <a:ext cx="3976687" cy="2528888"/>
            <a:chOff x="8042893" y="2903142"/>
            <a:chExt cx="3976687" cy="2528888"/>
          </a:xfrm>
        </p:grpSpPr>
        <p:graphicFrame>
          <p:nvGraphicFramePr>
            <p:cNvPr id="8" name="Object 7">
              <a:extLst>
                <a:ext uri="{FF2B5EF4-FFF2-40B4-BE49-F238E27FC236}">
                  <a16:creationId xmlns:a16="http://schemas.microsoft.com/office/drawing/2014/main" id="{76A39E21-2AC3-D5DA-1282-670B5D23EB1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94995339"/>
                </p:ext>
              </p:extLst>
            </p:nvPr>
          </p:nvGraphicFramePr>
          <p:xfrm>
            <a:off x="8042893" y="2903142"/>
            <a:ext cx="3976687" cy="25288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2" imgW="3977135" imgH="2529450" progId="Prism8.Document">
                    <p:embed/>
                  </p:oleObj>
                </mc:Choice>
                <mc:Fallback>
                  <p:oleObj name="Prism 8" r:id="rId12" imgW="3977135" imgH="2529450" progId="Prism8.Document">
                    <p:embed/>
                    <p:pic>
                      <p:nvPicPr>
                        <p:cNvPr id="8" name="Object 7">
                          <a:extLst>
                            <a:ext uri="{FF2B5EF4-FFF2-40B4-BE49-F238E27FC236}">
                              <a16:creationId xmlns:a16="http://schemas.microsoft.com/office/drawing/2014/main" id="{76A39E21-2AC3-D5DA-1282-670B5D23EB1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8042893" y="2903142"/>
                          <a:ext cx="3976687" cy="25288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6F4BC04B-8E0D-FA41-049C-066E1F0B561F}"/>
                </a:ext>
              </a:extLst>
            </p:cNvPr>
            <p:cNvSpPr txBox="1"/>
            <p:nvPr/>
          </p:nvSpPr>
          <p:spPr>
            <a:xfrm>
              <a:off x="11163630" y="4228400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F64C1DEA-9C92-A89C-631C-B1B13C7F2FF4}"/>
                </a:ext>
              </a:extLst>
            </p:cNvPr>
            <p:cNvSpPr txBox="1"/>
            <p:nvPr/>
          </p:nvSpPr>
          <p:spPr>
            <a:xfrm>
              <a:off x="10877149" y="4457273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9EA7C9E4-EBF9-EB88-D9B5-EFF62E889B55}"/>
                </a:ext>
              </a:extLst>
            </p:cNvPr>
            <p:cNvSpPr txBox="1"/>
            <p:nvPr/>
          </p:nvSpPr>
          <p:spPr>
            <a:xfrm>
              <a:off x="9524317" y="4457861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441A41AE-D379-E909-03B3-B27CA58EE332}"/>
                </a:ext>
              </a:extLst>
            </p:cNvPr>
            <p:cNvSpPr txBox="1"/>
            <p:nvPr/>
          </p:nvSpPr>
          <p:spPr>
            <a:xfrm>
              <a:off x="8964163" y="4628059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CE531E9D-1D31-95BE-A2AE-7F6244B52676}"/>
                </a:ext>
              </a:extLst>
            </p:cNvPr>
            <p:cNvSpPr txBox="1"/>
            <p:nvPr/>
          </p:nvSpPr>
          <p:spPr>
            <a:xfrm>
              <a:off x="10306563" y="4639058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57523F1F-A0A3-5716-8820-C49B46C08484}"/>
                </a:ext>
              </a:extLst>
            </p:cNvPr>
            <p:cNvSpPr txBox="1"/>
            <p:nvPr/>
          </p:nvSpPr>
          <p:spPr>
            <a:xfrm>
              <a:off x="9788484" y="3754213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E7686CEC-1B52-A4F4-D6E3-7D654D381829}"/>
                </a:ext>
              </a:extLst>
            </p:cNvPr>
            <p:cNvSpPr txBox="1"/>
            <p:nvPr/>
          </p:nvSpPr>
          <p:spPr>
            <a:xfrm>
              <a:off x="10605093" y="3524619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8F5B7EEF-8BB7-A659-0376-A1D46E73D363}"/>
                </a:ext>
              </a:extLst>
            </p:cNvPr>
            <p:cNvSpPr txBox="1"/>
            <p:nvPr/>
          </p:nvSpPr>
          <p:spPr>
            <a:xfrm>
              <a:off x="9212365" y="4752614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0D5814F1-D99A-86C0-0A32-24D92EC539D0}"/>
              </a:ext>
            </a:extLst>
          </p:cNvPr>
          <p:cNvSpPr txBox="1"/>
          <p:nvPr/>
        </p:nvSpPr>
        <p:spPr>
          <a:xfrm>
            <a:off x="160719" y="308238"/>
            <a:ext cx="497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63BD568-DD70-0197-2D7E-0636EDD9D3E2}"/>
              </a:ext>
            </a:extLst>
          </p:cNvPr>
          <p:cNvSpPr txBox="1"/>
          <p:nvPr/>
        </p:nvSpPr>
        <p:spPr>
          <a:xfrm>
            <a:off x="4359435" y="259517"/>
            <a:ext cx="497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6306226-196A-F1DC-3BC4-B4D1725F152A}"/>
              </a:ext>
            </a:extLst>
          </p:cNvPr>
          <p:cNvSpPr txBox="1"/>
          <p:nvPr/>
        </p:nvSpPr>
        <p:spPr>
          <a:xfrm>
            <a:off x="8151027" y="259517"/>
            <a:ext cx="497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2C263D5-CC83-C995-B3CA-E0EB7ED0ACFB}"/>
              </a:ext>
            </a:extLst>
          </p:cNvPr>
          <p:cNvSpPr txBox="1"/>
          <p:nvPr/>
        </p:nvSpPr>
        <p:spPr>
          <a:xfrm>
            <a:off x="119662" y="2808451"/>
            <a:ext cx="497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7F99F03-52D1-53C6-2487-D44B19FA20CF}"/>
              </a:ext>
            </a:extLst>
          </p:cNvPr>
          <p:cNvSpPr txBox="1"/>
          <p:nvPr/>
        </p:nvSpPr>
        <p:spPr>
          <a:xfrm>
            <a:off x="4249899" y="2765994"/>
            <a:ext cx="497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D93C07E-6AB7-A731-6281-B2DCBFDBE208}"/>
              </a:ext>
            </a:extLst>
          </p:cNvPr>
          <p:cNvSpPr txBox="1"/>
          <p:nvPr/>
        </p:nvSpPr>
        <p:spPr>
          <a:xfrm>
            <a:off x="8185154" y="2759742"/>
            <a:ext cx="497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E83812B-CE3C-73B3-BB34-48BB33894D0B}"/>
              </a:ext>
            </a:extLst>
          </p:cNvPr>
          <p:cNvSpPr txBox="1"/>
          <p:nvPr/>
        </p:nvSpPr>
        <p:spPr>
          <a:xfrm>
            <a:off x="233180" y="5737854"/>
            <a:ext cx="1172564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: 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Effect of melatonin priming on glyoxalase and non glyoxalase system under optimal and PEG-induced stress conditions in drought sensitive (L-799) and drought tolerant (Suraj) varieties of cotton (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Gossypium hirsutum 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L.). A) Relative fold change expression of glyoxalase genes 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GLYI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 B) 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GLYII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 C) 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GLYIII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 E) Relative fold change expression of non glyoxalase genes 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MGR1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, E) 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MGD1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 F) 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LDH5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data represent mean values ± SE of 3 independent experiments, with 3 replicates per treatment in each experiment. Different alphabets within the group represent significant differences among the treatments according to Duncan’s multiple range test (DMRT) at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value ≤ 0.05.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5DD1302-00DC-2B88-D93C-0C96DFBFA0F8}"/>
              </a:ext>
            </a:extLst>
          </p:cNvPr>
          <p:cNvSpPr txBox="1"/>
          <p:nvPr/>
        </p:nvSpPr>
        <p:spPr>
          <a:xfrm>
            <a:off x="1874588" y="1445245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FCF8A96-FDB4-FCE2-D911-2ED57619DD2D}"/>
              </a:ext>
            </a:extLst>
          </p:cNvPr>
          <p:cNvSpPr txBox="1"/>
          <p:nvPr/>
        </p:nvSpPr>
        <p:spPr>
          <a:xfrm>
            <a:off x="1587396" y="1917650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1A78948-B329-219E-3242-7A3B5B15C8BB}"/>
              </a:ext>
            </a:extLst>
          </p:cNvPr>
          <p:cNvSpPr txBox="1"/>
          <p:nvPr/>
        </p:nvSpPr>
        <p:spPr>
          <a:xfrm>
            <a:off x="1355066" y="2210691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962ECD73-F2EA-2931-B551-B8BB337C8246}"/>
              </a:ext>
            </a:extLst>
          </p:cNvPr>
          <p:cNvSpPr txBox="1"/>
          <p:nvPr/>
        </p:nvSpPr>
        <p:spPr>
          <a:xfrm>
            <a:off x="1047804" y="1989503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44F4F5F6-8E8D-D86A-8EBB-ACB0D64413EE}"/>
              </a:ext>
            </a:extLst>
          </p:cNvPr>
          <p:cNvSpPr txBox="1"/>
          <p:nvPr/>
        </p:nvSpPr>
        <p:spPr>
          <a:xfrm>
            <a:off x="2412103" y="1981045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84A2A223-1E46-2AD7-0F86-87423FE956FC}"/>
              </a:ext>
            </a:extLst>
          </p:cNvPr>
          <p:cNvSpPr txBox="1"/>
          <p:nvPr/>
        </p:nvSpPr>
        <p:spPr>
          <a:xfrm>
            <a:off x="2679889" y="456636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64AF73FB-9207-E0FD-D392-86F9406F29CF}"/>
              </a:ext>
            </a:extLst>
          </p:cNvPr>
          <p:cNvSpPr txBox="1"/>
          <p:nvPr/>
        </p:nvSpPr>
        <p:spPr>
          <a:xfrm>
            <a:off x="2948265" y="1755383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BCEE3022-AF6B-A15D-0FBF-8B80404419FC}"/>
              </a:ext>
            </a:extLst>
          </p:cNvPr>
          <p:cNvSpPr txBox="1"/>
          <p:nvPr/>
        </p:nvSpPr>
        <p:spPr>
          <a:xfrm>
            <a:off x="3212833" y="2117980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F8EF8554-8D8C-D0C3-802F-CA69FD1BD17F}"/>
              </a:ext>
            </a:extLst>
          </p:cNvPr>
          <p:cNvSpPr txBox="1"/>
          <p:nvPr/>
        </p:nvSpPr>
        <p:spPr>
          <a:xfrm>
            <a:off x="2846862" y="5418720"/>
            <a:ext cx="82905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 Control,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 PEG-treated,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 Melatonin primed control,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 Melatonin primed PEG-treated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627260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Group 41">
            <a:extLst>
              <a:ext uri="{FF2B5EF4-FFF2-40B4-BE49-F238E27FC236}">
                <a16:creationId xmlns:a16="http://schemas.microsoft.com/office/drawing/2014/main" id="{BA2BA095-5CB0-456C-6C03-CD512AB06038}"/>
              </a:ext>
            </a:extLst>
          </p:cNvPr>
          <p:cNvGrpSpPr/>
          <p:nvPr/>
        </p:nvGrpSpPr>
        <p:grpSpPr>
          <a:xfrm>
            <a:off x="1642965" y="2980443"/>
            <a:ext cx="3984625" cy="2528888"/>
            <a:chOff x="6283148" y="573205"/>
            <a:chExt cx="3984625" cy="2528888"/>
          </a:xfrm>
        </p:grpSpPr>
        <p:graphicFrame>
          <p:nvGraphicFramePr>
            <p:cNvPr id="43" name="Object 42">
              <a:extLst>
                <a:ext uri="{FF2B5EF4-FFF2-40B4-BE49-F238E27FC236}">
                  <a16:creationId xmlns:a16="http://schemas.microsoft.com/office/drawing/2014/main" id="{B3E4CA0F-631C-5B81-75C4-1E749A229DB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59460272"/>
                </p:ext>
              </p:extLst>
            </p:nvPr>
          </p:nvGraphicFramePr>
          <p:xfrm>
            <a:off x="6283148" y="573205"/>
            <a:ext cx="3984625" cy="25288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" imgW="3984694" imgH="2529450" progId="Prism8.Document">
                    <p:embed/>
                  </p:oleObj>
                </mc:Choice>
                <mc:Fallback>
                  <p:oleObj name="Prism 8" r:id="rId2" imgW="3984694" imgH="2529450" progId="Prism8.Document">
                    <p:embed/>
                    <p:pic>
                      <p:nvPicPr>
                        <p:cNvPr id="43" name="Object 42">
                          <a:extLst>
                            <a:ext uri="{FF2B5EF4-FFF2-40B4-BE49-F238E27FC236}">
                              <a16:creationId xmlns:a16="http://schemas.microsoft.com/office/drawing/2014/main" id="{B3E4CA0F-631C-5B81-75C4-1E749A229DB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6283148" y="573205"/>
                          <a:ext cx="3984625" cy="25288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4662396F-304D-6FAC-F315-22353DEF4A3F}"/>
                </a:ext>
              </a:extLst>
            </p:cNvPr>
            <p:cNvSpPr txBox="1"/>
            <p:nvPr/>
          </p:nvSpPr>
          <p:spPr>
            <a:xfrm>
              <a:off x="8042797" y="1002491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F32FCB18-7E05-BEFE-7DAA-61BE0F48BF22}"/>
                </a:ext>
              </a:extLst>
            </p:cNvPr>
            <p:cNvSpPr txBox="1"/>
            <p:nvPr/>
          </p:nvSpPr>
          <p:spPr>
            <a:xfrm>
              <a:off x="7220941" y="1529449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9B65261B-6EF3-932E-C549-2A1576E5320E}"/>
                </a:ext>
              </a:extLst>
            </p:cNvPr>
            <p:cNvSpPr txBox="1"/>
            <p:nvPr/>
          </p:nvSpPr>
          <p:spPr>
            <a:xfrm>
              <a:off x="7506940" y="1429811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446961A9-38BF-5EE7-4208-3FDAC7708E7C}"/>
                </a:ext>
              </a:extLst>
            </p:cNvPr>
            <p:cNvSpPr txBox="1"/>
            <p:nvPr/>
          </p:nvSpPr>
          <p:spPr>
            <a:xfrm>
              <a:off x="7792092" y="1559265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3044303C-19EC-B2C5-5BB5-211D12306CCC}"/>
                </a:ext>
              </a:extLst>
            </p:cNvPr>
            <p:cNvSpPr txBox="1"/>
            <p:nvPr/>
          </p:nvSpPr>
          <p:spPr>
            <a:xfrm>
              <a:off x="9147160" y="1503239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33442FCE-62E1-AC2B-CDAD-3D224E10EAAC}"/>
                </a:ext>
              </a:extLst>
            </p:cNvPr>
            <p:cNvSpPr txBox="1"/>
            <p:nvPr/>
          </p:nvSpPr>
          <p:spPr>
            <a:xfrm>
              <a:off x="9416759" y="992552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4B8A101F-7C47-B5BB-EC06-C4790E09F7AA}"/>
                </a:ext>
              </a:extLst>
            </p:cNvPr>
            <p:cNvSpPr txBox="1"/>
            <p:nvPr/>
          </p:nvSpPr>
          <p:spPr>
            <a:xfrm>
              <a:off x="8860744" y="982613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029BC72E-69D3-86EA-E9AF-A6C1BCFC96B5}"/>
                </a:ext>
              </a:extLst>
            </p:cNvPr>
            <p:cNvSpPr txBox="1"/>
            <p:nvPr/>
          </p:nvSpPr>
          <p:spPr>
            <a:xfrm>
              <a:off x="8590220" y="1508872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D6AADE52-97E5-F983-C845-9186BBF5544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5696085"/>
              </p:ext>
            </p:extLst>
          </p:nvPr>
        </p:nvGraphicFramePr>
        <p:xfrm>
          <a:off x="1539875" y="347663"/>
          <a:ext cx="4186238" cy="25288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4185908" imgH="2529450" progId="Prism8.Document">
                  <p:embed/>
                </p:oleObj>
              </mc:Choice>
              <mc:Fallback>
                <p:oleObj name="Prism 8" r:id="rId4" imgW="4185908" imgH="2529450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D6AADE52-97E5-F983-C845-9186BBF5544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539875" y="347663"/>
                        <a:ext cx="4186238" cy="25288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73AD402C-9DF6-4C55-BDEA-7FD5F536696A}"/>
              </a:ext>
            </a:extLst>
          </p:cNvPr>
          <p:cNvSpPr txBox="1"/>
          <p:nvPr/>
        </p:nvSpPr>
        <p:spPr>
          <a:xfrm>
            <a:off x="2765421" y="1896557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7785191-F5C4-6628-ECE4-8DBA86348ADC}"/>
              </a:ext>
            </a:extLst>
          </p:cNvPr>
          <p:cNvSpPr txBox="1"/>
          <p:nvPr/>
        </p:nvSpPr>
        <p:spPr>
          <a:xfrm>
            <a:off x="3867554" y="1330327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D2929A1-0B9B-7432-6FEC-02132D5A5AFA}"/>
              </a:ext>
            </a:extLst>
          </p:cNvPr>
          <p:cNvSpPr txBox="1"/>
          <p:nvPr/>
        </p:nvSpPr>
        <p:spPr>
          <a:xfrm>
            <a:off x="2500911" y="1396702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8CFA8F1-FD5F-76FA-BACB-CB8C22EA72F9}"/>
              </a:ext>
            </a:extLst>
          </p:cNvPr>
          <p:cNvSpPr txBox="1"/>
          <p:nvPr/>
        </p:nvSpPr>
        <p:spPr>
          <a:xfrm>
            <a:off x="3048230" y="1415556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D4F7D8B-B7F7-5DBA-CA46-C88479BCE4BD}"/>
              </a:ext>
            </a:extLst>
          </p:cNvPr>
          <p:cNvSpPr txBox="1"/>
          <p:nvPr/>
        </p:nvSpPr>
        <p:spPr>
          <a:xfrm>
            <a:off x="4424497" y="1191830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79D71AF-CF20-3029-B966-D5594053919F}"/>
              </a:ext>
            </a:extLst>
          </p:cNvPr>
          <p:cNvSpPr txBox="1"/>
          <p:nvPr/>
        </p:nvSpPr>
        <p:spPr>
          <a:xfrm>
            <a:off x="4128258" y="924258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5FC15DE-3D45-7143-5735-1953A02FB9A5}"/>
              </a:ext>
            </a:extLst>
          </p:cNvPr>
          <p:cNvSpPr txBox="1"/>
          <p:nvPr/>
        </p:nvSpPr>
        <p:spPr>
          <a:xfrm>
            <a:off x="3319199" y="1232848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5C132174-440C-B58A-EFC2-01034CDD5DC6}"/>
              </a:ext>
            </a:extLst>
          </p:cNvPr>
          <p:cNvSpPr txBox="1"/>
          <p:nvPr/>
        </p:nvSpPr>
        <p:spPr>
          <a:xfrm>
            <a:off x="4675242" y="875272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0AE8EC0-24EB-27E8-5B32-458B2132279A}"/>
              </a:ext>
            </a:extLst>
          </p:cNvPr>
          <p:cNvSpPr txBox="1"/>
          <p:nvPr/>
        </p:nvSpPr>
        <p:spPr>
          <a:xfrm>
            <a:off x="1721906" y="347331"/>
            <a:ext cx="497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CA6B97B9-84A2-6103-69F0-C24B4690D2BF}"/>
              </a:ext>
            </a:extLst>
          </p:cNvPr>
          <p:cNvGrpSpPr/>
          <p:nvPr/>
        </p:nvGrpSpPr>
        <p:grpSpPr>
          <a:xfrm>
            <a:off x="6078636" y="333993"/>
            <a:ext cx="3992562" cy="2623931"/>
            <a:chOff x="4590382" y="313996"/>
            <a:chExt cx="3992562" cy="2623931"/>
          </a:xfrm>
        </p:grpSpPr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DD396BB2-0A83-E3A9-34A7-9BF060E9711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51376981"/>
                </p:ext>
              </p:extLst>
            </p:nvPr>
          </p:nvGraphicFramePr>
          <p:xfrm>
            <a:off x="4590382" y="409040"/>
            <a:ext cx="3992562" cy="25288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6" imgW="3992253" imgH="2529450" progId="Prism8.Document">
                    <p:embed/>
                  </p:oleObj>
                </mc:Choice>
                <mc:Fallback>
                  <p:oleObj name="Prism 8" r:id="rId6" imgW="3992253" imgH="2529450" progId="Prism8.Document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DD396BB2-0A83-E3A9-34A7-9BF060E9711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4590382" y="409040"/>
                          <a:ext cx="3992562" cy="25288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055D7DA0-91FD-43E2-5602-7EC9BB69993D}"/>
                </a:ext>
              </a:extLst>
            </p:cNvPr>
            <p:cNvSpPr txBox="1"/>
            <p:nvPr/>
          </p:nvSpPr>
          <p:spPr>
            <a:xfrm>
              <a:off x="7473923" y="1902608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0BA978A-E64B-7F0C-0623-AE9AC6CC1F62}"/>
                </a:ext>
              </a:extLst>
            </p:cNvPr>
            <p:cNvSpPr txBox="1"/>
            <p:nvPr/>
          </p:nvSpPr>
          <p:spPr>
            <a:xfrm>
              <a:off x="6916982" y="1744061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3B73B666-CCA9-C5D8-71E6-02DAB1A5D2F2}"/>
                </a:ext>
              </a:extLst>
            </p:cNvPr>
            <p:cNvSpPr txBox="1"/>
            <p:nvPr/>
          </p:nvSpPr>
          <p:spPr>
            <a:xfrm>
              <a:off x="7735094" y="1347416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D6608F3D-B9F6-4C81-61DF-925C2AB6536E}"/>
                </a:ext>
              </a:extLst>
            </p:cNvPr>
            <p:cNvSpPr txBox="1"/>
            <p:nvPr/>
          </p:nvSpPr>
          <p:spPr>
            <a:xfrm>
              <a:off x="7185298" y="1237574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0E25244C-35B5-DB3A-8F59-2C1BA03CB714}"/>
                </a:ext>
              </a:extLst>
            </p:cNvPr>
            <p:cNvSpPr txBox="1"/>
            <p:nvPr/>
          </p:nvSpPr>
          <p:spPr>
            <a:xfrm>
              <a:off x="5820842" y="695988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EF2D05F5-DF33-757A-0BF3-9C09BE192E87}"/>
                </a:ext>
              </a:extLst>
            </p:cNvPr>
            <p:cNvSpPr txBox="1"/>
            <p:nvPr/>
          </p:nvSpPr>
          <p:spPr>
            <a:xfrm>
              <a:off x="6333844" y="824869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4AFD179E-3BBD-84C8-1CCE-BBDB10DBECDF}"/>
                </a:ext>
              </a:extLst>
            </p:cNvPr>
            <p:cNvSpPr txBox="1"/>
            <p:nvPr/>
          </p:nvSpPr>
          <p:spPr>
            <a:xfrm>
              <a:off x="5552784" y="1625609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D5A5229B-C4B8-12C2-F84E-5D7161AB7255}"/>
                </a:ext>
              </a:extLst>
            </p:cNvPr>
            <p:cNvSpPr txBox="1"/>
            <p:nvPr/>
          </p:nvSpPr>
          <p:spPr>
            <a:xfrm>
              <a:off x="6100298" y="1680491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1244157E-6E24-04C4-3FB8-C9A6AD739B92}"/>
                </a:ext>
              </a:extLst>
            </p:cNvPr>
            <p:cNvSpPr txBox="1"/>
            <p:nvPr/>
          </p:nvSpPr>
          <p:spPr>
            <a:xfrm>
              <a:off x="4699662" y="313996"/>
              <a:ext cx="4977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07B2007E-D651-CD9E-D1C4-D9A126BCE40F}"/>
              </a:ext>
            </a:extLst>
          </p:cNvPr>
          <p:cNvSpPr txBox="1"/>
          <p:nvPr/>
        </p:nvSpPr>
        <p:spPr>
          <a:xfrm>
            <a:off x="516491" y="5890565"/>
            <a:ext cx="1152430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: 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Effect of melatonin priming on glutathione pool under optimal and PEG-induced stress conditions in drought sensitive (L-799) and drought tolerant (Suraj) varieties of cotton (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Gossypium hirsutum 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L.). A) Reduced glutathione content GSH B) Oxidised glutathione content GSSG C) Total glutathione content D) Relative fold expression of Glutathione reductase (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GR1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data represent mean values ± SE of 3 independent experiments, with 3 replicates per treatment in each experiment. Different alphabets within the group represent significant differences among the treatments according to Duncan’s multiple range test (DMRT) at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value ≤ 0.05.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58A49BBC-C617-EC91-2F5F-D6065F6D747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34534552"/>
              </p:ext>
            </p:extLst>
          </p:nvPr>
        </p:nvGraphicFramePr>
        <p:xfrm>
          <a:off x="6086556" y="2970918"/>
          <a:ext cx="3976687" cy="25288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3977135" imgH="2529450" progId="Prism8.Document">
                  <p:embed/>
                </p:oleObj>
              </mc:Choice>
              <mc:Fallback>
                <p:oleObj name="Prism 8" r:id="rId8" imgW="3977135" imgH="2529450" progId="Prism8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58A49BBC-C617-EC91-2F5F-D6065F6D747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6086556" y="2970918"/>
                        <a:ext cx="3976687" cy="25288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" name="TextBox 29">
            <a:extLst>
              <a:ext uri="{FF2B5EF4-FFF2-40B4-BE49-F238E27FC236}">
                <a16:creationId xmlns:a16="http://schemas.microsoft.com/office/drawing/2014/main" id="{3D34BE1A-2FC3-67FD-F658-C822C9D2AE5D}"/>
              </a:ext>
            </a:extLst>
          </p:cNvPr>
          <p:cNvSpPr txBox="1"/>
          <p:nvPr/>
        </p:nvSpPr>
        <p:spPr>
          <a:xfrm>
            <a:off x="7838805" y="4199931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41A3EC2-DA72-6FE2-DB91-02CA7082056A}"/>
              </a:ext>
            </a:extLst>
          </p:cNvPr>
          <p:cNvSpPr txBox="1"/>
          <p:nvPr/>
        </p:nvSpPr>
        <p:spPr>
          <a:xfrm>
            <a:off x="7297154" y="4816522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16C2FF8-B262-D969-B56D-560183E2A8B1}"/>
              </a:ext>
            </a:extLst>
          </p:cNvPr>
          <p:cNvSpPr txBox="1"/>
          <p:nvPr/>
        </p:nvSpPr>
        <p:spPr>
          <a:xfrm>
            <a:off x="7010496" y="4692637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323EA5AA-E55D-93E5-4FEA-D6F9DE996817}"/>
              </a:ext>
            </a:extLst>
          </p:cNvPr>
          <p:cNvSpPr txBox="1"/>
          <p:nvPr/>
        </p:nvSpPr>
        <p:spPr>
          <a:xfrm>
            <a:off x="7583811" y="4692638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160DB7A-3A20-D1D5-6EA7-42EDE3BDE300}"/>
              </a:ext>
            </a:extLst>
          </p:cNvPr>
          <p:cNvSpPr txBox="1"/>
          <p:nvPr/>
        </p:nvSpPr>
        <p:spPr>
          <a:xfrm>
            <a:off x="8400680" y="4717621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FAAA399-9AC4-1D15-26F5-36D267DEB0EC}"/>
              </a:ext>
            </a:extLst>
          </p:cNvPr>
          <p:cNvSpPr txBox="1"/>
          <p:nvPr/>
        </p:nvSpPr>
        <p:spPr>
          <a:xfrm>
            <a:off x="8938028" y="4569526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135AD0E-A550-7F0E-8D15-262C756F1575}"/>
              </a:ext>
            </a:extLst>
          </p:cNvPr>
          <p:cNvSpPr txBox="1"/>
          <p:nvPr/>
        </p:nvSpPr>
        <p:spPr>
          <a:xfrm>
            <a:off x="8650049" y="3737363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E7F6EF5-1866-FE4F-2447-B58E1D1F3CE5}"/>
              </a:ext>
            </a:extLst>
          </p:cNvPr>
          <p:cNvSpPr txBox="1"/>
          <p:nvPr/>
        </p:nvSpPr>
        <p:spPr>
          <a:xfrm>
            <a:off x="9205784" y="3594375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B71CA5C-946D-F921-83CD-DD5C91F6450A}"/>
              </a:ext>
            </a:extLst>
          </p:cNvPr>
          <p:cNvSpPr txBox="1"/>
          <p:nvPr/>
        </p:nvSpPr>
        <p:spPr>
          <a:xfrm>
            <a:off x="1667946" y="2885730"/>
            <a:ext cx="497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500121C-C6C5-A09B-CE08-8B3BBD517129}"/>
              </a:ext>
            </a:extLst>
          </p:cNvPr>
          <p:cNvSpPr txBox="1"/>
          <p:nvPr/>
        </p:nvSpPr>
        <p:spPr>
          <a:xfrm>
            <a:off x="6278643" y="2887975"/>
            <a:ext cx="497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D54EC00-F25D-4A2B-8F86-77E09FB6815F}"/>
              </a:ext>
            </a:extLst>
          </p:cNvPr>
          <p:cNvSpPr txBox="1"/>
          <p:nvPr/>
        </p:nvSpPr>
        <p:spPr>
          <a:xfrm>
            <a:off x="2831410" y="5372875"/>
            <a:ext cx="82905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 Control,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 PEG-treated,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 Melatonin primed control,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 Melatonin primed PEG-treated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607364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" name="Group 46">
            <a:extLst>
              <a:ext uri="{FF2B5EF4-FFF2-40B4-BE49-F238E27FC236}">
                <a16:creationId xmlns:a16="http://schemas.microsoft.com/office/drawing/2014/main" id="{630EA5DC-CF73-A824-6215-2452557CFEBE}"/>
              </a:ext>
            </a:extLst>
          </p:cNvPr>
          <p:cNvGrpSpPr/>
          <p:nvPr/>
        </p:nvGrpSpPr>
        <p:grpSpPr>
          <a:xfrm>
            <a:off x="4354678" y="2907444"/>
            <a:ext cx="3908425" cy="2528888"/>
            <a:chOff x="342029" y="413177"/>
            <a:chExt cx="3908425" cy="2528888"/>
          </a:xfrm>
        </p:grpSpPr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id="{C9B24112-CB4C-994E-3C5C-116F789CF98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84713194"/>
                </p:ext>
              </p:extLst>
            </p:nvPr>
          </p:nvGraphicFramePr>
          <p:xfrm>
            <a:off x="342029" y="413177"/>
            <a:ext cx="3908425" cy="25288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" imgW="3908744" imgH="2529450" progId="Prism8.Document">
                    <p:embed/>
                  </p:oleObj>
                </mc:Choice>
                <mc:Fallback>
                  <p:oleObj name="Prism 8" r:id="rId2" imgW="3908744" imgH="2529450" progId="Prism8.Document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id="{C9B24112-CB4C-994E-3C5C-116F789CF98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342029" y="413177"/>
                          <a:ext cx="3908425" cy="25288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1C54BDCC-6A18-D653-E8E3-6A0E58FA4D20}"/>
                </a:ext>
              </a:extLst>
            </p:cNvPr>
            <p:cNvSpPr txBox="1"/>
            <p:nvPr/>
          </p:nvSpPr>
          <p:spPr>
            <a:xfrm>
              <a:off x="1216166" y="1313965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DFD72518-BE1E-05F5-A24B-049FD132B8EB}"/>
                </a:ext>
              </a:extLst>
            </p:cNvPr>
            <p:cNvSpPr txBox="1"/>
            <p:nvPr/>
          </p:nvSpPr>
          <p:spPr>
            <a:xfrm>
              <a:off x="1483422" y="545802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716584C-2CC6-6F16-E005-C8F8A646F029}"/>
                </a:ext>
              </a:extLst>
            </p:cNvPr>
            <p:cNvSpPr txBox="1"/>
            <p:nvPr/>
          </p:nvSpPr>
          <p:spPr>
            <a:xfrm>
              <a:off x="1747591" y="1317595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1DA0C535-616C-11A3-9E15-3BD19B43605A}"/>
                </a:ext>
              </a:extLst>
            </p:cNvPr>
            <p:cNvSpPr txBox="1"/>
            <p:nvPr/>
          </p:nvSpPr>
          <p:spPr>
            <a:xfrm>
              <a:off x="2038672" y="1424057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98F7CD28-2AD5-C0AA-4458-77600DE29D16}"/>
                </a:ext>
              </a:extLst>
            </p:cNvPr>
            <p:cNvSpPr txBox="1"/>
            <p:nvPr/>
          </p:nvSpPr>
          <p:spPr>
            <a:xfrm>
              <a:off x="2845253" y="1453306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6AADC9AB-CF89-CDA6-8E86-49A709CD200C}"/>
                </a:ext>
              </a:extLst>
            </p:cNvPr>
            <p:cNvSpPr txBox="1"/>
            <p:nvPr/>
          </p:nvSpPr>
          <p:spPr>
            <a:xfrm>
              <a:off x="3131379" y="1042018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5DF75E6-93F1-9B67-F6A0-E27400E62788}"/>
                </a:ext>
              </a:extLst>
            </p:cNvPr>
            <p:cNvSpPr txBox="1"/>
            <p:nvPr/>
          </p:nvSpPr>
          <p:spPr>
            <a:xfrm>
              <a:off x="3406271" y="1051565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85C74B7-B316-5C7D-1B39-F194986F9964}"/>
                </a:ext>
              </a:extLst>
            </p:cNvPr>
            <p:cNvSpPr txBox="1"/>
            <p:nvPr/>
          </p:nvSpPr>
          <p:spPr>
            <a:xfrm>
              <a:off x="2580418" y="1119838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08680BD1-56AA-08A3-4C59-D77EB9FC2E5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39598856"/>
              </p:ext>
            </p:extLst>
          </p:nvPr>
        </p:nvGraphicFramePr>
        <p:xfrm>
          <a:off x="494793" y="243027"/>
          <a:ext cx="3892550" cy="25288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3893266" imgH="2529450" progId="Prism8.Document">
                  <p:embed/>
                </p:oleObj>
              </mc:Choice>
              <mc:Fallback>
                <p:oleObj name="Prism 8" r:id="rId4" imgW="3893266" imgH="2529450" progId="Prism8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08680BD1-56AA-08A3-4C59-D77EB9FC2E5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94793" y="243027"/>
                        <a:ext cx="3892550" cy="25288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53" name="Group 52">
            <a:extLst>
              <a:ext uri="{FF2B5EF4-FFF2-40B4-BE49-F238E27FC236}">
                <a16:creationId xmlns:a16="http://schemas.microsoft.com/office/drawing/2014/main" id="{F4A7615C-0562-5542-FEE7-5DD7A20F9B22}"/>
              </a:ext>
            </a:extLst>
          </p:cNvPr>
          <p:cNvGrpSpPr/>
          <p:nvPr/>
        </p:nvGrpSpPr>
        <p:grpSpPr>
          <a:xfrm>
            <a:off x="1335222" y="641823"/>
            <a:ext cx="2499434" cy="1424864"/>
            <a:chOff x="1335222" y="641823"/>
            <a:chExt cx="2499434" cy="1424864"/>
          </a:xfrm>
        </p:grpSpPr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752149F7-3C20-1ED5-3233-0E2E3DA1DDFD}"/>
                </a:ext>
              </a:extLst>
            </p:cNvPr>
            <p:cNvSpPr txBox="1"/>
            <p:nvPr/>
          </p:nvSpPr>
          <p:spPr>
            <a:xfrm>
              <a:off x="3244150" y="1263156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018CAF6-2AE0-6F24-C370-501C5D97015A}"/>
                </a:ext>
              </a:extLst>
            </p:cNvPr>
            <p:cNvSpPr txBox="1"/>
            <p:nvPr/>
          </p:nvSpPr>
          <p:spPr>
            <a:xfrm>
              <a:off x="1868449" y="1789688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48A0EB6-01AD-57E4-06AC-D2D124AEE04A}"/>
                </a:ext>
              </a:extLst>
            </p:cNvPr>
            <p:cNvSpPr txBox="1"/>
            <p:nvPr/>
          </p:nvSpPr>
          <p:spPr>
            <a:xfrm>
              <a:off x="2148886" y="1709559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60D01463-20A7-0E21-65FB-118F66A0C0D5}"/>
                </a:ext>
              </a:extLst>
            </p:cNvPr>
            <p:cNvSpPr txBox="1"/>
            <p:nvPr/>
          </p:nvSpPr>
          <p:spPr>
            <a:xfrm>
              <a:off x="1335222" y="1723699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5E9EB035-5829-D0F1-CDF8-465FB6EBD1B9}"/>
                </a:ext>
              </a:extLst>
            </p:cNvPr>
            <p:cNvSpPr txBox="1"/>
            <p:nvPr/>
          </p:nvSpPr>
          <p:spPr>
            <a:xfrm>
              <a:off x="1599172" y="641823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6EC9D0FC-0AD9-E1F2-09E5-7FA4EEBC8A4A}"/>
                </a:ext>
              </a:extLst>
            </p:cNvPr>
            <p:cNvSpPr txBox="1"/>
            <p:nvPr/>
          </p:nvSpPr>
          <p:spPr>
            <a:xfrm>
              <a:off x="3500709" y="1533303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0AFC5264-6AA0-3A2F-B52D-FF729B4E3F67}"/>
                </a:ext>
              </a:extLst>
            </p:cNvPr>
            <p:cNvSpPr txBox="1"/>
            <p:nvPr/>
          </p:nvSpPr>
          <p:spPr>
            <a:xfrm>
              <a:off x="2700747" y="1728412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62A01442-9AA9-D458-7623-731CB962DCD9}"/>
                </a:ext>
              </a:extLst>
            </p:cNvPr>
            <p:cNvSpPr txBox="1"/>
            <p:nvPr/>
          </p:nvSpPr>
          <p:spPr>
            <a:xfrm>
              <a:off x="2981184" y="1703035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834305F0-E043-801C-C35A-859F5A3AAF98}"/>
              </a:ext>
            </a:extLst>
          </p:cNvPr>
          <p:cNvSpPr txBox="1"/>
          <p:nvPr/>
        </p:nvSpPr>
        <p:spPr>
          <a:xfrm>
            <a:off x="460782" y="184669"/>
            <a:ext cx="497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1470719-FEC6-E48A-6820-F43C34BBD9B7}"/>
              </a:ext>
            </a:extLst>
          </p:cNvPr>
          <p:cNvSpPr txBox="1"/>
          <p:nvPr/>
        </p:nvSpPr>
        <p:spPr>
          <a:xfrm>
            <a:off x="404219" y="2635978"/>
            <a:ext cx="497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50" name="Group 49">
            <a:extLst>
              <a:ext uri="{FF2B5EF4-FFF2-40B4-BE49-F238E27FC236}">
                <a16:creationId xmlns:a16="http://schemas.microsoft.com/office/drawing/2014/main" id="{FB33A40C-52B2-0D09-6268-401073F424D4}"/>
              </a:ext>
            </a:extLst>
          </p:cNvPr>
          <p:cNvGrpSpPr/>
          <p:nvPr/>
        </p:nvGrpSpPr>
        <p:grpSpPr>
          <a:xfrm>
            <a:off x="4399345" y="291723"/>
            <a:ext cx="3892550" cy="2528888"/>
            <a:chOff x="8357984" y="365465"/>
            <a:chExt cx="3892550" cy="2528888"/>
          </a:xfrm>
        </p:grpSpPr>
        <p:graphicFrame>
          <p:nvGraphicFramePr>
            <p:cNvPr id="22" name="Object 21">
              <a:extLst>
                <a:ext uri="{FF2B5EF4-FFF2-40B4-BE49-F238E27FC236}">
                  <a16:creationId xmlns:a16="http://schemas.microsoft.com/office/drawing/2014/main" id="{702BA7EF-3362-5858-A5A3-87105A107FF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92279806"/>
                </p:ext>
              </p:extLst>
            </p:nvPr>
          </p:nvGraphicFramePr>
          <p:xfrm>
            <a:off x="8357984" y="365465"/>
            <a:ext cx="3892550" cy="25288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6" imgW="3893266" imgH="2529450" progId="Prism8.Document">
                    <p:embed/>
                  </p:oleObj>
                </mc:Choice>
                <mc:Fallback>
                  <p:oleObj name="Prism 8" r:id="rId6" imgW="3893266" imgH="2529450" progId="Prism8.Document">
                    <p:embed/>
                    <p:pic>
                      <p:nvPicPr>
                        <p:cNvPr id="22" name="Object 21">
                          <a:extLst>
                            <a:ext uri="{FF2B5EF4-FFF2-40B4-BE49-F238E27FC236}">
                              <a16:creationId xmlns:a16="http://schemas.microsoft.com/office/drawing/2014/main" id="{702BA7EF-3362-5858-A5A3-87105A107FF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8357984" y="365465"/>
                          <a:ext cx="3892550" cy="25288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FF0A41E8-D06D-5CA5-2A9E-2ED7BAF0B804}"/>
                </a:ext>
              </a:extLst>
            </p:cNvPr>
            <p:cNvSpPr txBox="1"/>
            <p:nvPr/>
          </p:nvSpPr>
          <p:spPr>
            <a:xfrm>
              <a:off x="9201613" y="1889792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0D9BFFF7-A29F-C7F6-0102-910DC7634D4B}"/>
                </a:ext>
              </a:extLst>
            </p:cNvPr>
            <p:cNvSpPr txBox="1"/>
            <p:nvPr/>
          </p:nvSpPr>
          <p:spPr>
            <a:xfrm>
              <a:off x="9479628" y="1944320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772DFCF9-FDFE-D6EA-3C07-793D785EC25D}"/>
                </a:ext>
              </a:extLst>
            </p:cNvPr>
            <p:cNvSpPr txBox="1"/>
            <p:nvPr/>
          </p:nvSpPr>
          <p:spPr>
            <a:xfrm>
              <a:off x="9763119" y="1783238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A344B2C3-0BD2-9AA9-D8C3-B4E5F1AF4FEC}"/>
                </a:ext>
              </a:extLst>
            </p:cNvPr>
            <p:cNvSpPr txBox="1"/>
            <p:nvPr/>
          </p:nvSpPr>
          <p:spPr>
            <a:xfrm>
              <a:off x="10027338" y="1442955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4A4CBAA1-9BC2-F8F1-967C-B3F8DD6C8C40}"/>
                </a:ext>
              </a:extLst>
            </p:cNvPr>
            <p:cNvSpPr txBox="1"/>
            <p:nvPr/>
          </p:nvSpPr>
          <p:spPr>
            <a:xfrm>
              <a:off x="10845196" y="544624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E123B0C1-ABF8-ADCA-BDA8-D4A6669447A2}"/>
                </a:ext>
              </a:extLst>
            </p:cNvPr>
            <p:cNvSpPr txBox="1"/>
            <p:nvPr/>
          </p:nvSpPr>
          <p:spPr>
            <a:xfrm>
              <a:off x="10563647" y="1912310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D16339AA-D45A-EF0A-E8D5-3C847D7D2BC2}"/>
                </a:ext>
              </a:extLst>
            </p:cNvPr>
            <p:cNvSpPr txBox="1"/>
            <p:nvPr/>
          </p:nvSpPr>
          <p:spPr>
            <a:xfrm>
              <a:off x="11111069" y="1563990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C1DEAC0D-878B-2C87-D306-4604D692E652}"/>
                </a:ext>
              </a:extLst>
            </p:cNvPr>
            <p:cNvSpPr txBox="1"/>
            <p:nvPr/>
          </p:nvSpPr>
          <p:spPr>
            <a:xfrm>
              <a:off x="11407875" y="2082483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1" name="TextBox 30">
            <a:extLst>
              <a:ext uri="{FF2B5EF4-FFF2-40B4-BE49-F238E27FC236}">
                <a16:creationId xmlns:a16="http://schemas.microsoft.com/office/drawing/2014/main" id="{DA1CD002-F6A8-523F-81B6-C3CCDA12363F}"/>
              </a:ext>
            </a:extLst>
          </p:cNvPr>
          <p:cNvSpPr txBox="1"/>
          <p:nvPr/>
        </p:nvSpPr>
        <p:spPr>
          <a:xfrm>
            <a:off x="4509055" y="284491"/>
            <a:ext cx="497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51" name="Group 50">
            <a:extLst>
              <a:ext uri="{FF2B5EF4-FFF2-40B4-BE49-F238E27FC236}">
                <a16:creationId xmlns:a16="http://schemas.microsoft.com/office/drawing/2014/main" id="{AA8E51D3-6505-D93E-3720-28C25B1BC863}"/>
              </a:ext>
            </a:extLst>
          </p:cNvPr>
          <p:cNvGrpSpPr/>
          <p:nvPr/>
        </p:nvGrpSpPr>
        <p:grpSpPr>
          <a:xfrm>
            <a:off x="8423089" y="326586"/>
            <a:ext cx="3892550" cy="2528888"/>
            <a:chOff x="363114" y="2782157"/>
            <a:chExt cx="3892550" cy="2528888"/>
          </a:xfrm>
        </p:grpSpPr>
        <p:graphicFrame>
          <p:nvGraphicFramePr>
            <p:cNvPr id="32" name="Object 31">
              <a:extLst>
                <a:ext uri="{FF2B5EF4-FFF2-40B4-BE49-F238E27FC236}">
                  <a16:creationId xmlns:a16="http://schemas.microsoft.com/office/drawing/2014/main" id="{AE8CC8EB-5D90-7217-F5A5-83989682A3A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4462265"/>
                </p:ext>
              </p:extLst>
            </p:nvPr>
          </p:nvGraphicFramePr>
          <p:xfrm>
            <a:off x="363114" y="2782157"/>
            <a:ext cx="3892550" cy="25288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8" imgW="3893266" imgH="2529450" progId="Prism8.Document">
                    <p:embed/>
                  </p:oleObj>
                </mc:Choice>
                <mc:Fallback>
                  <p:oleObj name="Prism 8" r:id="rId8" imgW="3893266" imgH="2529450" progId="Prism8.Document">
                    <p:embed/>
                    <p:pic>
                      <p:nvPicPr>
                        <p:cNvPr id="32" name="Object 31">
                          <a:extLst>
                            <a:ext uri="{FF2B5EF4-FFF2-40B4-BE49-F238E27FC236}">
                              <a16:creationId xmlns:a16="http://schemas.microsoft.com/office/drawing/2014/main" id="{AE8CC8EB-5D90-7217-F5A5-83989682A3A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363114" y="2782157"/>
                          <a:ext cx="3892550" cy="25288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4A9008D7-65D1-F752-64A8-2EF7E9E2C224}"/>
                </a:ext>
              </a:extLst>
            </p:cNvPr>
            <p:cNvGrpSpPr/>
            <p:nvPr/>
          </p:nvGrpSpPr>
          <p:grpSpPr>
            <a:xfrm>
              <a:off x="1206442" y="3013347"/>
              <a:ext cx="2545144" cy="1806098"/>
              <a:chOff x="1601403" y="1600832"/>
              <a:chExt cx="2545144" cy="1806098"/>
            </a:xfrm>
          </p:grpSpPr>
          <p:grpSp>
            <p:nvGrpSpPr>
              <p:cNvPr id="34" name="Group 33">
                <a:extLst>
                  <a:ext uri="{FF2B5EF4-FFF2-40B4-BE49-F238E27FC236}">
                    <a16:creationId xmlns:a16="http://schemas.microsoft.com/office/drawing/2014/main" id="{FB16F4CB-1854-0DB9-5950-3FD16D2BFF23}"/>
                  </a:ext>
                </a:extLst>
              </p:cNvPr>
              <p:cNvGrpSpPr/>
              <p:nvPr/>
            </p:nvGrpSpPr>
            <p:grpSpPr>
              <a:xfrm>
                <a:off x="1601403" y="1600832"/>
                <a:ext cx="2545144" cy="1806098"/>
                <a:chOff x="8223795" y="5609414"/>
                <a:chExt cx="2545144" cy="1806098"/>
              </a:xfrm>
            </p:grpSpPr>
            <p:grpSp>
              <p:nvGrpSpPr>
                <p:cNvPr id="36" name="Group 35">
                  <a:extLst>
                    <a:ext uri="{FF2B5EF4-FFF2-40B4-BE49-F238E27FC236}">
                      <a16:creationId xmlns:a16="http://schemas.microsoft.com/office/drawing/2014/main" id="{EE8EC348-C542-0626-0E21-D0EFE9A1FB9F}"/>
                    </a:ext>
                  </a:extLst>
                </p:cNvPr>
                <p:cNvGrpSpPr/>
                <p:nvPr/>
              </p:nvGrpSpPr>
              <p:grpSpPr>
                <a:xfrm>
                  <a:off x="8223795" y="5609414"/>
                  <a:ext cx="2545144" cy="1806098"/>
                  <a:chOff x="8049904" y="1957138"/>
                  <a:chExt cx="2534182" cy="1806098"/>
                </a:xfrm>
              </p:grpSpPr>
              <p:grpSp>
                <p:nvGrpSpPr>
                  <p:cNvPr id="38" name="Group 37">
                    <a:extLst>
                      <a:ext uri="{FF2B5EF4-FFF2-40B4-BE49-F238E27FC236}">
                        <a16:creationId xmlns:a16="http://schemas.microsoft.com/office/drawing/2014/main" id="{08E1B561-3FA9-9307-EFAC-BCF26F42EE35}"/>
                      </a:ext>
                    </a:extLst>
                  </p:cNvPr>
                  <p:cNvGrpSpPr/>
                  <p:nvPr/>
                </p:nvGrpSpPr>
                <p:grpSpPr>
                  <a:xfrm>
                    <a:off x="8049904" y="1957138"/>
                    <a:ext cx="2534182" cy="1530054"/>
                    <a:chOff x="-1906390" y="6417964"/>
                    <a:chExt cx="2534182" cy="1530054"/>
                  </a:xfrm>
                </p:grpSpPr>
                <p:sp>
                  <p:nvSpPr>
                    <p:cNvPr id="40" name="TextBox 39">
                      <a:extLst>
                        <a:ext uri="{FF2B5EF4-FFF2-40B4-BE49-F238E27FC236}">
                          <a16:creationId xmlns:a16="http://schemas.microsoft.com/office/drawing/2014/main" id="{1FA0FA1A-7846-3D1B-5DA0-7DCC8877A87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1347338" y="7551086"/>
                      <a:ext cx="332509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IN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1" name="TextBox 40">
                      <a:extLst>
                        <a:ext uri="{FF2B5EF4-FFF2-40B4-BE49-F238E27FC236}">
                          <a16:creationId xmlns:a16="http://schemas.microsoft.com/office/drawing/2014/main" id="{B0BF303B-5975-11C8-AAFB-934B95D7355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323037" y="6641701"/>
                      <a:ext cx="332509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endParaRPr lang="en-IN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2" name="TextBox 41">
                      <a:extLst>
                        <a:ext uri="{FF2B5EF4-FFF2-40B4-BE49-F238E27FC236}">
                          <a16:creationId xmlns:a16="http://schemas.microsoft.com/office/drawing/2014/main" id="{405DBE51-221E-5D54-00F5-CF19B56F1DB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1906390" y="7671019"/>
                      <a:ext cx="332509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IN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3" name="TextBox 42">
                      <a:extLst>
                        <a:ext uri="{FF2B5EF4-FFF2-40B4-BE49-F238E27FC236}">
                          <a16:creationId xmlns:a16="http://schemas.microsoft.com/office/drawing/2014/main" id="{1A367D7B-1668-A2E4-1BFD-1602C9A91BE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1079780" y="7255251"/>
                      <a:ext cx="332509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IN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4" name="TextBox 43">
                      <a:extLst>
                        <a:ext uri="{FF2B5EF4-FFF2-40B4-BE49-F238E27FC236}">
                          <a16:creationId xmlns:a16="http://schemas.microsoft.com/office/drawing/2014/main" id="{2A4A138E-0AD6-F21C-C952-9D5B0982FEE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254844" y="6417964"/>
                      <a:ext cx="332509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IN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5" name="TextBox 44">
                      <a:extLst>
                        <a:ext uri="{FF2B5EF4-FFF2-40B4-BE49-F238E27FC236}">
                          <a16:creationId xmlns:a16="http://schemas.microsoft.com/office/drawing/2014/main" id="{BA48D43B-4E57-C953-6B40-F78AF99D413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95283" y="7493735"/>
                      <a:ext cx="332509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IN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39" name="TextBox 38">
                    <a:extLst>
                      <a:ext uri="{FF2B5EF4-FFF2-40B4-BE49-F238E27FC236}">
                        <a16:creationId xmlns:a16="http://schemas.microsoft.com/office/drawing/2014/main" id="{164E59E8-5494-2D64-378B-5D97F954D7C2}"/>
                      </a:ext>
                    </a:extLst>
                  </p:cNvPr>
                  <p:cNvSpPr txBox="1"/>
                  <p:nvPr/>
                </p:nvSpPr>
                <p:spPr>
                  <a:xfrm>
                    <a:off x="8319386" y="3486237"/>
                    <a:ext cx="332509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</a:t>
                    </a:r>
                    <a:endParaRPr lang="en-IN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5E2FF498-F743-C782-1CBB-8DD105AA78A9}"/>
                    </a:ext>
                  </a:extLst>
                </p:cNvPr>
                <p:cNvSpPr txBox="1"/>
                <p:nvPr/>
              </p:nvSpPr>
              <p:spPr>
                <a:xfrm>
                  <a:off x="10149656" y="6720838"/>
                  <a:ext cx="33394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  <a:endParaRPr lang="en-IN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0D7BF857-FC87-9F6B-F4BD-848D89A4AFEB}"/>
                  </a:ext>
                </a:extLst>
              </p:cNvPr>
              <p:cNvSpPr txBox="1"/>
              <p:nvPr/>
            </p:nvSpPr>
            <p:spPr>
              <a:xfrm>
                <a:off x="2981117" y="2921986"/>
                <a:ext cx="33394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46" name="TextBox 45">
            <a:extLst>
              <a:ext uri="{FF2B5EF4-FFF2-40B4-BE49-F238E27FC236}">
                <a16:creationId xmlns:a16="http://schemas.microsoft.com/office/drawing/2014/main" id="{607F14B4-8AD7-F505-488E-FD75895909C3}"/>
              </a:ext>
            </a:extLst>
          </p:cNvPr>
          <p:cNvSpPr txBox="1"/>
          <p:nvPr/>
        </p:nvSpPr>
        <p:spPr>
          <a:xfrm>
            <a:off x="8377304" y="278934"/>
            <a:ext cx="497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EC34CE4A-29E0-4561-71BB-D064A2382C0E}"/>
              </a:ext>
            </a:extLst>
          </p:cNvPr>
          <p:cNvSpPr txBox="1"/>
          <p:nvPr/>
        </p:nvSpPr>
        <p:spPr>
          <a:xfrm>
            <a:off x="4665358" y="2595494"/>
            <a:ext cx="497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pSp>
        <p:nvGrpSpPr>
          <p:cNvPr id="64" name="Group 63">
            <a:extLst>
              <a:ext uri="{FF2B5EF4-FFF2-40B4-BE49-F238E27FC236}">
                <a16:creationId xmlns:a16="http://schemas.microsoft.com/office/drawing/2014/main" id="{86C837BA-C98D-08F9-ED05-A13EA52A1F35}"/>
              </a:ext>
            </a:extLst>
          </p:cNvPr>
          <p:cNvGrpSpPr/>
          <p:nvPr/>
        </p:nvGrpSpPr>
        <p:grpSpPr>
          <a:xfrm>
            <a:off x="347661" y="2187560"/>
            <a:ext cx="3892550" cy="3229489"/>
            <a:chOff x="-2192" y="2764909"/>
            <a:chExt cx="3892550" cy="3229489"/>
          </a:xfrm>
        </p:grpSpPr>
        <p:graphicFrame>
          <p:nvGraphicFramePr>
            <p:cNvPr id="65" name="Object 64">
              <a:extLst>
                <a:ext uri="{FF2B5EF4-FFF2-40B4-BE49-F238E27FC236}">
                  <a16:creationId xmlns:a16="http://schemas.microsoft.com/office/drawing/2014/main" id="{FD7715B4-73DD-81E6-2BCF-D82354C4A45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73791327"/>
                </p:ext>
              </p:extLst>
            </p:nvPr>
          </p:nvGraphicFramePr>
          <p:xfrm>
            <a:off x="-2192" y="3221035"/>
            <a:ext cx="3892550" cy="27733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0" imgW="3893266" imgH="2773504" progId="Prism8.Document">
                    <p:embed/>
                  </p:oleObj>
                </mc:Choice>
                <mc:Fallback>
                  <p:oleObj name="Prism 8" r:id="rId10" imgW="3893266" imgH="2773504" progId="Prism8.Document">
                    <p:embed/>
                    <p:pic>
                      <p:nvPicPr>
                        <p:cNvPr id="65" name="Object 64">
                          <a:extLst>
                            <a:ext uri="{FF2B5EF4-FFF2-40B4-BE49-F238E27FC236}">
                              <a16:creationId xmlns:a16="http://schemas.microsoft.com/office/drawing/2014/main" id="{FD7715B4-73DD-81E6-2BCF-D82354C4A45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-2192" y="3221035"/>
                          <a:ext cx="3892550" cy="27733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66" name="Group 65">
              <a:extLst>
                <a:ext uri="{FF2B5EF4-FFF2-40B4-BE49-F238E27FC236}">
                  <a16:creationId xmlns:a16="http://schemas.microsoft.com/office/drawing/2014/main" id="{97C4D24C-A568-8D72-A4B9-63747877644A}"/>
                </a:ext>
              </a:extLst>
            </p:cNvPr>
            <p:cNvGrpSpPr/>
            <p:nvPr/>
          </p:nvGrpSpPr>
          <p:grpSpPr>
            <a:xfrm>
              <a:off x="867033" y="2764909"/>
              <a:ext cx="2523085" cy="2772985"/>
              <a:chOff x="1579733" y="1824569"/>
              <a:chExt cx="2523085" cy="2772985"/>
            </a:xfrm>
          </p:grpSpPr>
          <p:grpSp>
            <p:nvGrpSpPr>
              <p:cNvPr id="67" name="Group 66">
                <a:extLst>
                  <a:ext uri="{FF2B5EF4-FFF2-40B4-BE49-F238E27FC236}">
                    <a16:creationId xmlns:a16="http://schemas.microsoft.com/office/drawing/2014/main" id="{83818746-E399-F1A8-DEDB-F0AE95C90E25}"/>
                  </a:ext>
                </a:extLst>
              </p:cNvPr>
              <p:cNvGrpSpPr/>
              <p:nvPr/>
            </p:nvGrpSpPr>
            <p:grpSpPr>
              <a:xfrm>
                <a:off x="1579733" y="1824569"/>
                <a:ext cx="2250966" cy="2772985"/>
                <a:chOff x="8202125" y="5833151"/>
                <a:chExt cx="2250966" cy="2772985"/>
              </a:xfrm>
            </p:grpSpPr>
            <p:grpSp>
              <p:nvGrpSpPr>
                <p:cNvPr id="69" name="Group 68">
                  <a:extLst>
                    <a:ext uri="{FF2B5EF4-FFF2-40B4-BE49-F238E27FC236}">
                      <a16:creationId xmlns:a16="http://schemas.microsoft.com/office/drawing/2014/main" id="{04FFBB7A-90D5-B3E8-AB67-BB369A120C92}"/>
                    </a:ext>
                  </a:extLst>
                </p:cNvPr>
                <p:cNvGrpSpPr/>
                <p:nvPr/>
              </p:nvGrpSpPr>
              <p:grpSpPr>
                <a:xfrm>
                  <a:off x="8202125" y="5833151"/>
                  <a:ext cx="1983172" cy="2772985"/>
                  <a:chOff x="8028330" y="2180875"/>
                  <a:chExt cx="1974631" cy="2772985"/>
                </a:xfrm>
              </p:grpSpPr>
              <p:grpSp>
                <p:nvGrpSpPr>
                  <p:cNvPr id="71" name="Group 70">
                    <a:extLst>
                      <a:ext uri="{FF2B5EF4-FFF2-40B4-BE49-F238E27FC236}">
                        <a16:creationId xmlns:a16="http://schemas.microsoft.com/office/drawing/2014/main" id="{F96F4913-198B-6B68-A315-E4CC3EFFF082}"/>
                      </a:ext>
                    </a:extLst>
                  </p:cNvPr>
                  <p:cNvGrpSpPr/>
                  <p:nvPr/>
                </p:nvGrpSpPr>
                <p:grpSpPr>
                  <a:xfrm>
                    <a:off x="8028330" y="2180875"/>
                    <a:ext cx="1974631" cy="2451203"/>
                    <a:chOff x="-1927964" y="6641701"/>
                    <a:chExt cx="1974631" cy="2451203"/>
                  </a:xfrm>
                </p:grpSpPr>
                <p:sp>
                  <p:nvSpPr>
                    <p:cNvPr id="73" name="TextBox 72">
                      <a:extLst>
                        <a:ext uri="{FF2B5EF4-FFF2-40B4-BE49-F238E27FC236}">
                          <a16:creationId xmlns:a16="http://schemas.microsoft.com/office/drawing/2014/main" id="{DF7EC2FF-54B0-EF47-9E1D-C9C015F9D5C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1392386" y="8705237"/>
                      <a:ext cx="332509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IN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74" name="TextBox 73">
                      <a:extLst>
                        <a:ext uri="{FF2B5EF4-FFF2-40B4-BE49-F238E27FC236}">
                          <a16:creationId xmlns:a16="http://schemas.microsoft.com/office/drawing/2014/main" id="{A52336A8-26AA-F1DA-2F54-73B88C6D940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323037" y="6641701"/>
                      <a:ext cx="332509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endParaRPr lang="en-IN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75" name="TextBox 74">
                      <a:extLst>
                        <a:ext uri="{FF2B5EF4-FFF2-40B4-BE49-F238E27FC236}">
                          <a16:creationId xmlns:a16="http://schemas.microsoft.com/office/drawing/2014/main" id="{BD82D718-FC5A-EAFF-0100-4B3D97B3403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1927964" y="8787624"/>
                      <a:ext cx="332509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IN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76" name="TextBox 75">
                      <a:extLst>
                        <a:ext uri="{FF2B5EF4-FFF2-40B4-BE49-F238E27FC236}">
                          <a16:creationId xmlns:a16="http://schemas.microsoft.com/office/drawing/2014/main" id="{249476C0-4CF3-4993-7774-A1B075FF57C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1106926" y="7536283"/>
                      <a:ext cx="332509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IN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77" name="TextBox 76">
                      <a:extLst>
                        <a:ext uri="{FF2B5EF4-FFF2-40B4-BE49-F238E27FC236}">
                          <a16:creationId xmlns:a16="http://schemas.microsoft.com/office/drawing/2014/main" id="{23AC7430-6008-768D-8ED5-C11662F4B77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285842" y="8086638"/>
                      <a:ext cx="332509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IN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78" name="TextBox 77">
                      <a:extLst>
                        <a:ext uri="{FF2B5EF4-FFF2-40B4-BE49-F238E27FC236}">
                          <a16:creationId xmlns:a16="http://schemas.microsoft.com/office/drawing/2014/main" id="{D05DDDF5-321B-B5FB-E7DE-5BB41A3DBD0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585172" y="8815905"/>
                      <a:ext cx="332509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IN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72" name="TextBox 71">
                    <a:extLst>
                      <a:ext uri="{FF2B5EF4-FFF2-40B4-BE49-F238E27FC236}">
                        <a16:creationId xmlns:a16="http://schemas.microsoft.com/office/drawing/2014/main" id="{36A63032-1D7F-92A9-E653-990A29D660B1}"/>
                      </a:ext>
                    </a:extLst>
                  </p:cNvPr>
                  <p:cNvSpPr txBox="1"/>
                  <p:nvPr/>
                </p:nvSpPr>
                <p:spPr>
                  <a:xfrm>
                    <a:off x="8294591" y="4676861"/>
                    <a:ext cx="332509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endParaRPr lang="en-IN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70" name="TextBox 69">
                  <a:extLst>
                    <a:ext uri="{FF2B5EF4-FFF2-40B4-BE49-F238E27FC236}">
                      <a16:creationId xmlns:a16="http://schemas.microsoft.com/office/drawing/2014/main" id="{71C3ECB9-FE44-FA4F-AD19-42A389290867}"/>
                    </a:ext>
                  </a:extLst>
                </p:cNvPr>
                <p:cNvSpPr txBox="1"/>
                <p:nvPr/>
              </p:nvSpPr>
              <p:spPr>
                <a:xfrm>
                  <a:off x="10063670" y="7358330"/>
                  <a:ext cx="38942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b</a:t>
                  </a:r>
                  <a:endParaRPr lang="en-IN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334E7ABC-D860-D6DC-2DF0-6C98B71F1837}"/>
                  </a:ext>
                </a:extLst>
              </p:cNvPr>
              <p:cNvSpPr txBox="1"/>
              <p:nvPr/>
            </p:nvSpPr>
            <p:spPr>
              <a:xfrm>
                <a:off x="3768871" y="3472858"/>
                <a:ext cx="33394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aphicFrame>
        <p:nvGraphicFramePr>
          <p:cNvPr id="79" name="Object 78">
            <a:extLst>
              <a:ext uri="{FF2B5EF4-FFF2-40B4-BE49-F238E27FC236}">
                <a16:creationId xmlns:a16="http://schemas.microsoft.com/office/drawing/2014/main" id="{66F6E0B1-A457-DBA6-6231-B5342E7BB6E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99339234"/>
              </p:ext>
            </p:extLst>
          </p:nvPr>
        </p:nvGraphicFramePr>
        <p:xfrm>
          <a:off x="8296089" y="2819390"/>
          <a:ext cx="4019550" cy="25288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2" imgW="4019969" imgH="2529450" progId="Prism8.Document">
                  <p:embed/>
                </p:oleObj>
              </mc:Choice>
              <mc:Fallback>
                <p:oleObj name="Prism 8" r:id="rId12" imgW="4019969" imgH="2529450" progId="Prism8.Document">
                  <p:embed/>
                  <p:pic>
                    <p:nvPicPr>
                      <p:cNvPr id="79" name="Object 78">
                        <a:extLst>
                          <a:ext uri="{FF2B5EF4-FFF2-40B4-BE49-F238E27FC236}">
                            <a16:creationId xmlns:a16="http://schemas.microsoft.com/office/drawing/2014/main" id="{66F6E0B1-A457-DBA6-6231-B5342E7BB6E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8296089" y="2819390"/>
                        <a:ext cx="4019550" cy="25288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0" name="TextBox 79">
            <a:extLst>
              <a:ext uri="{FF2B5EF4-FFF2-40B4-BE49-F238E27FC236}">
                <a16:creationId xmlns:a16="http://schemas.microsoft.com/office/drawing/2014/main" id="{4483D68E-E24F-BC52-E133-7B969E669616}"/>
              </a:ext>
            </a:extLst>
          </p:cNvPr>
          <p:cNvSpPr txBox="1"/>
          <p:nvPr/>
        </p:nvSpPr>
        <p:spPr>
          <a:xfrm>
            <a:off x="9281494" y="3871408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8B670011-6A0C-9A37-D0E7-33748C3A3D11}"/>
              </a:ext>
            </a:extLst>
          </p:cNvPr>
          <p:cNvSpPr txBox="1"/>
          <p:nvPr/>
        </p:nvSpPr>
        <p:spPr>
          <a:xfrm>
            <a:off x="10919941" y="3331584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1399DE67-3167-44B7-D8DD-5EA3C02DA355}"/>
              </a:ext>
            </a:extLst>
          </p:cNvPr>
          <p:cNvSpPr txBox="1"/>
          <p:nvPr/>
        </p:nvSpPr>
        <p:spPr>
          <a:xfrm>
            <a:off x="9551376" y="4450366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29A781DE-4A77-3510-5770-3EC6BDD7F3ED}"/>
              </a:ext>
            </a:extLst>
          </p:cNvPr>
          <p:cNvSpPr txBox="1"/>
          <p:nvPr/>
        </p:nvSpPr>
        <p:spPr>
          <a:xfrm>
            <a:off x="9824795" y="3535949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5A35EC5E-F361-ABB7-6E55-EDA03648B1F0}"/>
              </a:ext>
            </a:extLst>
          </p:cNvPr>
          <p:cNvSpPr txBox="1"/>
          <p:nvPr/>
        </p:nvSpPr>
        <p:spPr>
          <a:xfrm>
            <a:off x="10097332" y="3142146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BC6E6D63-BDA0-F5D9-EE14-9F0BF49AD699}"/>
              </a:ext>
            </a:extLst>
          </p:cNvPr>
          <p:cNvSpPr txBox="1"/>
          <p:nvPr/>
        </p:nvSpPr>
        <p:spPr>
          <a:xfrm>
            <a:off x="11165316" y="3469836"/>
            <a:ext cx="3842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374E9029-30DA-99ED-3E9D-D3FFDA1B69C5}"/>
              </a:ext>
            </a:extLst>
          </p:cNvPr>
          <p:cNvSpPr txBox="1"/>
          <p:nvPr/>
        </p:nvSpPr>
        <p:spPr>
          <a:xfrm>
            <a:off x="11465125" y="3528068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7DEA8E96-2739-AA91-CB52-0A4FB237A45B}"/>
              </a:ext>
            </a:extLst>
          </p:cNvPr>
          <p:cNvSpPr txBox="1"/>
          <p:nvPr/>
        </p:nvSpPr>
        <p:spPr>
          <a:xfrm>
            <a:off x="10629612" y="3826482"/>
            <a:ext cx="33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4ABC5A3C-733E-3ED1-C6F1-B23F6CA8EB70}"/>
              </a:ext>
            </a:extLst>
          </p:cNvPr>
          <p:cNvSpPr txBox="1"/>
          <p:nvPr/>
        </p:nvSpPr>
        <p:spPr>
          <a:xfrm>
            <a:off x="8213711" y="2543612"/>
            <a:ext cx="497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776DE0C6-E862-04F4-2C76-5BFA1296BD91}"/>
              </a:ext>
            </a:extLst>
          </p:cNvPr>
          <p:cNvSpPr txBox="1"/>
          <p:nvPr/>
        </p:nvSpPr>
        <p:spPr>
          <a:xfrm>
            <a:off x="182667" y="5476816"/>
            <a:ext cx="1199252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: 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Effect of melatonin priming on glycolysis under optimal and PEG-induced stress conditions in drought sensitive (L-799) and drought tolerant (Suraj) varieties of cotton (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Gossypium hirsutum 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L.). A) Relative fold change expression of glycolysis genes 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HK3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, B) 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TPI1, C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) Relative fold change expression of glycolysis downstream genes 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PGK5 D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) PK1 F) Endogenous pyruvate levels E) Endogenous glucose and F) pyruvate content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data represent mean values ± SD of 3 independent experiments, with 3 replicates per treatment in each experiment. Different alphabets represent significant differences among the treatments according to Duncan multiple range test (DMRT) at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value ≤ 0.05.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40302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TextBox 69">
            <a:extLst>
              <a:ext uri="{FF2B5EF4-FFF2-40B4-BE49-F238E27FC236}">
                <a16:creationId xmlns:a16="http://schemas.microsoft.com/office/drawing/2014/main" id="{E4190E24-10B2-D2FF-F098-95ACF5FB1731}"/>
              </a:ext>
            </a:extLst>
          </p:cNvPr>
          <p:cNvSpPr txBox="1"/>
          <p:nvPr/>
        </p:nvSpPr>
        <p:spPr>
          <a:xfrm>
            <a:off x="180948" y="5611179"/>
            <a:ext cx="1199252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: 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Effect of melatonin on relative fold change expression of autophagy related genes under optimal and PEG-induced stress conditions in drought sensitive (L-799) and drought tolerant (Suraj) varieties of cotton (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Gossypium hirsutum 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L.). A) 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ATG8c, 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ATG3, 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 ATG5, 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 ATG18a, 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E)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 SnRK2.6 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F) 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SnRK1.1. 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C, Seedlings grown under optimal conditions (control). P. Seedlings grown under PEG induced drought stress conditions for 4 days (PEG stress)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data represent mean values ± SD of 3 independent experiments, with 3 replicates per treatment in each experiment. Different alphabets represent significant differences among the treatments according to Duncan multiple range test (DMRT) at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value ≤ 0.05.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E2622B08-2762-BF83-220F-EE100B664310}"/>
              </a:ext>
            </a:extLst>
          </p:cNvPr>
          <p:cNvGrpSpPr/>
          <p:nvPr/>
        </p:nvGrpSpPr>
        <p:grpSpPr>
          <a:xfrm>
            <a:off x="8339899" y="336545"/>
            <a:ext cx="3976687" cy="2528887"/>
            <a:chOff x="4520231" y="2837846"/>
            <a:chExt cx="3976687" cy="2528887"/>
          </a:xfrm>
        </p:grpSpPr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FEDBB8AA-9A6D-C0A8-C48B-86ED1600016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02671965"/>
                </p:ext>
              </p:extLst>
            </p:nvPr>
          </p:nvGraphicFramePr>
          <p:xfrm>
            <a:off x="4520231" y="2837846"/>
            <a:ext cx="3976687" cy="25288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3" imgW="3977135" imgH="2529450" progId="Prism8.Document">
                    <p:embed/>
                  </p:oleObj>
                </mc:Choice>
                <mc:Fallback>
                  <p:oleObj name="Prism 8" r:id="rId3" imgW="3977135" imgH="2529450" progId="Prism8.Document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FEDBB8AA-9A6D-C0A8-C48B-86ED1600016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4520231" y="2837846"/>
                          <a:ext cx="3976687" cy="25288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B63BB08F-D495-0A19-35A1-FB213857BF95}"/>
                </a:ext>
              </a:extLst>
            </p:cNvPr>
            <p:cNvGrpSpPr/>
            <p:nvPr/>
          </p:nvGrpSpPr>
          <p:grpSpPr>
            <a:xfrm>
              <a:off x="5464134" y="3494697"/>
              <a:ext cx="2625541" cy="1459800"/>
              <a:chOff x="5045990" y="3136615"/>
              <a:chExt cx="2067657" cy="1107955"/>
            </a:xfrm>
          </p:grpSpPr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AB206482-B221-9F42-D047-DFA308D0DD7B}"/>
                  </a:ext>
                </a:extLst>
              </p:cNvPr>
              <p:cNvSpPr txBox="1"/>
              <p:nvPr/>
            </p:nvSpPr>
            <p:spPr>
              <a:xfrm>
                <a:off x="5701531" y="3802378"/>
                <a:ext cx="333947" cy="2102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81844D49-13B2-92E8-2D3B-B91B8937C19E}"/>
                  </a:ext>
                </a:extLst>
              </p:cNvPr>
              <p:cNvSpPr txBox="1"/>
              <p:nvPr/>
            </p:nvSpPr>
            <p:spPr>
              <a:xfrm>
                <a:off x="5045990" y="3955187"/>
                <a:ext cx="333947" cy="2102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10A929B1-C8AA-3A7A-81AD-647E1D73C67E}"/>
                  </a:ext>
                </a:extLst>
              </p:cNvPr>
              <p:cNvSpPr txBox="1"/>
              <p:nvPr/>
            </p:nvSpPr>
            <p:spPr>
              <a:xfrm>
                <a:off x="5469532" y="3965457"/>
                <a:ext cx="333947" cy="2102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8AACDB26-7576-C4C4-CC49-AF4B63AD7BF3}"/>
                  </a:ext>
                </a:extLst>
              </p:cNvPr>
              <p:cNvSpPr txBox="1"/>
              <p:nvPr/>
            </p:nvSpPr>
            <p:spPr>
              <a:xfrm>
                <a:off x="5273604" y="4020024"/>
                <a:ext cx="333947" cy="2102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696AF1AE-C596-DA54-E52B-C90868C152FC}"/>
                  </a:ext>
                </a:extLst>
              </p:cNvPr>
              <p:cNvSpPr txBox="1"/>
              <p:nvPr/>
            </p:nvSpPr>
            <p:spPr>
              <a:xfrm>
                <a:off x="6350895" y="3136615"/>
                <a:ext cx="333947" cy="2102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20207A06-239B-3944-3ED6-C8511126FCA6}"/>
                  </a:ext>
                </a:extLst>
              </p:cNvPr>
              <p:cNvSpPr txBox="1"/>
              <p:nvPr/>
            </p:nvSpPr>
            <p:spPr>
              <a:xfrm>
                <a:off x="6116721" y="3955187"/>
                <a:ext cx="333947" cy="2102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B66B5946-1755-6E2C-C234-BA61885FE17C}"/>
                  </a:ext>
                </a:extLst>
              </p:cNvPr>
              <p:cNvSpPr txBox="1"/>
              <p:nvPr/>
            </p:nvSpPr>
            <p:spPr>
              <a:xfrm>
                <a:off x="6554073" y="4020024"/>
                <a:ext cx="333947" cy="2102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BEC1ED02-E03E-814D-D7E9-74AFD27C9430}"/>
                  </a:ext>
                </a:extLst>
              </p:cNvPr>
              <p:cNvSpPr txBox="1"/>
              <p:nvPr/>
            </p:nvSpPr>
            <p:spPr>
              <a:xfrm>
                <a:off x="6779700" y="4034334"/>
                <a:ext cx="333947" cy="2102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68" name="TextBox 67">
            <a:extLst>
              <a:ext uri="{FF2B5EF4-FFF2-40B4-BE49-F238E27FC236}">
                <a16:creationId xmlns:a16="http://schemas.microsoft.com/office/drawing/2014/main" id="{C0DF8B89-9F81-1F05-D6D1-C0EC82584F9F}"/>
              </a:ext>
            </a:extLst>
          </p:cNvPr>
          <p:cNvSpPr txBox="1"/>
          <p:nvPr/>
        </p:nvSpPr>
        <p:spPr>
          <a:xfrm>
            <a:off x="365507" y="289513"/>
            <a:ext cx="497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85" name="Group 84">
            <a:extLst>
              <a:ext uri="{FF2B5EF4-FFF2-40B4-BE49-F238E27FC236}">
                <a16:creationId xmlns:a16="http://schemas.microsoft.com/office/drawing/2014/main" id="{A9063404-7ABD-2AC1-3E30-A2F4FF478498}"/>
              </a:ext>
            </a:extLst>
          </p:cNvPr>
          <p:cNvGrpSpPr/>
          <p:nvPr/>
        </p:nvGrpSpPr>
        <p:grpSpPr>
          <a:xfrm>
            <a:off x="4479555" y="290940"/>
            <a:ext cx="4008357" cy="2569620"/>
            <a:chOff x="8276383" y="289514"/>
            <a:chExt cx="4008357" cy="2569620"/>
          </a:xfrm>
        </p:grpSpPr>
        <p:graphicFrame>
          <p:nvGraphicFramePr>
            <p:cNvPr id="86" name="Object 85">
              <a:extLst>
                <a:ext uri="{FF2B5EF4-FFF2-40B4-BE49-F238E27FC236}">
                  <a16:creationId xmlns:a16="http://schemas.microsoft.com/office/drawing/2014/main" id="{62E618D3-792B-07AE-F118-C075707353C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082199725"/>
                </p:ext>
              </p:extLst>
            </p:nvPr>
          </p:nvGraphicFramePr>
          <p:xfrm>
            <a:off x="8365202" y="366759"/>
            <a:ext cx="3919538" cy="24923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5" imgW="3919182" imgH="2491654" progId="Prism8.Document">
                    <p:embed/>
                  </p:oleObj>
                </mc:Choice>
                <mc:Fallback>
                  <p:oleObj name="Prism 8" r:id="rId5" imgW="3919182" imgH="2491654" progId="Prism8.Document">
                    <p:embed/>
                    <p:pic>
                      <p:nvPicPr>
                        <p:cNvPr id="86" name="Object 85">
                          <a:extLst>
                            <a:ext uri="{FF2B5EF4-FFF2-40B4-BE49-F238E27FC236}">
                              <a16:creationId xmlns:a16="http://schemas.microsoft.com/office/drawing/2014/main" id="{62E618D3-792B-07AE-F118-C075707353C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8365202" y="366759"/>
                          <a:ext cx="3919538" cy="24923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87" name="Group 86">
              <a:extLst>
                <a:ext uri="{FF2B5EF4-FFF2-40B4-BE49-F238E27FC236}">
                  <a16:creationId xmlns:a16="http://schemas.microsoft.com/office/drawing/2014/main" id="{12B2C857-4432-CB0F-B671-4F160FADF26B}"/>
                </a:ext>
              </a:extLst>
            </p:cNvPr>
            <p:cNvGrpSpPr/>
            <p:nvPr/>
          </p:nvGrpSpPr>
          <p:grpSpPr>
            <a:xfrm>
              <a:off x="9281347" y="635608"/>
              <a:ext cx="2605785" cy="1784686"/>
              <a:chOff x="433315" y="1422482"/>
              <a:chExt cx="1988145" cy="1399517"/>
            </a:xfrm>
          </p:grpSpPr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177133DD-B0E1-594D-C80E-0AEF142FACFA}"/>
                  </a:ext>
                </a:extLst>
              </p:cNvPr>
              <p:cNvSpPr txBox="1"/>
              <p:nvPr/>
            </p:nvSpPr>
            <p:spPr>
              <a:xfrm>
                <a:off x="851259" y="2456060"/>
                <a:ext cx="333947" cy="2172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8CAD3513-F589-32FD-6698-EF9546450F3F}"/>
                  </a:ext>
                </a:extLst>
              </p:cNvPr>
              <p:cNvSpPr txBox="1"/>
              <p:nvPr/>
            </p:nvSpPr>
            <p:spPr>
              <a:xfrm>
                <a:off x="639145" y="2604782"/>
                <a:ext cx="333947" cy="2172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493419B8-7BAB-9459-B1FA-E6DAEDC2E0B7}"/>
                  </a:ext>
                </a:extLst>
              </p:cNvPr>
              <p:cNvSpPr txBox="1"/>
              <p:nvPr/>
            </p:nvSpPr>
            <p:spPr>
              <a:xfrm>
                <a:off x="1687897" y="1422482"/>
                <a:ext cx="333947" cy="2172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F6E05DA3-7429-72B2-CBFC-4226502CF824}"/>
                  </a:ext>
                </a:extLst>
              </p:cNvPr>
              <p:cNvSpPr txBox="1"/>
              <p:nvPr/>
            </p:nvSpPr>
            <p:spPr>
              <a:xfrm>
                <a:off x="1051331" y="2132350"/>
                <a:ext cx="333947" cy="2172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A2E956F9-B62E-D51E-497F-CEDCDACA26B2}"/>
                  </a:ext>
                </a:extLst>
              </p:cNvPr>
              <p:cNvSpPr txBox="1"/>
              <p:nvPr/>
            </p:nvSpPr>
            <p:spPr>
              <a:xfrm>
                <a:off x="2087513" y="2519248"/>
                <a:ext cx="333947" cy="2172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7DCC7ABB-078D-8BD3-EC04-3247C5ACEE11}"/>
                  </a:ext>
                </a:extLst>
              </p:cNvPr>
              <p:cNvSpPr txBox="1"/>
              <p:nvPr/>
            </p:nvSpPr>
            <p:spPr>
              <a:xfrm>
                <a:off x="1471238" y="2515994"/>
                <a:ext cx="333947" cy="2172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8A8AD428-3516-318D-7EE6-1FE947F3E3A6}"/>
                  </a:ext>
                </a:extLst>
              </p:cNvPr>
              <p:cNvSpPr txBox="1"/>
              <p:nvPr/>
            </p:nvSpPr>
            <p:spPr>
              <a:xfrm>
                <a:off x="433315" y="2505681"/>
                <a:ext cx="333947" cy="2172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4EDDA748-27CC-6569-F2E9-5FB5F538D298}"/>
                  </a:ext>
                </a:extLst>
              </p:cNvPr>
              <p:cNvSpPr txBox="1"/>
              <p:nvPr/>
            </p:nvSpPr>
            <p:spPr>
              <a:xfrm>
                <a:off x="1890885" y="2358611"/>
                <a:ext cx="333947" cy="2172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FF39D8E9-6E79-9AD6-659C-2763C734812F}"/>
                </a:ext>
              </a:extLst>
            </p:cNvPr>
            <p:cNvSpPr txBox="1"/>
            <p:nvPr/>
          </p:nvSpPr>
          <p:spPr>
            <a:xfrm>
              <a:off x="8276383" y="289514"/>
              <a:ext cx="4977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grpSp>
        <p:nvGrpSpPr>
          <p:cNvPr id="97" name="Group 96">
            <a:extLst>
              <a:ext uri="{FF2B5EF4-FFF2-40B4-BE49-F238E27FC236}">
                <a16:creationId xmlns:a16="http://schemas.microsoft.com/office/drawing/2014/main" id="{7B80B58A-F6DD-8A60-FD01-FD7A44A1003A}"/>
              </a:ext>
            </a:extLst>
          </p:cNvPr>
          <p:cNvGrpSpPr/>
          <p:nvPr/>
        </p:nvGrpSpPr>
        <p:grpSpPr>
          <a:xfrm>
            <a:off x="718665" y="3027215"/>
            <a:ext cx="3919537" cy="2492375"/>
            <a:chOff x="367664" y="2842122"/>
            <a:chExt cx="3919537" cy="2492375"/>
          </a:xfrm>
        </p:grpSpPr>
        <p:graphicFrame>
          <p:nvGraphicFramePr>
            <p:cNvPr id="98" name="Object 97">
              <a:extLst>
                <a:ext uri="{FF2B5EF4-FFF2-40B4-BE49-F238E27FC236}">
                  <a16:creationId xmlns:a16="http://schemas.microsoft.com/office/drawing/2014/main" id="{D64E8EC7-DC3C-7849-1DA6-741BA90E6E6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49320915"/>
                </p:ext>
              </p:extLst>
            </p:nvPr>
          </p:nvGraphicFramePr>
          <p:xfrm>
            <a:off x="367664" y="2842122"/>
            <a:ext cx="3919537" cy="24923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7" imgW="3919182" imgH="2491654" progId="Prism8.Document">
                    <p:embed/>
                  </p:oleObj>
                </mc:Choice>
                <mc:Fallback>
                  <p:oleObj name="Prism 8" r:id="rId7" imgW="3919182" imgH="2491654" progId="Prism8.Document">
                    <p:embed/>
                    <p:pic>
                      <p:nvPicPr>
                        <p:cNvPr id="98" name="Object 97">
                          <a:extLst>
                            <a:ext uri="{FF2B5EF4-FFF2-40B4-BE49-F238E27FC236}">
                              <a16:creationId xmlns:a16="http://schemas.microsoft.com/office/drawing/2014/main" id="{D64E8EC7-DC3C-7849-1DA6-741BA90E6E6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367664" y="2842122"/>
                          <a:ext cx="3919537" cy="24923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99" name="Group 98">
              <a:extLst>
                <a:ext uri="{FF2B5EF4-FFF2-40B4-BE49-F238E27FC236}">
                  <a16:creationId xmlns:a16="http://schemas.microsoft.com/office/drawing/2014/main" id="{AC79A08E-1F7C-869A-9837-893DD3F875FA}"/>
                </a:ext>
              </a:extLst>
            </p:cNvPr>
            <p:cNvGrpSpPr/>
            <p:nvPr/>
          </p:nvGrpSpPr>
          <p:grpSpPr>
            <a:xfrm>
              <a:off x="1265867" y="3121047"/>
              <a:ext cx="2616768" cy="1808346"/>
              <a:chOff x="5067217" y="3115693"/>
              <a:chExt cx="2060748" cy="1372493"/>
            </a:xfrm>
          </p:grpSpPr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2B36CFB2-60E3-F52A-BE02-DAA3356BACF9}"/>
                  </a:ext>
                </a:extLst>
              </p:cNvPr>
              <p:cNvSpPr txBox="1"/>
              <p:nvPr/>
            </p:nvSpPr>
            <p:spPr>
              <a:xfrm>
                <a:off x="5698639" y="3821227"/>
                <a:ext cx="333947" cy="2102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1D85CB20-0A4F-802C-D1D8-D5D3BC56D394}"/>
                  </a:ext>
                </a:extLst>
              </p:cNvPr>
              <p:cNvSpPr txBox="1"/>
              <p:nvPr/>
            </p:nvSpPr>
            <p:spPr>
              <a:xfrm>
                <a:off x="5067217" y="4104218"/>
                <a:ext cx="333947" cy="2102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0A65225B-41A8-DF2A-C36F-1A85E82974D7}"/>
                  </a:ext>
                </a:extLst>
              </p:cNvPr>
              <p:cNvSpPr txBox="1"/>
              <p:nvPr/>
            </p:nvSpPr>
            <p:spPr>
              <a:xfrm>
                <a:off x="5504705" y="4131361"/>
                <a:ext cx="333947" cy="2102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C70A8E8B-EA04-688E-9373-9834654247D1}"/>
                  </a:ext>
                </a:extLst>
              </p:cNvPr>
              <p:cNvSpPr txBox="1"/>
              <p:nvPr/>
            </p:nvSpPr>
            <p:spPr>
              <a:xfrm>
                <a:off x="5288108" y="4277950"/>
                <a:ext cx="333947" cy="2102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TextBox 103">
                <a:extLst>
                  <a:ext uri="{FF2B5EF4-FFF2-40B4-BE49-F238E27FC236}">
                    <a16:creationId xmlns:a16="http://schemas.microsoft.com/office/drawing/2014/main" id="{C2D8133E-C292-DD04-8C77-D6474A28CF8F}"/>
                  </a:ext>
                </a:extLst>
              </p:cNvPr>
              <p:cNvSpPr txBox="1"/>
              <p:nvPr/>
            </p:nvSpPr>
            <p:spPr>
              <a:xfrm>
                <a:off x="6358072" y="3115693"/>
                <a:ext cx="333947" cy="2102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7B59EDA2-A78B-4BBF-F67A-9B02D23FB8C9}"/>
                  </a:ext>
                </a:extLst>
              </p:cNvPr>
              <p:cNvSpPr txBox="1"/>
              <p:nvPr/>
            </p:nvSpPr>
            <p:spPr>
              <a:xfrm>
                <a:off x="6147356" y="4164388"/>
                <a:ext cx="333947" cy="2102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D85AB150-493E-6CDA-3AF5-C33EF27938B4}"/>
                  </a:ext>
                </a:extLst>
              </p:cNvPr>
              <p:cNvSpPr txBox="1"/>
              <p:nvPr/>
            </p:nvSpPr>
            <p:spPr>
              <a:xfrm>
                <a:off x="6562545" y="4011298"/>
                <a:ext cx="333947" cy="2102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id="{185248EA-4F70-3BAA-4A3F-852475A445F9}"/>
                  </a:ext>
                </a:extLst>
              </p:cNvPr>
              <p:cNvSpPr txBox="1"/>
              <p:nvPr/>
            </p:nvSpPr>
            <p:spPr>
              <a:xfrm>
                <a:off x="6794018" y="4170981"/>
                <a:ext cx="333947" cy="2102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08" name="Group 107">
            <a:extLst>
              <a:ext uri="{FF2B5EF4-FFF2-40B4-BE49-F238E27FC236}">
                <a16:creationId xmlns:a16="http://schemas.microsoft.com/office/drawing/2014/main" id="{0B6EC11C-0B05-3231-2294-75404AD80876}"/>
              </a:ext>
            </a:extLst>
          </p:cNvPr>
          <p:cNvGrpSpPr/>
          <p:nvPr/>
        </p:nvGrpSpPr>
        <p:grpSpPr>
          <a:xfrm>
            <a:off x="4650964" y="2918133"/>
            <a:ext cx="3923737" cy="2612657"/>
            <a:chOff x="4532378" y="289514"/>
            <a:chExt cx="3923737" cy="2612657"/>
          </a:xfrm>
        </p:grpSpPr>
        <p:graphicFrame>
          <p:nvGraphicFramePr>
            <p:cNvPr id="109" name="Object 108">
              <a:extLst>
                <a:ext uri="{FF2B5EF4-FFF2-40B4-BE49-F238E27FC236}">
                  <a16:creationId xmlns:a16="http://schemas.microsoft.com/office/drawing/2014/main" id="{6AC79D58-1170-D5EE-4D0D-E928451E1EE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4696949"/>
                </p:ext>
              </p:extLst>
            </p:nvPr>
          </p:nvGraphicFramePr>
          <p:xfrm>
            <a:off x="4598490" y="409796"/>
            <a:ext cx="3857625" cy="24923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9" imgW="3858350" imgH="2491654" progId="Prism8.Document">
                    <p:embed/>
                  </p:oleObj>
                </mc:Choice>
                <mc:Fallback>
                  <p:oleObj name="Prism 8" r:id="rId9" imgW="3858350" imgH="2491654" progId="Prism8.Document">
                    <p:embed/>
                    <p:pic>
                      <p:nvPicPr>
                        <p:cNvPr id="109" name="Object 108">
                          <a:extLst>
                            <a:ext uri="{FF2B5EF4-FFF2-40B4-BE49-F238E27FC236}">
                              <a16:creationId xmlns:a16="http://schemas.microsoft.com/office/drawing/2014/main" id="{6AC79D58-1170-D5EE-4D0D-E928451E1EE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4598490" y="409796"/>
                          <a:ext cx="3857625" cy="24923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110" name="Group 109">
              <a:extLst>
                <a:ext uri="{FF2B5EF4-FFF2-40B4-BE49-F238E27FC236}">
                  <a16:creationId xmlns:a16="http://schemas.microsoft.com/office/drawing/2014/main" id="{40A0DBCD-AE23-0C74-9EE9-484CFAAEED91}"/>
                </a:ext>
              </a:extLst>
            </p:cNvPr>
            <p:cNvGrpSpPr/>
            <p:nvPr/>
          </p:nvGrpSpPr>
          <p:grpSpPr>
            <a:xfrm>
              <a:off x="5427661" y="748842"/>
              <a:ext cx="2662146" cy="1733926"/>
              <a:chOff x="964064" y="1177182"/>
              <a:chExt cx="1842478" cy="1202203"/>
            </a:xfrm>
          </p:grpSpPr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id="{084D1DEB-7925-782B-69BD-83E4017576E9}"/>
                  </a:ext>
                </a:extLst>
              </p:cNvPr>
              <p:cNvSpPr txBox="1"/>
              <p:nvPr/>
            </p:nvSpPr>
            <p:spPr>
              <a:xfrm>
                <a:off x="1340992" y="2023509"/>
                <a:ext cx="333947" cy="192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" name="TextBox 112">
                <a:extLst>
                  <a:ext uri="{FF2B5EF4-FFF2-40B4-BE49-F238E27FC236}">
                    <a16:creationId xmlns:a16="http://schemas.microsoft.com/office/drawing/2014/main" id="{E1AEC3BA-5944-FD87-50B6-E3E852690619}"/>
                  </a:ext>
                </a:extLst>
              </p:cNvPr>
              <p:cNvSpPr txBox="1"/>
              <p:nvPr/>
            </p:nvSpPr>
            <p:spPr>
              <a:xfrm>
                <a:off x="1152528" y="2187330"/>
                <a:ext cx="333947" cy="192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4" name="TextBox 113">
                <a:extLst>
                  <a:ext uri="{FF2B5EF4-FFF2-40B4-BE49-F238E27FC236}">
                    <a16:creationId xmlns:a16="http://schemas.microsoft.com/office/drawing/2014/main" id="{D5B3300B-83D8-2753-1B82-CD15A4B2AD28}"/>
                  </a:ext>
                </a:extLst>
              </p:cNvPr>
              <p:cNvSpPr txBox="1"/>
              <p:nvPr/>
            </p:nvSpPr>
            <p:spPr>
              <a:xfrm>
                <a:off x="2100218" y="1752828"/>
                <a:ext cx="333947" cy="192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F0B8A314-C623-9436-5E4C-772CAAF87C64}"/>
                  </a:ext>
                </a:extLst>
              </p:cNvPr>
              <p:cNvSpPr txBox="1"/>
              <p:nvPr/>
            </p:nvSpPr>
            <p:spPr>
              <a:xfrm>
                <a:off x="1527539" y="1177182"/>
                <a:ext cx="333947" cy="192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" name="TextBox 115">
                <a:extLst>
                  <a:ext uri="{FF2B5EF4-FFF2-40B4-BE49-F238E27FC236}">
                    <a16:creationId xmlns:a16="http://schemas.microsoft.com/office/drawing/2014/main" id="{AF4BD2E4-6A1E-055D-62D8-EC60A0D98088}"/>
                  </a:ext>
                </a:extLst>
              </p:cNvPr>
              <p:cNvSpPr txBox="1"/>
              <p:nvPr/>
            </p:nvSpPr>
            <p:spPr>
              <a:xfrm>
                <a:off x="2472595" y="2103328"/>
                <a:ext cx="333947" cy="192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TextBox 116">
                <a:extLst>
                  <a:ext uri="{FF2B5EF4-FFF2-40B4-BE49-F238E27FC236}">
                    <a16:creationId xmlns:a16="http://schemas.microsoft.com/office/drawing/2014/main" id="{6C117317-5423-5021-A308-E19B021EB993}"/>
                  </a:ext>
                </a:extLst>
              </p:cNvPr>
              <p:cNvSpPr txBox="1"/>
              <p:nvPr/>
            </p:nvSpPr>
            <p:spPr>
              <a:xfrm>
                <a:off x="1918026" y="2066059"/>
                <a:ext cx="333947" cy="192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" name="TextBox 117">
                <a:extLst>
                  <a:ext uri="{FF2B5EF4-FFF2-40B4-BE49-F238E27FC236}">
                    <a16:creationId xmlns:a16="http://schemas.microsoft.com/office/drawing/2014/main" id="{DE97E2E6-E1D6-0F3F-7D06-AD819525C7AA}"/>
                  </a:ext>
                </a:extLst>
              </p:cNvPr>
              <p:cNvSpPr txBox="1"/>
              <p:nvPr/>
            </p:nvSpPr>
            <p:spPr>
              <a:xfrm>
                <a:off x="964064" y="2047123"/>
                <a:ext cx="333947" cy="192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9" name="TextBox 118">
                <a:extLst>
                  <a:ext uri="{FF2B5EF4-FFF2-40B4-BE49-F238E27FC236}">
                    <a16:creationId xmlns:a16="http://schemas.microsoft.com/office/drawing/2014/main" id="{852EDDFA-5643-82A4-EC12-28BA41D87832}"/>
                  </a:ext>
                </a:extLst>
              </p:cNvPr>
              <p:cNvSpPr txBox="1"/>
              <p:nvPr/>
            </p:nvSpPr>
            <p:spPr>
              <a:xfrm>
                <a:off x="2282781" y="1917255"/>
                <a:ext cx="333947" cy="192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22A38BF3-2781-B232-32FC-D4E4B873BF16}"/>
                </a:ext>
              </a:extLst>
            </p:cNvPr>
            <p:cNvSpPr txBox="1"/>
            <p:nvPr/>
          </p:nvSpPr>
          <p:spPr>
            <a:xfrm>
              <a:off x="4532378" y="289514"/>
              <a:ext cx="4977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</p:grpSp>
      <p:grpSp>
        <p:nvGrpSpPr>
          <p:cNvPr id="120" name="Group 119">
            <a:extLst>
              <a:ext uri="{FF2B5EF4-FFF2-40B4-BE49-F238E27FC236}">
                <a16:creationId xmlns:a16="http://schemas.microsoft.com/office/drawing/2014/main" id="{5D34CD37-62B4-AF5D-BD7E-AE7B99CA752D}"/>
              </a:ext>
            </a:extLst>
          </p:cNvPr>
          <p:cNvGrpSpPr/>
          <p:nvPr/>
        </p:nvGrpSpPr>
        <p:grpSpPr>
          <a:xfrm>
            <a:off x="8315724" y="2790025"/>
            <a:ext cx="3976688" cy="2773363"/>
            <a:chOff x="8306297" y="2563782"/>
            <a:chExt cx="3976688" cy="2773363"/>
          </a:xfrm>
        </p:grpSpPr>
        <p:graphicFrame>
          <p:nvGraphicFramePr>
            <p:cNvPr id="121" name="Object 120">
              <a:extLst>
                <a:ext uri="{FF2B5EF4-FFF2-40B4-BE49-F238E27FC236}">
                  <a16:creationId xmlns:a16="http://schemas.microsoft.com/office/drawing/2014/main" id="{09DFE9F0-DFA5-9F8A-8BCC-1F76C2243A1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17087335"/>
                </p:ext>
              </p:extLst>
            </p:nvPr>
          </p:nvGraphicFramePr>
          <p:xfrm>
            <a:off x="8306297" y="2563782"/>
            <a:ext cx="3976688" cy="27733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1" imgW="3977135" imgH="2773504" progId="Prism8.Document">
                    <p:embed/>
                  </p:oleObj>
                </mc:Choice>
                <mc:Fallback>
                  <p:oleObj name="Prism 8" r:id="rId11" imgW="3977135" imgH="2773504" progId="Prism8.Document">
                    <p:embed/>
                    <p:pic>
                      <p:nvPicPr>
                        <p:cNvPr id="121" name="Object 120">
                          <a:extLst>
                            <a:ext uri="{FF2B5EF4-FFF2-40B4-BE49-F238E27FC236}">
                              <a16:creationId xmlns:a16="http://schemas.microsoft.com/office/drawing/2014/main" id="{09DFE9F0-DFA5-9F8A-8BCC-1F76C2243A1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8306297" y="2563782"/>
                          <a:ext cx="3976688" cy="27733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122" name="Group 121">
              <a:extLst>
                <a:ext uri="{FF2B5EF4-FFF2-40B4-BE49-F238E27FC236}">
                  <a16:creationId xmlns:a16="http://schemas.microsoft.com/office/drawing/2014/main" id="{3C9FB69E-B412-AE51-72DF-E159796EE8FC}"/>
                </a:ext>
              </a:extLst>
            </p:cNvPr>
            <p:cNvGrpSpPr/>
            <p:nvPr/>
          </p:nvGrpSpPr>
          <p:grpSpPr>
            <a:xfrm>
              <a:off x="9223992" y="3241137"/>
              <a:ext cx="2574028" cy="1665687"/>
              <a:chOff x="4758482" y="3432258"/>
              <a:chExt cx="2099021" cy="1391454"/>
            </a:xfrm>
          </p:grpSpPr>
          <p:sp>
            <p:nvSpPr>
              <p:cNvPr id="124" name="TextBox 123">
                <a:extLst>
                  <a:ext uri="{FF2B5EF4-FFF2-40B4-BE49-F238E27FC236}">
                    <a16:creationId xmlns:a16="http://schemas.microsoft.com/office/drawing/2014/main" id="{8AFD8EDF-A009-C771-EA18-9CA2A531528E}"/>
                  </a:ext>
                </a:extLst>
              </p:cNvPr>
              <p:cNvSpPr txBox="1"/>
              <p:nvPr/>
            </p:nvSpPr>
            <p:spPr>
              <a:xfrm>
                <a:off x="5428042" y="3432258"/>
                <a:ext cx="333947" cy="2313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5" name="TextBox 124">
                <a:extLst>
                  <a:ext uri="{FF2B5EF4-FFF2-40B4-BE49-F238E27FC236}">
                    <a16:creationId xmlns:a16="http://schemas.microsoft.com/office/drawing/2014/main" id="{E097815D-22E7-D4AB-9C78-2F336C91EE88}"/>
                  </a:ext>
                </a:extLst>
              </p:cNvPr>
              <p:cNvSpPr txBox="1"/>
              <p:nvPr/>
            </p:nvSpPr>
            <p:spPr>
              <a:xfrm>
                <a:off x="4758482" y="4552345"/>
                <a:ext cx="333947" cy="2313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TextBox 125">
                <a:extLst>
                  <a:ext uri="{FF2B5EF4-FFF2-40B4-BE49-F238E27FC236}">
                    <a16:creationId xmlns:a16="http://schemas.microsoft.com/office/drawing/2014/main" id="{20195401-D2CB-48A1-1125-D78821DE644B}"/>
                  </a:ext>
                </a:extLst>
              </p:cNvPr>
              <p:cNvSpPr txBox="1"/>
              <p:nvPr/>
            </p:nvSpPr>
            <p:spPr>
              <a:xfrm>
                <a:off x="5187278" y="4546922"/>
                <a:ext cx="333947" cy="2313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TextBox 126">
                <a:extLst>
                  <a:ext uri="{FF2B5EF4-FFF2-40B4-BE49-F238E27FC236}">
                    <a16:creationId xmlns:a16="http://schemas.microsoft.com/office/drawing/2014/main" id="{7A533AFF-B74E-787E-AB98-936658A710E2}"/>
                  </a:ext>
                </a:extLst>
              </p:cNvPr>
              <p:cNvSpPr txBox="1"/>
              <p:nvPr/>
            </p:nvSpPr>
            <p:spPr>
              <a:xfrm>
                <a:off x="4988418" y="4592317"/>
                <a:ext cx="333947" cy="2313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TextBox 127">
                <a:extLst>
                  <a:ext uri="{FF2B5EF4-FFF2-40B4-BE49-F238E27FC236}">
                    <a16:creationId xmlns:a16="http://schemas.microsoft.com/office/drawing/2014/main" id="{4BFDAA8B-B432-5254-75B5-29A121C353D6}"/>
                  </a:ext>
                </a:extLst>
              </p:cNvPr>
              <p:cNvSpPr txBox="1"/>
              <p:nvPr/>
            </p:nvSpPr>
            <p:spPr>
              <a:xfrm>
                <a:off x="6100106" y="3583815"/>
                <a:ext cx="333947" cy="2313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9" name="TextBox 128">
                <a:extLst>
                  <a:ext uri="{FF2B5EF4-FFF2-40B4-BE49-F238E27FC236}">
                    <a16:creationId xmlns:a16="http://schemas.microsoft.com/office/drawing/2014/main" id="{E062A9A1-7868-CF9A-8926-7D95947A0A69}"/>
                  </a:ext>
                </a:extLst>
              </p:cNvPr>
              <p:cNvSpPr txBox="1"/>
              <p:nvPr/>
            </p:nvSpPr>
            <p:spPr>
              <a:xfrm>
                <a:off x="6294826" y="4502278"/>
                <a:ext cx="333947" cy="2313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0" name="TextBox 129">
                <a:extLst>
                  <a:ext uri="{FF2B5EF4-FFF2-40B4-BE49-F238E27FC236}">
                    <a16:creationId xmlns:a16="http://schemas.microsoft.com/office/drawing/2014/main" id="{B1FDCCC7-B916-B646-C778-82EBD1B58131}"/>
                  </a:ext>
                </a:extLst>
              </p:cNvPr>
              <p:cNvSpPr txBox="1"/>
              <p:nvPr/>
            </p:nvSpPr>
            <p:spPr>
              <a:xfrm>
                <a:off x="5845864" y="4556627"/>
                <a:ext cx="333947" cy="2313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1" name="TextBox 130">
                <a:extLst>
                  <a:ext uri="{FF2B5EF4-FFF2-40B4-BE49-F238E27FC236}">
                    <a16:creationId xmlns:a16="http://schemas.microsoft.com/office/drawing/2014/main" id="{7E19B629-FCAD-6945-377F-D4E0E2E24EE8}"/>
                  </a:ext>
                </a:extLst>
              </p:cNvPr>
              <p:cNvSpPr txBox="1"/>
              <p:nvPr/>
            </p:nvSpPr>
            <p:spPr>
              <a:xfrm>
                <a:off x="6523556" y="4536009"/>
                <a:ext cx="333947" cy="2313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1D4F2C82-CBF7-3F99-0D29-201BD3FB23D1}"/>
                </a:ext>
              </a:extLst>
            </p:cNvPr>
            <p:cNvSpPr txBox="1"/>
            <p:nvPr/>
          </p:nvSpPr>
          <p:spPr>
            <a:xfrm>
              <a:off x="8486497" y="2583491"/>
              <a:ext cx="4977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</p:grpSp>
      <p:sp>
        <p:nvSpPr>
          <p:cNvPr id="132" name="TextBox 131">
            <a:extLst>
              <a:ext uri="{FF2B5EF4-FFF2-40B4-BE49-F238E27FC236}">
                <a16:creationId xmlns:a16="http://schemas.microsoft.com/office/drawing/2014/main" id="{3FC651A3-DDF8-9618-A5AC-F4A39C207FFE}"/>
              </a:ext>
            </a:extLst>
          </p:cNvPr>
          <p:cNvSpPr txBox="1"/>
          <p:nvPr/>
        </p:nvSpPr>
        <p:spPr>
          <a:xfrm>
            <a:off x="8415608" y="319885"/>
            <a:ext cx="497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5378D34B-E8A4-6744-AE51-7BEA86F35096}"/>
              </a:ext>
            </a:extLst>
          </p:cNvPr>
          <p:cNvSpPr txBox="1"/>
          <p:nvPr/>
        </p:nvSpPr>
        <p:spPr>
          <a:xfrm>
            <a:off x="382440" y="2835074"/>
            <a:ext cx="497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155BE810-E361-F307-E2C4-C8269E1FA5E3}"/>
              </a:ext>
            </a:extLst>
          </p:cNvPr>
          <p:cNvGrpSpPr/>
          <p:nvPr/>
        </p:nvGrpSpPr>
        <p:grpSpPr>
          <a:xfrm>
            <a:off x="519113" y="441325"/>
            <a:ext cx="3986212" cy="2492375"/>
            <a:chOff x="593262" y="2867173"/>
            <a:chExt cx="3986212" cy="2492375"/>
          </a:xfrm>
        </p:grpSpPr>
        <p:graphicFrame>
          <p:nvGraphicFramePr>
            <p:cNvPr id="134" name="Object 133">
              <a:extLst>
                <a:ext uri="{FF2B5EF4-FFF2-40B4-BE49-F238E27FC236}">
                  <a16:creationId xmlns:a16="http://schemas.microsoft.com/office/drawing/2014/main" id="{CC7489CA-7BAD-22D3-CC13-E1B82E9F63B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3967612"/>
                </p:ext>
              </p:extLst>
            </p:nvPr>
          </p:nvGraphicFramePr>
          <p:xfrm>
            <a:off x="593262" y="2867173"/>
            <a:ext cx="3986212" cy="24923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3" imgW="3986134" imgH="2491654" progId="Prism8.Document">
                    <p:embed/>
                  </p:oleObj>
                </mc:Choice>
                <mc:Fallback>
                  <p:oleObj name="Prism 8" r:id="rId13" imgW="3986134" imgH="2491654" progId="Prism8.Document">
                    <p:embed/>
                    <p:pic>
                      <p:nvPicPr>
                        <p:cNvPr id="134" name="Object 133">
                          <a:extLst>
                            <a:ext uri="{FF2B5EF4-FFF2-40B4-BE49-F238E27FC236}">
                              <a16:creationId xmlns:a16="http://schemas.microsoft.com/office/drawing/2014/main" id="{CC7489CA-7BAD-22D3-CC13-E1B82E9F63B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593262" y="2867173"/>
                          <a:ext cx="3986212" cy="24923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02DF92FE-4D38-D971-0C0C-2AFC740F5087}"/>
                </a:ext>
              </a:extLst>
            </p:cNvPr>
            <p:cNvSpPr txBox="1"/>
            <p:nvPr/>
          </p:nvSpPr>
          <p:spPr>
            <a:xfrm>
              <a:off x="1531078" y="4505128"/>
              <a:ext cx="4240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589B139A-2593-7867-2D8F-81CAB94A4D21}"/>
                </a:ext>
              </a:extLst>
            </p:cNvPr>
            <p:cNvSpPr txBox="1"/>
            <p:nvPr/>
          </p:nvSpPr>
          <p:spPr>
            <a:xfrm>
              <a:off x="2080036" y="4463336"/>
              <a:ext cx="4240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59215442-F42F-9787-FC23-FAD58A0CA4A6}"/>
                </a:ext>
              </a:extLst>
            </p:cNvPr>
            <p:cNvSpPr txBox="1"/>
            <p:nvPr/>
          </p:nvSpPr>
          <p:spPr>
            <a:xfrm>
              <a:off x="1811568" y="4641186"/>
              <a:ext cx="4240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3A34A3DB-6C76-16A0-8F4A-A5846E0928E0}"/>
                </a:ext>
              </a:extLst>
            </p:cNvPr>
            <p:cNvSpPr txBox="1"/>
            <p:nvPr/>
          </p:nvSpPr>
          <p:spPr>
            <a:xfrm>
              <a:off x="2350797" y="4028503"/>
              <a:ext cx="4240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5F5D7AC6-27C5-022E-8124-D1E1C4855ECA}"/>
                </a:ext>
              </a:extLst>
            </p:cNvPr>
            <p:cNvSpPr txBox="1"/>
            <p:nvPr/>
          </p:nvSpPr>
          <p:spPr>
            <a:xfrm>
              <a:off x="3172098" y="3139603"/>
              <a:ext cx="4240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82601D06-B62E-C29D-371A-66ABBDFC59C6}"/>
                </a:ext>
              </a:extLst>
            </p:cNvPr>
            <p:cNvSpPr txBox="1"/>
            <p:nvPr/>
          </p:nvSpPr>
          <p:spPr>
            <a:xfrm>
              <a:off x="3438832" y="4314413"/>
              <a:ext cx="4240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55917FD0-16BB-D7C7-6420-5ED5FD5E5269}"/>
                </a:ext>
              </a:extLst>
            </p:cNvPr>
            <p:cNvSpPr txBox="1"/>
            <p:nvPr/>
          </p:nvSpPr>
          <p:spPr>
            <a:xfrm>
              <a:off x="3696170" y="4528837"/>
              <a:ext cx="4240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4E9A1370-26C0-06BA-E893-E211FE371EEC}"/>
                </a:ext>
              </a:extLst>
            </p:cNvPr>
            <p:cNvSpPr txBox="1"/>
            <p:nvPr/>
          </p:nvSpPr>
          <p:spPr>
            <a:xfrm>
              <a:off x="2897950" y="4519107"/>
              <a:ext cx="4240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5088155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" name="Group 34">
            <a:extLst>
              <a:ext uri="{FF2B5EF4-FFF2-40B4-BE49-F238E27FC236}">
                <a16:creationId xmlns:a16="http://schemas.microsoft.com/office/drawing/2014/main" id="{3ACB0892-DA15-D370-14DA-BB7042A25660}"/>
              </a:ext>
            </a:extLst>
          </p:cNvPr>
          <p:cNvGrpSpPr/>
          <p:nvPr/>
        </p:nvGrpSpPr>
        <p:grpSpPr>
          <a:xfrm>
            <a:off x="8196077" y="207700"/>
            <a:ext cx="3976688" cy="2528888"/>
            <a:chOff x="8101640" y="1393890"/>
            <a:chExt cx="3976688" cy="2528888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AB1705A0-DB0E-1E4B-D340-8A51FEA6F9DD}"/>
                </a:ext>
              </a:extLst>
            </p:cNvPr>
            <p:cNvSpPr txBox="1"/>
            <p:nvPr/>
          </p:nvSpPr>
          <p:spPr>
            <a:xfrm>
              <a:off x="9856192" y="3019819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9743AEA7-57CE-4A2F-94B5-78CC3756B7C0}"/>
                </a:ext>
              </a:extLst>
            </p:cNvPr>
            <p:cNvSpPr txBox="1"/>
            <p:nvPr/>
          </p:nvSpPr>
          <p:spPr>
            <a:xfrm>
              <a:off x="9580918" y="3187439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580F6653-6C4F-9B9A-17C5-57105AED13AC}"/>
                </a:ext>
              </a:extLst>
            </p:cNvPr>
            <p:cNvSpPr txBox="1"/>
            <p:nvPr/>
          </p:nvSpPr>
          <p:spPr>
            <a:xfrm>
              <a:off x="9295682" y="1549666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0C64DF6D-DB06-2391-E25F-71C28CDCABE3}"/>
                </a:ext>
              </a:extLst>
            </p:cNvPr>
            <p:cNvSpPr txBox="1"/>
            <p:nvPr/>
          </p:nvSpPr>
          <p:spPr>
            <a:xfrm>
              <a:off x="10963373" y="2999065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BE1FAAFD-8749-4873-419E-AEA4EC36DC0F}"/>
                </a:ext>
              </a:extLst>
            </p:cNvPr>
            <p:cNvSpPr txBox="1"/>
            <p:nvPr/>
          </p:nvSpPr>
          <p:spPr>
            <a:xfrm>
              <a:off x="10406111" y="3137564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E8055C42-B162-49C6-17AC-89E50B99F2EC}"/>
                </a:ext>
              </a:extLst>
            </p:cNvPr>
            <p:cNvSpPr txBox="1"/>
            <p:nvPr/>
          </p:nvSpPr>
          <p:spPr>
            <a:xfrm>
              <a:off x="9030999" y="3134422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8B744773-6B73-85C2-BCFC-50A189F98849}"/>
                </a:ext>
              </a:extLst>
            </p:cNvPr>
            <p:cNvSpPr txBox="1"/>
            <p:nvPr/>
          </p:nvSpPr>
          <p:spPr>
            <a:xfrm>
              <a:off x="11227229" y="3137565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3C624C8B-BB5B-58E7-E835-1C7BA67F4921}"/>
                </a:ext>
              </a:extLst>
            </p:cNvPr>
            <p:cNvSpPr txBox="1"/>
            <p:nvPr/>
          </p:nvSpPr>
          <p:spPr>
            <a:xfrm>
              <a:off x="10679817" y="3009042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id="{F7D94CA5-F00B-BC66-ADBD-7E4AA250F72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32162032"/>
                </p:ext>
              </p:extLst>
            </p:nvPr>
          </p:nvGraphicFramePr>
          <p:xfrm>
            <a:off x="8101640" y="1393890"/>
            <a:ext cx="3976688" cy="25288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" imgW="3977135" imgH="2529450" progId="Prism8.Document">
                    <p:embed/>
                  </p:oleObj>
                </mc:Choice>
                <mc:Fallback>
                  <p:oleObj name="Prism 8" r:id="rId2" imgW="3977135" imgH="2529450" progId="Prism8.Document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id="{F7D94CA5-F00B-BC66-ADBD-7E4AA250F72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8101640" y="1393890"/>
                          <a:ext cx="3976688" cy="25288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A25209FD-3526-C7F9-E512-527ACBC132CE}"/>
              </a:ext>
            </a:extLst>
          </p:cNvPr>
          <p:cNvGrpSpPr/>
          <p:nvPr/>
        </p:nvGrpSpPr>
        <p:grpSpPr>
          <a:xfrm>
            <a:off x="2390634" y="2993857"/>
            <a:ext cx="8061868" cy="2528887"/>
            <a:chOff x="3965285" y="2782051"/>
            <a:chExt cx="8061868" cy="2528887"/>
          </a:xfrm>
        </p:grpSpPr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918277F8-DB2C-4E3C-EB40-6F583921B906}"/>
                </a:ext>
              </a:extLst>
            </p:cNvPr>
            <p:cNvSpPr txBox="1"/>
            <p:nvPr/>
          </p:nvSpPr>
          <p:spPr>
            <a:xfrm>
              <a:off x="5181336" y="3086442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8FBD753-4FED-0C2B-DE51-B8BCADB39525}"/>
                </a:ext>
              </a:extLst>
            </p:cNvPr>
            <p:cNvSpPr txBox="1"/>
            <p:nvPr/>
          </p:nvSpPr>
          <p:spPr>
            <a:xfrm>
              <a:off x="5712016" y="4320945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AD5B28E8-2018-D3D0-AEF3-96ADE6D23025}"/>
                </a:ext>
              </a:extLst>
            </p:cNvPr>
            <p:cNvSpPr txBox="1"/>
            <p:nvPr/>
          </p:nvSpPr>
          <p:spPr>
            <a:xfrm>
              <a:off x="5437249" y="4551730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914DDB51-18CE-1BD9-0816-43B20068A9CC}"/>
                </a:ext>
              </a:extLst>
            </p:cNvPr>
            <p:cNvSpPr txBox="1"/>
            <p:nvPr/>
          </p:nvSpPr>
          <p:spPr>
            <a:xfrm>
              <a:off x="4875670" y="4513065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01751AE5-28A8-28FD-9186-D3FDB8ACFB4D}"/>
                </a:ext>
              </a:extLst>
            </p:cNvPr>
            <p:cNvSpPr txBox="1"/>
            <p:nvPr/>
          </p:nvSpPr>
          <p:spPr>
            <a:xfrm>
              <a:off x="6255875" y="4506580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B020598A-47D0-F505-21F9-D20B011BC872}"/>
                </a:ext>
              </a:extLst>
            </p:cNvPr>
            <p:cNvSpPr txBox="1"/>
            <p:nvPr/>
          </p:nvSpPr>
          <p:spPr>
            <a:xfrm>
              <a:off x="6520046" y="4490610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E9B9BD0B-694B-9904-637F-F61009B302B1}"/>
                </a:ext>
              </a:extLst>
            </p:cNvPr>
            <p:cNvSpPr txBox="1"/>
            <p:nvPr/>
          </p:nvSpPr>
          <p:spPr>
            <a:xfrm>
              <a:off x="6788733" y="4471617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CE1F9E7A-585D-E9A2-A457-7F37D9FB2164}"/>
                </a:ext>
              </a:extLst>
            </p:cNvPr>
            <p:cNvSpPr txBox="1"/>
            <p:nvPr/>
          </p:nvSpPr>
          <p:spPr>
            <a:xfrm>
              <a:off x="7088630" y="4550684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33" name="Object 32">
              <a:extLst>
                <a:ext uri="{FF2B5EF4-FFF2-40B4-BE49-F238E27FC236}">
                  <a16:creationId xmlns:a16="http://schemas.microsoft.com/office/drawing/2014/main" id="{FD7E7BD6-4F44-4613-7C94-45EDDAAEE15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89354643"/>
                </p:ext>
              </p:extLst>
            </p:nvPr>
          </p:nvGraphicFramePr>
          <p:xfrm>
            <a:off x="3965285" y="2782051"/>
            <a:ext cx="3976687" cy="25288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4" imgW="3977135" imgH="2529450" progId="Prism8.Document">
                    <p:embed/>
                  </p:oleObj>
                </mc:Choice>
                <mc:Fallback>
                  <p:oleObj name="Prism 8" r:id="rId4" imgW="3977135" imgH="2529450" progId="Prism8.Document">
                    <p:embed/>
                    <p:pic>
                      <p:nvPicPr>
                        <p:cNvPr id="33" name="Object 32">
                          <a:extLst>
                            <a:ext uri="{FF2B5EF4-FFF2-40B4-BE49-F238E27FC236}">
                              <a16:creationId xmlns:a16="http://schemas.microsoft.com/office/drawing/2014/main" id="{FD7E7BD6-4F44-4613-7C94-45EDDAAEE15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3965285" y="2782051"/>
                          <a:ext cx="3976687" cy="25288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AD22D70F-3743-A06E-A6B9-9F5AC419505F}"/>
                </a:ext>
              </a:extLst>
            </p:cNvPr>
            <p:cNvSpPr txBox="1"/>
            <p:nvPr/>
          </p:nvSpPr>
          <p:spPr>
            <a:xfrm>
              <a:off x="9262756" y="3163624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6828BAEE-7472-5775-B32E-3F9CD6DD0CE9}"/>
                </a:ext>
              </a:extLst>
            </p:cNvPr>
            <p:cNvSpPr txBox="1"/>
            <p:nvPr/>
          </p:nvSpPr>
          <p:spPr>
            <a:xfrm>
              <a:off x="8997334" y="4535067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39D9966D-B434-17CF-8836-76698E3FD9AF}"/>
                </a:ext>
              </a:extLst>
            </p:cNvPr>
            <p:cNvSpPr txBox="1"/>
            <p:nvPr/>
          </p:nvSpPr>
          <p:spPr>
            <a:xfrm>
              <a:off x="9524084" y="4601281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60C613D5-1826-BB0F-4518-4EDF244069FD}"/>
                </a:ext>
              </a:extLst>
            </p:cNvPr>
            <p:cNvSpPr txBox="1"/>
            <p:nvPr/>
          </p:nvSpPr>
          <p:spPr>
            <a:xfrm>
              <a:off x="9829428" y="3897448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8088E790-D16F-1D56-28D2-1BFCCBA2364A}"/>
                </a:ext>
              </a:extLst>
            </p:cNvPr>
            <p:cNvSpPr txBox="1"/>
            <p:nvPr/>
          </p:nvSpPr>
          <p:spPr>
            <a:xfrm>
              <a:off x="10338749" y="4541138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C6693369-59C5-9C37-B95D-B50D68CAB61B}"/>
                </a:ext>
              </a:extLst>
            </p:cNvPr>
            <p:cNvSpPr txBox="1"/>
            <p:nvPr/>
          </p:nvSpPr>
          <p:spPr>
            <a:xfrm>
              <a:off x="10614870" y="4532183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2C2DA008-B010-104D-6FFA-A41A17F27A39}"/>
                </a:ext>
              </a:extLst>
            </p:cNvPr>
            <p:cNvSpPr txBox="1"/>
            <p:nvPr/>
          </p:nvSpPr>
          <p:spPr>
            <a:xfrm>
              <a:off x="10920536" y="4520400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11398B4E-E076-924F-EDE5-5C71C4FE343C}"/>
                </a:ext>
              </a:extLst>
            </p:cNvPr>
            <p:cNvSpPr txBox="1"/>
            <p:nvPr/>
          </p:nvSpPr>
          <p:spPr>
            <a:xfrm>
              <a:off x="11196657" y="4532183"/>
              <a:ext cx="3339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45" name="Object 44">
              <a:extLst>
                <a:ext uri="{FF2B5EF4-FFF2-40B4-BE49-F238E27FC236}">
                  <a16:creationId xmlns:a16="http://schemas.microsoft.com/office/drawing/2014/main" id="{B9F57909-3FD3-2603-2E84-D8D7F212B78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15274371"/>
                </p:ext>
              </p:extLst>
            </p:nvPr>
          </p:nvGraphicFramePr>
          <p:xfrm>
            <a:off x="8031416" y="2782051"/>
            <a:ext cx="3995737" cy="24923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6" imgW="3995493" imgH="2491654" progId="Prism8.Document">
                    <p:embed/>
                  </p:oleObj>
                </mc:Choice>
                <mc:Fallback>
                  <p:oleObj name="Prism 8" r:id="rId6" imgW="3995493" imgH="2491654" progId="Prism8.Document">
                    <p:embed/>
                    <p:pic>
                      <p:nvPicPr>
                        <p:cNvPr id="45" name="Object 44">
                          <a:extLst>
                            <a:ext uri="{FF2B5EF4-FFF2-40B4-BE49-F238E27FC236}">
                              <a16:creationId xmlns:a16="http://schemas.microsoft.com/office/drawing/2014/main" id="{B9F57909-3FD3-2603-2E84-D8D7F212B78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8031416" y="2782051"/>
                          <a:ext cx="3995737" cy="24923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DE23FFF4-1837-80E2-ECC7-BE50D74922AD}"/>
              </a:ext>
            </a:extLst>
          </p:cNvPr>
          <p:cNvSpPr txBox="1"/>
          <p:nvPr/>
        </p:nvSpPr>
        <p:spPr>
          <a:xfrm>
            <a:off x="13501538" y="2418074"/>
            <a:ext cx="497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B6CCF7F-B8D0-CE10-FA67-AFF799750DB8}"/>
              </a:ext>
            </a:extLst>
          </p:cNvPr>
          <p:cNvSpPr txBox="1"/>
          <p:nvPr/>
        </p:nvSpPr>
        <p:spPr>
          <a:xfrm>
            <a:off x="4273365" y="76853"/>
            <a:ext cx="497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0EE6CBF-AA1B-D29E-8B52-D9E7F97A6C0B}"/>
              </a:ext>
            </a:extLst>
          </p:cNvPr>
          <p:cNvSpPr txBox="1"/>
          <p:nvPr/>
        </p:nvSpPr>
        <p:spPr>
          <a:xfrm>
            <a:off x="8245444" y="109613"/>
            <a:ext cx="497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1AE6895-30E6-5625-6393-06910BDCDAFB}"/>
              </a:ext>
            </a:extLst>
          </p:cNvPr>
          <p:cNvSpPr txBox="1"/>
          <p:nvPr/>
        </p:nvSpPr>
        <p:spPr>
          <a:xfrm>
            <a:off x="2702019" y="2802240"/>
            <a:ext cx="497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3EA354F-15B3-EF03-9D55-9099E06C4B38}"/>
              </a:ext>
            </a:extLst>
          </p:cNvPr>
          <p:cNvSpPr txBox="1"/>
          <p:nvPr/>
        </p:nvSpPr>
        <p:spPr>
          <a:xfrm>
            <a:off x="226190" y="5674182"/>
            <a:ext cx="1199252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7: 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Effect of melatonin priming on relative fold change expression of MAPK and  necrosis related genes under optimal and PEG-induced stress conditions in drought sensitive (L-799) and drought tolerant (Suraj) varieties of cotton (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Gossypium hirsutum 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L.). Relative fold change expression of necrosis related genes A) 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RAF18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 B) 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BAG2, C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 BAG6, D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MC9 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and E) 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SOG1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data represent mean values ± SD of 3 independent experiments, with 3 replicates per treatment in each experiment. Different alphabets represent significant differences among the treatments according to Duncan multiple range test (DMRT) at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value ≤ 0.05.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6" name="Object 45">
            <a:extLst>
              <a:ext uri="{FF2B5EF4-FFF2-40B4-BE49-F238E27FC236}">
                <a16:creationId xmlns:a16="http://schemas.microsoft.com/office/drawing/2014/main" id="{B435C6FC-1FFD-80A9-5EC1-65E7510BD3C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58296664"/>
              </p:ext>
            </p:extLst>
          </p:nvPr>
        </p:nvGraphicFramePr>
        <p:xfrm>
          <a:off x="415524" y="296927"/>
          <a:ext cx="3922712" cy="2492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3922422" imgH="2491654" progId="Prism8.Document">
                  <p:embed/>
                </p:oleObj>
              </mc:Choice>
              <mc:Fallback>
                <p:oleObj name="Prism 8" r:id="rId8" imgW="3922422" imgH="2491654" progId="Prism8.Document">
                  <p:embed/>
                  <p:pic>
                    <p:nvPicPr>
                      <p:cNvPr id="46" name="Object 45">
                        <a:extLst>
                          <a:ext uri="{FF2B5EF4-FFF2-40B4-BE49-F238E27FC236}">
                            <a16:creationId xmlns:a16="http://schemas.microsoft.com/office/drawing/2014/main" id="{B435C6FC-1FFD-80A9-5EC1-65E7510BD3C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15524" y="296927"/>
                        <a:ext cx="3922712" cy="2492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7" name="TextBox 46">
            <a:extLst>
              <a:ext uri="{FF2B5EF4-FFF2-40B4-BE49-F238E27FC236}">
                <a16:creationId xmlns:a16="http://schemas.microsoft.com/office/drawing/2014/main" id="{3F6F7614-5AC7-CBF8-DC54-EF4583CD68D6}"/>
              </a:ext>
            </a:extLst>
          </p:cNvPr>
          <p:cNvSpPr txBox="1"/>
          <p:nvPr/>
        </p:nvSpPr>
        <p:spPr>
          <a:xfrm>
            <a:off x="327427" y="319382"/>
            <a:ext cx="497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3082D076-5CFF-7DF8-59AA-993CCE293A68}"/>
              </a:ext>
            </a:extLst>
          </p:cNvPr>
          <p:cNvSpPr txBox="1"/>
          <p:nvPr/>
        </p:nvSpPr>
        <p:spPr>
          <a:xfrm>
            <a:off x="2146994" y="1034968"/>
            <a:ext cx="3325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EE13E216-38A9-DD6E-BD7E-08FA349D3E21}"/>
              </a:ext>
            </a:extLst>
          </p:cNvPr>
          <p:cNvSpPr txBox="1"/>
          <p:nvPr/>
        </p:nvSpPr>
        <p:spPr>
          <a:xfrm>
            <a:off x="1327154" y="1893861"/>
            <a:ext cx="3325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74DEFA3-580F-4A97-8D25-B465AEAD1ED0}"/>
              </a:ext>
            </a:extLst>
          </p:cNvPr>
          <p:cNvSpPr txBox="1"/>
          <p:nvPr/>
        </p:nvSpPr>
        <p:spPr>
          <a:xfrm>
            <a:off x="1872009" y="1904916"/>
            <a:ext cx="3325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C76DEAF5-3762-C3A1-0DDC-265D93C5F153}"/>
              </a:ext>
            </a:extLst>
          </p:cNvPr>
          <p:cNvSpPr txBox="1"/>
          <p:nvPr/>
        </p:nvSpPr>
        <p:spPr>
          <a:xfrm>
            <a:off x="1599582" y="2141699"/>
            <a:ext cx="3325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908E21FB-92E9-4F36-E15F-5D206E02B29A}"/>
              </a:ext>
            </a:extLst>
          </p:cNvPr>
          <p:cNvSpPr txBox="1"/>
          <p:nvPr/>
        </p:nvSpPr>
        <p:spPr>
          <a:xfrm>
            <a:off x="2965330" y="499701"/>
            <a:ext cx="3325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2348AA7-F617-41CC-FD2C-41B4C7B0F10D}"/>
              </a:ext>
            </a:extLst>
          </p:cNvPr>
          <p:cNvSpPr txBox="1"/>
          <p:nvPr/>
        </p:nvSpPr>
        <p:spPr>
          <a:xfrm>
            <a:off x="3239388" y="1567452"/>
            <a:ext cx="3325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6DA85498-0F90-B0B5-0266-365BFC9848D1}"/>
              </a:ext>
            </a:extLst>
          </p:cNvPr>
          <p:cNvSpPr txBox="1"/>
          <p:nvPr/>
        </p:nvSpPr>
        <p:spPr>
          <a:xfrm>
            <a:off x="2702019" y="1900024"/>
            <a:ext cx="3325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BC224530-7CAB-13CD-23DA-2E674E570930}"/>
              </a:ext>
            </a:extLst>
          </p:cNvPr>
          <p:cNvSpPr txBox="1"/>
          <p:nvPr/>
        </p:nvSpPr>
        <p:spPr>
          <a:xfrm>
            <a:off x="3503961" y="1923581"/>
            <a:ext cx="3325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1CD581F7-9FA6-9597-1CE6-7A45C2095F86}"/>
              </a:ext>
            </a:extLst>
          </p:cNvPr>
          <p:cNvSpPr txBox="1"/>
          <p:nvPr/>
        </p:nvSpPr>
        <p:spPr>
          <a:xfrm>
            <a:off x="6816137" y="2770746"/>
            <a:ext cx="497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5" name="Group 64">
            <a:extLst>
              <a:ext uri="{FF2B5EF4-FFF2-40B4-BE49-F238E27FC236}">
                <a16:creationId xmlns:a16="http://schemas.microsoft.com/office/drawing/2014/main" id="{1D99191B-41FB-38AF-04E6-94306131FF39}"/>
              </a:ext>
            </a:extLst>
          </p:cNvPr>
          <p:cNvGrpSpPr/>
          <p:nvPr/>
        </p:nvGrpSpPr>
        <p:grpSpPr>
          <a:xfrm>
            <a:off x="4388127" y="244213"/>
            <a:ext cx="4056062" cy="2492375"/>
            <a:chOff x="4172093" y="346285"/>
            <a:chExt cx="4056062" cy="2492375"/>
          </a:xfrm>
        </p:grpSpPr>
        <p:graphicFrame>
          <p:nvGraphicFramePr>
            <p:cNvPr id="43" name="Object 42">
              <a:extLst>
                <a:ext uri="{FF2B5EF4-FFF2-40B4-BE49-F238E27FC236}">
                  <a16:creationId xmlns:a16="http://schemas.microsoft.com/office/drawing/2014/main" id="{E9CF4B96-6099-3B79-FFE2-0EFD4CAA5CC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29150596"/>
                </p:ext>
              </p:extLst>
            </p:nvPr>
          </p:nvGraphicFramePr>
          <p:xfrm>
            <a:off x="4172093" y="346285"/>
            <a:ext cx="4056062" cy="24923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0" imgW="4056325" imgH="2491654" progId="Prism8.Document">
                    <p:embed/>
                  </p:oleObj>
                </mc:Choice>
                <mc:Fallback>
                  <p:oleObj name="Prism 8" r:id="rId10" imgW="4056325" imgH="2491654" progId="Prism8.Document">
                    <p:embed/>
                    <p:pic>
                      <p:nvPicPr>
                        <p:cNvPr id="43" name="Object 42">
                          <a:extLst>
                            <a:ext uri="{FF2B5EF4-FFF2-40B4-BE49-F238E27FC236}">
                              <a16:creationId xmlns:a16="http://schemas.microsoft.com/office/drawing/2014/main" id="{E9CF4B96-6099-3B79-FFE2-0EFD4CAA5CC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4172093" y="346285"/>
                          <a:ext cx="4056062" cy="24923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56" name="Group 55">
              <a:extLst>
                <a:ext uri="{FF2B5EF4-FFF2-40B4-BE49-F238E27FC236}">
                  <a16:creationId xmlns:a16="http://schemas.microsoft.com/office/drawing/2014/main" id="{11112B47-DEEB-A31E-4B7A-1CCF55E4D1DA}"/>
                </a:ext>
              </a:extLst>
            </p:cNvPr>
            <p:cNvGrpSpPr/>
            <p:nvPr/>
          </p:nvGrpSpPr>
          <p:grpSpPr>
            <a:xfrm>
              <a:off x="5214432" y="490518"/>
              <a:ext cx="2527992" cy="1748265"/>
              <a:chOff x="1174945" y="719243"/>
              <a:chExt cx="2527992" cy="1748265"/>
            </a:xfrm>
          </p:grpSpPr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94F61B9F-4396-02AC-22BD-C2C1BE09AEBE}"/>
                  </a:ext>
                </a:extLst>
              </p:cNvPr>
              <p:cNvSpPr txBox="1"/>
              <p:nvPr/>
            </p:nvSpPr>
            <p:spPr>
              <a:xfrm>
                <a:off x="1993537" y="1690610"/>
                <a:ext cx="33394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32DD36A4-B7C7-EAD0-02BC-DC8C35A45E9A}"/>
                  </a:ext>
                </a:extLst>
              </p:cNvPr>
              <p:cNvSpPr txBox="1"/>
              <p:nvPr/>
            </p:nvSpPr>
            <p:spPr>
              <a:xfrm>
                <a:off x="1174945" y="1904083"/>
                <a:ext cx="33394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9425323A-A192-746A-CBBF-AB4315569A2E}"/>
                  </a:ext>
                </a:extLst>
              </p:cNvPr>
              <p:cNvSpPr txBox="1"/>
              <p:nvPr/>
            </p:nvSpPr>
            <p:spPr>
              <a:xfrm>
                <a:off x="1450864" y="719243"/>
                <a:ext cx="33394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F0B9C63B-22E7-0F73-21BC-4C389D90FCC6}"/>
                  </a:ext>
                </a:extLst>
              </p:cNvPr>
              <p:cNvSpPr txBox="1"/>
              <p:nvPr/>
            </p:nvSpPr>
            <p:spPr>
              <a:xfrm>
                <a:off x="3083724" y="1530314"/>
                <a:ext cx="33394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55347900-0B4A-D881-B3F5-DD288F69B64A}"/>
                  </a:ext>
                </a:extLst>
              </p:cNvPr>
              <p:cNvSpPr txBox="1"/>
              <p:nvPr/>
            </p:nvSpPr>
            <p:spPr>
              <a:xfrm>
                <a:off x="2827117" y="2190509"/>
                <a:ext cx="33394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CD3D49A0-2575-4104-53D5-6C316D0DB29C}"/>
                  </a:ext>
                </a:extLst>
              </p:cNvPr>
              <p:cNvSpPr txBox="1"/>
              <p:nvPr/>
            </p:nvSpPr>
            <p:spPr>
              <a:xfrm>
                <a:off x="1737074" y="1787795"/>
                <a:ext cx="33394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CA4E89B2-C025-92BE-55D6-FE3A35FA6A84}"/>
                  </a:ext>
                </a:extLst>
              </p:cNvPr>
              <p:cNvSpPr txBox="1"/>
              <p:nvPr/>
            </p:nvSpPr>
            <p:spPr>
              <a:xfrm>
                <a:off x="3368990" y="2080290"/>
                <a:ext cx="33394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A651B6B4-AC02-6768-AB05-BEB8F7F8F1B1}"/>
                  </a:ext>
                </a:extLst>
              </p:cNvPr>
              <p:cNvSpPr txBox="1"/>
              <p:nvPr/>
            </p:nvSpPr>
            <p:spPr>
              <a:xfrm>
                <a:off x="2541056" y="1816772"/>
                <a:ext cx="33394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2992853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/>
        </p:nvGraphicFramePr>
        <p:xfrm>
          <a:off x="370840" y="528320"/>
          <a:ext cx="5725160" cy="4960112"/>
        </p:xfrm>
        <a:graphic>
          <a:graphicData uri="http://schemas.openxmlformats.org/drawingml/2006/table">
            <a:tbl>
              <a:tblPr firstRow="1" firstCol="1" bandRow="1"/>
              <a:tblGrid>
                <a:gridCol w="118300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26250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27965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ene name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orward primer (5’-3’)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b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verse primer (5’-3’)</a:t>
                      </a:r>
                      <a:endParaRPr lang="en-IN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i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ctin4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GAGCAGGAACTGGAGACTG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GGACTTCTGGACAACGGA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NAT2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2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GAGAGCAAGCAGAAAGA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GGTGGTTCAACGATTTG 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449735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MTR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GGGCTCTCCCTATTTG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AGATAGAAGGCGTGGT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177397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GS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GAGTGCGTTTGGTGGAA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AGCCAGGTGCAACAACA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0182035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SAO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TGACACTTCCACCAAAG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TAGCAACTGCAACAGAG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909499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LYI-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GTCACCAACTACGAGAA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GTTCCTGGGTGACTATT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2922265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LYII-2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GGATCATGTCACTACCT 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GTTGCATAAGCCTGAAG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07662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LYIII-DJ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ATGGAGTCCGAGAAACC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GGTATGCGGTACATTTC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522039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GR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CCTCGCATCACCTTGTA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CGCCGTCAGAACATTTA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14322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DH5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TCGGGACATGGATGTTG 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CACATGCCTCCTATTGT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817408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GD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CTTCCAGTGCAGACCAA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CTCAGCCGAATCAAACA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71399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R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GAGTTACAGCGTCTTAC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GATCCACAACCTTTCC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083747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K3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TGGGACAGGTACGAATG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CACCGGAAGTTGTAAGA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131164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PI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CGGTGGCAACTGGAAAT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GGAGGGCTCACAACAA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443376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GK5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CTGGTGTCATGTCCTTA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CCGCTTCCAATATCAAC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3855803"/>
                  </a:ext>
                </a:extLst>
              </a:tr>
            </a:tbl>
          </a:graphicData>
        </a:graphic>
      </p:graphicFrame>
      <p:sp>
        <p:nvSpPr>
          <p:cNvPr id="7" name="Rectangle 6"/>
          <p:cNvSpPr/>
          <p:nvPr/>
        </p:nvSpPr>
        <p:spPr>
          <a:xfrm>
            <a:off x="1463041" y="5878177"/>
            <a:ext cx="1010920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IN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Table 1. </a:t>
            </a:r>
            <a:r>
              <a:rPr lang="en-IN" sz="12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ist of primer sequences of the genes selected for analysing their transcript levels using </a:t>
            </a:r>
            <a:r>
              <a:rPr lang="en-IN" sz="1200" dirty="0" err="1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qRT</a:t>
            </a:r>
            <a:r>
              <a:rPr lang="en-IN" sz="12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PCR in experimental plants.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EED703A8-E35F-947F-DD5F-466358F4DE99}"/>
              </a:ext>
            </a:extLst>
          </p:cNvPr>
          <p:cNvGraphicFramePr>
            <a:graphicFrameLocks noGrp="1"/>
          </p:cNvGraphicFramePr>
          <p:nvPr/>
        </p:nvGraphicFramePr>
        <p:xfrm>
          <a:off x="6245571" y="528320"/>
          <a:ext cx="5725160" cy="4666057"/>
        </p:xfrm>
        <a:graphic>
          <a:graphicData uri="http://schemas.openxmlformats.org/drawingml/2006/table">
            <a:tbl>
              <a:tblPr firstRow="1" firstCol="1" bandRow="1"/>
              <a:tblGrid>
                <a:gridCol w="118300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26250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27965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ene name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orward primer (5’-3’)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b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verse primer (5’-3’)</a:t>
                      </a:r>
                      <a:endParaRPr lang="en-IN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20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K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CTGGAGAGTCTTGCATC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ACAGCTGGTCTGTACT </a:t>
                      </a:r>
                      <a:r>
                        <a:rPr lang="en-IN" sz="12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G3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AGGGACGGTAGAGAGAA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TAGGGCATTTGGAGACA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G5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CCTCTTCAAATCCATCTCC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TCAAAGGCGCTAACAG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12452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G18a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CTCCACATCTCCTTCAAC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GAAATCCCGGCGAAATA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G8c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GTATCCAGACAGAGTTCCT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CCCACAGTCAAATCAGATG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ST1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CCAGAAGAGAGTGAAACTG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CAAATCCGCAGGAAAGA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nRK1.1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TGAACCGACATCTCCAG</a:t>
                      </a:r>
                      <a:endParaRPr lang="en-IN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GTCCAAGAGCCCATTTC</a:t>
                      </a:r>
                      <a:endParaRPr lang="en-IN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IN" sz="1200" b="0" i="1" u="none" strike="noStrike" kern="1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nRK2.6</a:t>
                      </a:r>
                      <a:endParaRPr kumimoji="0" lang="en-IN" sz="1200" b="0" i="0" u="none" strike="noStrike" kern="1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GACCGGCTATGGATATG</a:t>
                      </a:r>
                      <a:endParaRPr lang="en-IN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CGAGCTCCTTGGTAAC</a:t>
                      </a:r>
                      <a:endParaRPr lang="en-IN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47749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i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IN10</a:t>
                      </a:r>
                      <a:endParaRPr lang="en-IN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TGAACCGACATCTCCAG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GTCCAAGAGCCCATTTC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2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AF18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GTCCATCGTGTGTTACT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TCTTCCCTCCTGCAAT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20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AG2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GACTAAAGCGACAGGAC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GTCTAAGCTCCCAATCA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96966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20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AG6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CAGTGGTAGCCTTGATA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CCTTGTTCTCCTTGTTC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868719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20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C9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CACCACCTGTTGATTAC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TGTTCCAGTGTTGATGG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0438768"/>
                  </a:ext>
                </a:extLst>
              </a:tr>
              <a:tr h="318719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200" i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OG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GCTGTCTCTTTGTGATG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TGCTCTGCTCCTAACT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705909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081208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0</TotalTime>
  <Words>1300</Words>
  <Application>Microsoft Office PowerPoint</Application>
  <PresentationFormat>Widescreen</PresentationFormat>
  <Paragraphs>396</Paragraphs>
  <Slides>8</Slides>
  <Notes>3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8</vt:i4>
      </vt:variant>
    </vt:vector>
  </HeadingPairs>
  <TitlesOfParts>
    <vt:vector size="15" baseType="lpstr">
      <vt:lpstr>Arial</vt:lpstr>
      <vt:lpstr>Calibri</vt:lpstr>
      <vt:lpstr>Calibri Light</vt:lpstr>
      <vt:lpstr>Times New Roman</vt:lpstr>
      <vt:lpstr>Office Theme</vt:lpstr>
      <vt:lpstr>Prism 8</vt:lpstr>
      <vt:lpstr>GraphPad Prism 8 Projec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upriya Laha</dc:creator>
  <cp:lastModifiedBy>deepika dake</cp:lastModifiedBy>
  <cp:revision>21</cp:revision>
  <dcterms:created xsi:type="dcterms:W3CDTF">2024-09-13T14:27:00Z</dcterms:created>
  <dcterms:modified xsi:type="dcterms:W3CDTF">2025-01-15T07:29:25Z</dcterms:modified>
</cp:coreProperties>
</file>